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4400213" cy="21599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38" d="100"/>
          <a:sy n="38" d="100"/>
        </p:scale>
        <p:origin x="180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tanabe Satoshi" userId="ca2b3ca5d2e030cf" providerId="LiveId" clId="{E51FB160-E9ED-4F58-A1D1-1562DB2755EE}"/>
    <pc:docChg chg="modSld">
      <pc:chgData name="Watanabe Satoshi" userId="ca2b3ca5d2e030cf" providerId="LiveId" clId="{E51FB160-E9ED-4F58-A1D1-1562DB2755EE}" dt="2021-08-28T06:42:03.650" v="61" actId="1076"/>
      <pc:docMkLst>
        <pc:docMk/>
      </pc:docMkLst>
      <pc:sldChg chg="modSp mod">
        <pc:chgData name="Watanabe Satoshi" userId="ca2b3ca5d2e030cf" providerId="LiveId" clId="{E51FB160-E9ED-4F58-A1D1-1562DB2755EE}" dt="2021-08-28T06:42:03.650" v="61" actId="1076"/>
        <pc:sldMkLst>
          <pc:docMk/>
          <pc:sldMk cId="2949443104" sldId="256"/>
        </pc:sldMkLst>
        <pc:spChg chg="mod">
          <ac:chgData name="Watanabe Satoshi" userId="ca2b3ca5d2e030cf" providerId="LiveId" clId="{E51FB160-E9ED-4F58-A1D1-1562DB2755EE}" dt="2021-08-28T06:35:28.616" v="0" actId="121"/>
          <ac:spMkLst>
            <pc:docMk/>
            <pc:sldMk cId="2949443104" sldId="256"/>
            <ac:spMk id="28" creationId="{BA45FBA5-36B8-4DD3-BDC2-16230979E893}"/>
          </ac:spMkLst>
        </pc:spChg>
        <pc:spChg chg="mod">
          <ac:chgData name="Watanabe Satoshi" userId="ca2b3ca5d2e030cf" providerId="LiveId" clId="{E51FB160-E9ED-4F58-A1D1-1562DB2755EE}" dt="2021-08-28T06:35:28.616" v="0" actId="121"/>
          <ac:spMkLst>
            <pc:docMk/>
            <pc:sldMk cId="2949443104" sldId="256"/>
            <ac:spMk id="29" creationId="{A3D81423-5C45-4A52-BA3C-ABE79DBD2CC1}"/>
          </ac:spMkLst>
        </pc:spChg>
        <pc:spChg chg="mod">
          <ac:chgData name="Watanabe Satoshi" userId="ca2b3ca5d2e030cf" providerId="LiveId" clId="{E51FB160-E9ED-4F58-A1D1-1562DB2755EE}" dt="2021-08-28T06:35:39.653" v="1" actId="121"/>
          <ac:spMkLst>
            <pc:docMk/>
            <pc:sldMk cId="2949443104" sldId="256"/>
            <ac:spMk id="80" creationId="{D5A70594-748A-48CB-B472-8E9265E4A650}"/>
          </ac:spMkLst>
        </pc:spChg>
        <pc:spChg chg="mod">
          <ac:chgData name="Watanabe Satoshi" userId="ca2b3ca5d2e030cf" providerId="LiveId" clId="{E51FB160-E9ED-4F58-A1D1-1562DB2755EE}" dt="2021-08-28T06:35:39.653" v="1" actId="121"/>
          <ac:spMkLst>
            <pc:docMk/>
            <pc:sldMk cId="2949443104" sldId="256"/>
            <ac:spMk id="81" creationId="{1CB2606A-EBBE-462F-BD9F-8AED656C992F}"/>
          </ac:spMkLst>
        </pc:spChg>
        <pc:spChg chg="mod">
          <ac:chgData name="Watanabe Satoshi" userId="ca2b3ca5d2e030cf" providerId="LiveId" clId="{E51FB160-E9ED-4F58-A1D1-1562DB2755EE}" dt="2021-08-28T06:35:56.134" v="2" actId="121"/>
          <ac:spMkLst>
            <pc:docMk/>
            <pc:sldMk cId="2949443104" sldId="256"/>
            <ac:spMk id="100" creationId="{40CA8479-6A4D-4D32-AC7C-64ACBC27C2FE}"/>
          </ac:spMkLst>
        </pc:spChg>
        <pc:spChg chg="mod">
          <ac:chgData name="Watanabe Satoshi" userId="ca2b3ca5d2e030cf" providerId="LiveId" clId="{E51FB160-E9ED-4F58-A1D1-1562DB2755EE}" dt="2021-08-28T06:35:56.134" v="2" actId="121"/>
          <ac:spMkLst>
            <pc:docMk/>
            <pc:sldMk cId="2949443104" sldId="256"/>
            <ac:spMk id="101" creationId="{330890A9-70E7-40C0-860C-D6498C0A9160}"/>
          </ac:spMkLst>
        </pc:spChg>
        <pc:spChg chg="mod">
          <ac:chgData name="Watanabe Satoshi" userId="ca2b3ca5d2e030cf" providerId="LiveId" clId="{E51FB160-E9ED-4F58-A1D1-1562DB2755EE}" dt="2021-08-28T06:39:02.769" v="27" actId="1037"/>
          <ac:spMkLst>
            <pc:docMk/>
            <pc:sldMk cId="2949443104" sldId="256"/>
            <ac:spMk id="122" creationId="{A732B967-AFE6-4ABB-AEFE-53840C3B0BBC}"/>
          </ac:spMkLst>
        </pc:spChg>
        <pc:spChg chg="mod">
          <ac:chgData name="Watanabe Satoshi" userId="ca2b3ca5d2e030cf" providerId="LiveId" clId="{E51FB160-E9ED-4F58-A1D1-1562DB2755EE}" dt="2021-08-28T06:39:07.950" v="29" actId="1037"/>
          <ac:spMkLst>
            <pc:docMk/>
            <pc:sldMk cId="2949443104" sldId="256"/>
            <ac:spMk id="123" creationId="{00887E2F-9078-4B90-ABE1-38F07F21B73E}"/>
          </ac:spMkLst>
        </pc:spChg>
        <pc:spChg chg="mod">
          <ac:chgData name="Watanabe Satoshi" userId="ca2b3ca5d2e030cf" providerId="LiveId" clId="{E51FB160-E9ED-4F58-A1D1-1562DB2755EE}" dt="2021-08-28T06:38:54.550" v="25" actId="1037"/>
          <ac:spMkLst>
            <pc:docMk/>
            <pc:sldMk cId="2949443104" sldId="256"/>
            <ac:spMk id="126" creationId="{19887FD8-4B79-4DB3-9116-96D45B62B3FC}"/>
          </ac:spMkLst>
        </pc:spChg>
        <pc:spChg chg="mod">
          <ac:chgData name="Watanabe Satoshi" userId="ca2b3ca5d2e030cf" providerId="LiveId" clId="{E51FB160-E9ED-4F58-A1D1-1562DB2755EE}" dt="2021-08-28T06:38:47.931" v="23" actId="1038"/>
          <ac:spMkLst>
            <pc:docMk/>
            <pc:sldMk cId="2949443104" sldId="256"/>
            <ac:spMk id="127" creationId="{3E85D322-4ED4-48DE-B6CD-A0D8DE7CEF90}"/>
          </ac:spMkLst>
        </pc:spChg>
        <pc:spChg chg="mod">
          <ac:chgData name="Watanabe Satoshi" userId="ca2b3ca5d2e030cf" providerId="LiveId" clId="{E51FB160-E9ED-4F58-A1D1-1562DB2755EE}" dt="2021-08-28T06:38:42.305" v="20" actId="1037"/>
          <ac:spMkLst>
            <pc:docMk/>
            <pc:sldMk cId="2949443104" sldId="256"/>
            <ac:spMk id="128" creationId="{DC44FF83-19C1-4A91-9D8C-74015989AC91}"/>
          </ac:spMkLst>
        </pc:spChg>
        <pc:spChg chg="mod">
          <ac:chgData name="Watanabe Satoshi" userId="ca2b3ca5d2e030cf" providerId="LiveId" clId="{E51FB160-E9ED-4F58-A1D1-1562DB2755EE}" dt="2021-08-28T06:39:02.769" v="27" actId="1037"/>
          <ac:spMkLst>
            <pc:docMk/>
            <pc:sldMk cId="2949443104" sldId="256"/>
            <ac:spMk id="130" creationId="{DB513877-127C-49D6-BEE3-FE741D96C764}"/>
          </ac:spMkLst>
        </pc:spChg>
        <pc:spChg chg="mod">
          <ac:chgData name="Watanabe Satoshi" userId="ca2b3ca5d2e030cf" providerId="LiveId" clId="{E51FB160-E9ED-4F58-A1D1-1562DB2755EE}" dt="2021-08-28T06:39:07.950" v="29" actId="1037"/>
          <ac:spMkLst>
            <pc:docMk/>
            <pc:sldMk cId="2949443104" sldId="256"/>
            <ac:spMk id="131" creationId="{C2C3C880-E790-472E-A614-3A6E1BA58ED5}"/>
          </ac:spMkLst>
        </pc:spChg>
        <pc:spChg chg="mod">
          <ac:chgData name="Watanabe Satoshi" userId="ca2b3ca5d2e030cf" providerId="LiveId" clId="{E51FB160-E9ED-4F58-A1D1-1562DB2755EE}" dt="2021-08-28T06:38:54.550" v="25" actId="1037"/>
          <ac:spMkLst>
            <pc:docMk/>
            <pc:sldMk cId="2949443104" sldId="256"/>
            <ac:spMk id="134" creationId="{E2B6E284-66DB-431F-B8F7-E6FDB9C4B5E4}"/>
          </ac:spMkLst>
        </pc:spChg>
        <pc:spChg chg="mod">
          <ac:chgData name="Watanabe Satoshi" userId="ca2b3ca5d2e030cf" providerId="LiveId" clId="{E51FB160-E9ED-4F58-A1D1-1562DB2755EE}" dt="2021-08-28T06:38:47.931" v="23" actId="1038"/>
          <ac:spMkLst>
            <pc:docMk/>
            <pc:sldMk cId="2949443104" sldId="256"/>
            <ac:spMk id="135" creationId="{7917105F-5ED6-4F06-8352-7C4B33578F17}"/>
          </ac:spMkLst>
        </pc:spChg>
        <pc:spChg chg="mod">
          <ac:chgData name="Watanabe Satoshi" userId="ca2b3ca5d2e030cf" providerId="LiveId" clId="{E51FB160-E9ED-4F58-A1D1-1562DB2755EE}" dt="2021-08-28T06:38:42.305" v="20" actId="1037"/>
          <ac:spMkLst>
            <pc:docMk/>
            <pc:sldMk cId="2949443104" sldId="256"/>
            <ac:spMk id="136" creationId="{6E127BDC-A9E4-4FD0-9357-E9B94B0674CE}"/>
          </ac:spMkLst>
        </pc:spChg>
        <pc:spChg chg="mod">
          <ac:chgData name="Watanabe Satoshi" userId="ca2b3ca5d2e030cf" providerId="LiveId" clId="{E51FB160-E9ED-4F58-A1D1-1562DB2755EE}" dt="2021-08-28T06:42:03.650" v="61" actId="1076"/>
          <ac:spMkLst>
            <pc:docMk/>
            <pc:sldMk cId="2949443104" sldId="256"/>
            <ac:spMk id="162" creationId="{4F620676-F3AF-43AD-B327-7BF8A5523AF5}"/>
          </ac:spMkLst>
        </pc:spChg>
        <pc:spChg chg="mod">
          <ac:chgData name="Watanabe Satoshi" userId="ca2b3ca5d2e030cf" providerId="LiveId" clId="{E51FB160-E9ED-4F58-A1D1-1562DB2755EE}" dt="2021-08-28T06:38:14.348" v="18" actId="1038"/>
          <ac:spMkLst>
            <pc:docMk/>
            <pc:sldMk cId="2949443104" sldId="256"/>
            <ac:spMk id="178" creationId="{685E2451-FBB9-49E2-A02D-E7322CC61EF1}"/>
          </ac:spMkLst>
        </pc:spChg>
        <pc:spChg chg="mod">
          <ac:chgData name="Watanabe Satoshi" userId="ca2b3ca5d2e030cf" providerId="LiveId" clId="{E51FB160-E9ED-4F58-A1D1-1562DB2755EE}" dt="2021-08-28T06:38:07.069" v="14" actId="1038"/>
          <ac:spMkLst>
            <pc:docMk/>
            <pc:sldMk cId="2949443104" sldId="256"/>
            <ac:spMk id="179" creationId="{32A0A5C4-F51B-4A5C-9B1C-9128558C4305}"/>
          </ac:spMkLst>
        </pc:spChg>
        <pc:spChg chg="mod">
          <ac:chgData name="Watanabe Satoshi" userId="ca2b3ca5d2e030cf" providerId="LiveId" clId="{E51FB160-E9ED-4F58-A1D1-1562DB2755EE}" dt="2021-08-28T06:38:00.367" v="8" actId="1038"/>
          <ac:spMkLst>
            <pc:docMk/>
            <pc:sldMk cId="2949443104" sldId="256"/>
            <ac:spMk id="180" creationId="{2BF5F005-7D0F-4429-BF27-A465553E6986}"/>
          </ac:spMkLst>
        </pc:spChg>
        <pc:spChg chg="mod">
          <ac:chgData name="Watanabe Satoshi" userId="ca2b3ca5d2e030cf" providerId="LiveId" clId="{E51FB160-E9ED-4F58-A1D1-1562DB2755EE}" dt="2021-08-28T06:38:14.348" v="18" actId="1038"/>
          <ac:spMkLst>
            <pc:docMk/>
            <pc:sldMk cId="2949443104" sldId="256"/>
            <ac:spMk id="185" creationId="{80A42783-853C-4E29-AE4E-3B85ACE31C76}"/>
          </ac:spMkLst>
        </pc:spChg>
        <pc:spChg chg="mod">
          <ac:chgData name="Watanabe Satoshi" userId="ca2b3ca5d2e030cf" providerId="LiveId" clId="{E51FB160-E9ED-4F58-A1D1-1562DB2755EE}" dt="2021-08-28T06:38:07.069" v="14" actId="1038"/>
          <ac:spMkLst>
            <pc:docMk/>
            <pc:sldMk cId="2949443104" sldId="256"/>
            <ac:spMk id="186" creationId="{15C810B8-B3AC-4BF4-9086-7EA3C34C4D04}"/>
          </ac:spMkLst>
        </pc:spChg>
        <pc:spChg chg="mod">
          <ac:chgData name="Watanabe Satoshi" userId="ca2b3ca5d2e030cf" providerId="LiveId" clId="{E51FB160-E9ED-4F58-A1D1-1562DB2755EE}" dt="2021-08-28T06:38:00.367" v="8" actId="1038"/>
          <ac:spMkLst>
            <pc:docMk/>
            <pc:sldMk cId="2949443104" sldId="256"/>
            <ac:spMk id="187" creationId="{2895F1DA-D329-45F5-8449-78572E8FBD93}"/>
          </ac:spMkLst>
        </pc:spChg>
        <pc:spChg chg="mod">
          <ac:chgData name="Watanabe Satoshi" userId="ca2b3ca5d2e030cf" providerId="LiveId" clId="{E51FB160-E9ED-4F58-A1D1-1562DB2755EE}" dt="2021-08-28T06:40:21.299" v="60" actId="1037"/>
          <ac:spMkLst>
            <pc:docMk/>
            <pc:sldMk cId="2949443104" sldId="256"/>
            <ac:spMk id="193" creationId="{9159AA64-A914-49AD-8009-1A603E3CE76D}"/>
          </ac:spMkLst>
        </pc:spChg>
        <pc:spChg chg="mod">
          <ac:chgData name="Watanabe Satoshi" userId="ca2b3ca5d2e030cf" providerId="LiveId" clId="{E51FB160-E9ED-4F58-A1D1-1562DB2755EE}" dt="2021-08-28T06:40:11.656" v="56" actId="552"/>
          <ac:spMkLst>
            <pc:docMk/>
            <pc:sldMk cId="2949443104" sldId="256"/>
            <ac:spMk id="194" creationId="{5FE16149-30D1-4F09-9312-75907A833C61}"/>
          </ac:spMkLst>
        </pc:spChg>
        <pc:spChg chg="mod">
          <ac:chgData name="Watanabe Satoshi" userId="ca2b3ca5d2e030cf" providerId="LiveId" clId="{E51FB160-E9ED-4F58-A1D1-1562DB2755EE}" dt="2021-08-28T06:39:55.135" v="49" actId="1037"/>
          <ac:spMkLst>
            <pc:docMk/>
            <pc:sldMk cId="2949443104" sldId="256"/>
            <ac:spMk id="195" creationId="{C90C3A5F-026B-4CDF-897E-FD8CFBBA3B6C}"/>
          </ac:spMkLst>
        </pc:spChg>
        <pc:spChg chg="mod">
          <ac:chgData name="Watanabe Satoshi" userId="ca2b3ca5d2e030cf" providerId="LiveId" clId="{E51FB160-E9ED-4F58-A1D1-1562DB2755EE}" dt="2021-08-28T06:39:49.964" v="45" actId="1037"/>
          <ac:spMkLst>
            <pc:docMk/>
            <pc:sldMk cId="2949443104" sldId="256"/>
            <ac:spMk id="196" creationId="{8054EE86-CBC0-4030-B1CA-0ADE181FF1A3}"/>
          </ac:spMkLst>
        </pc:spChg>
        <pc:spChg chg="mod">
          <ac:chgData name="Watanabe Satoshi" userId="ca2b3ca5d2e030cf" providerId="LiveId" clId="{E51FB160-E9ED-4F58-A1D1-1562DB2755EE}" dt="2021-08-28T06:39:37.986" v="40" actId="1037"/>
          <ac:spMkLst>
            <pc:docMk/>
            <pc:sldMk cId="2949443104" sldId="256"/>
            <ac:spMk id="197" creationId="{EF91881C-62BF-476B-871B-B03AE8974FA1}"/>
          </ac:spMkLst>
        </pc:spChg>
        <pc:spChg chg="mod">
          <ac:chgData name="Watanabe Satoshi" userId="ca2b3ca5d2e030cf" providerId="LiveId" clId="{E51FB160-E9ED-4F58-A1D1-1562DB2755EE}" dt="2021-08-28T06:39:30.370" v="38" actId="1037"/>
          <ac:spMkLst>
            <pc:docMk/>
            <pc:sldMk cId="2949443104" sldId="256"/>
            <ac:spMk id="198" creationId="{8CAFC6A0-E931-4061-8823-F394107D107B}"/>
          </ac:spMkLst>
        </pc:spChg>
        <pc:spChg chg="mod">
          <ac:chgData name="Watanabe Satoshi" userId="ca2b3ca5d2e030cf" providerId="LiveId" clId="{E51FB160-E9ED-4F58-A1D1-1562DB2755EE}" dt="2021-08-28T06:39:19.536" v="30" actId="1037"/>
          <ac:spMkLst>
            <pc:docMk/>
            <pc:sldMk cId="2949443104" sldId="256"/>
            <ac:spMk id="199" creationId="{64F8C3A8-F5B8-4E62-B2DD-4A898C511D68}"/>
          </ac:spMkLst>
        </pc:spChg>
        <pc:spChg chg="mod">
          <ac:chgData name="Watanabe Satoshi" userId="ca2b3ca5d2e030cf" providerId="LiveId" clId="{E51FB160-E9ED-4F58-A1D1-1562DB2755EE}" dt="2021-08-28T06:40:21.299" v="60" actId="1037"/>
          <ac:spMkLst>
            <pc:docMk/>
            <pc:sldMk cId="2949443104" sldId="256"/>
            <ac:spMk id="200" creationId="{66145C1B-D57E-4B11-B5AB-71A4639140B1}"/>
          </ac:spMkLst>
        </pc:spChg>
        <pc:spChg chg="mod">
          <ac:chgData name="Watanabe Satoshi" userId="ca2b3ca5d2e030cf" providerId="LiveId" clId="{E51FB160-E9ED-4F58-A1D1-1562DB2755EE}" dt="2021-08-28T06:40:11.656" v="56" actId="552"/>
          <ac:spMkLst>
            <pc:docMk/>
            <pc:sldMk cId="2949443104" sldId="256"/>
            <ac:spMk id="201" creationId="{70A49A46-73FA-4A29-AE9D-30638F7B96DC}"/>
          </ac:spMkLst>
        </pc:spChg>
        <pc:spChg chg="mod">
          <ac:chgData name="Watanabe Satoshi" userId="ca2b3ca5d2e030cf" providerId="LiveId" clId="{E51FB160-E9ED-4F58-A1D1-1562DB2755EE}" dt="2021-08-28T06:39:55.135" v="49" actId="1037"/>
          <ac:spMkLst>
            <pc:docMk/>
            <pc:sldMk cId="2949443104" sldId="256"/>
            <ac:spMk id="202" creationId="{13FE8A25-CD61-4061-A4A1-DC465B4F86EB}"/>
          </ac:spMkLst>
        </pc:spChg>
        <pc:spChg chg="mod">
          <ac:chgData name="Watanabe Satoshi" userId="ca2b3ca5d2e030cf" providerId="LiveId" clId="{E51FB160-E9ED-4F58-A1D1-1562DB2755EE}" dt="2021-08-28T06:39:49.964" v="45" actId="1037"/>
          <ac:spMkLst>
            <pc:docMk/>
            <pc:sldMk cId="2949443104" sldId="256"/>
            <ac:spMk id="203" creationId="{0C89E9CF-B667-4A09-AA14-01E47D6AE2A6}"/>
          </ac:spMkLst>
        </pc:spChg>
        <pc:spChg chg="mod">
          <ac:chgData name="Watanabe Satoshi" userId="ca2b3ca5d2e030cf" providerId="LiveId" clId="{E51FB160-E9ED-4F58-A1D1-1562DB2755EE}" dt="2021-08-28T06:39:37.986" v="40" actId="1037"/>
          <ac:spMkLst>
            <pc:docMk/>
            <pc:sldMk cId="2949443104" sldId="256"/>
            <ac:spMk id="204" creationId="{B331D8C1-5BA2-4BDA-961D-51AF3243E0AA}"/>
          </ac:spMkLst>
        </pc:spChg>
        <pc:spChg chg="mod">
          <ac:chgData name="Watanabe Satoshi" userId="ca2b3ca5d2e030cf" providerId="LiveId" clId="{E51FB160-E9ED-4F58-A1D1-1562DB2755EE}" dt="2021-08-28T06:39:30.370" v="38" actId="1037"/>
          <ac:spMkLst>
            <pc:docMk/>
            <pc:sldMk cId="2949443104" sldId="256"/>
            <ac:spMk id="205" creationId="{50892535-0FF7-4704-B88D-9D975D2B36F8}"/>
          </ac:spMkLst>
        </pc:spChg>
        <pc:spChg chg="mod">
          <ac:chgData name="Watanabe Satoshi" userId="ca2b3ca5d2e030cf" providerId="LiveId" clId="{E51FB160-E9ED-4F58-A1D1-1562DB2755EE}" dt="2021-08-28T06:39:19.536" v="30" actId="1037"/>
          <ac:spMkLst>
            <pc:docMk/>
            <pc:sldMk cId="2949443104" sldId="256"/>
            <ac:spMk id="206" creationId="{3F814245-9E72-46F8-B90D-5F33EB0922AB}"/>
          </ac:spMkLst>
        </pc:spChg>
        <pc:spChg chg="mod">
          <ac:chgData name="Watanabe Satoshi" userId="ca2b3ca5d2e030cf" providerId="LiveId" clId="{E51FB160-E9ED-4F58-A1D1-1562DB2755EE}" dt="2021-08-28T06:39:59.174" v="50" actId="1076"/>
          <ac:spMkLst>
            <pc:docMk/>
            <pc:sldMk cId="2949443104" sldId="256"/>
            <ac:spMk id="223" creationId="{7D5ECED7-E042-4A7D-BF21-7A0D1251E475}"/>
          </ac:spMkLst>
        </pc:spChg>
      </pc:sldChg>
    </pc:docChg>
  </pc:docChgLst>
  <pc:docChgLst>
    <pc:chgData name="Watanabe Satoshi" userId="ca2b3ca5d2e030cf" providerId="LiveId" clId="{C73E2EEB-F248-420B-B050-C3BDD783B668}"/>
    <pc:docChg chg="undo custSel modSld">
      <pc:chgData name="Watanabe Satoshi" userId="ca2b3ca5d2e030cf" providerId="LiveId" clId="{C73E2EEB-F248-420B-B050-C3BDD783B668}" dt="2021-08-29T02:35:27.757" v="1132" actId="1036"/>
      <pc:docMkLst>
        <pc:docMk/>
      </pc:docMkLst>
      <pc:sldChg chg="addSp delSp modSp mod">
        <pc:chgData name="Watanabe Satoshi" userId="ca2b3ca5d2e030cf" providerId="LiveId" clId="{C73E2EEB-F248-420B-B050-C3BDD783B668}" dt="2021-08-29T02:35:27.757" v="1132" actId="1036"/>
        <pc:sldMkLst>
          <pc:docMk/>
          <pc:sldMk cId="2949443104" sldId="256"/>
        </pc:sldMkLst>
        <pc:spChg chg="add mod">
          <ac:chgData name="Watanabe Satoshi" userId="ca2b3ca5d2e030cf" providerId="LiveId" clId="{C73E2EEB-F248-420B-B050-C3BDD783B668}" dt="2021-08-27T14:17:28.468" v="310" actId="554"/>
          <ac:spMkLst>
            <pc:docMk/>
            <pc:sldMk cId="2949443104" sldId="256"/>
            <ac:spMk id="2" creationId="{ED72B4F3-144F-48EE-A615-06322EA9A880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5" creationId="{B4901D5D-7ADB-4A36-A7DD-53C81D57D65C}"/>
          </ac:spMkLst>
        </pc:spChg>
        <pc:spChg chg="mod">
          <ac:chgData name="Watanabe Satoshi" userId="ca2b3ca5d2e030cf" providerId="LiveId" clId="{C73E2EEB-F248-420B-B050-C3BDD783B668}" dt="2021-08-27T14:17:53.178" v="317" actId="1037"/>
          <ac:spMkLst>
            <pc:docMk/>
            <pc:sldMk cId="2949443104" sldId="256"/>
            <ac:spMk id="6" creationId="{DB61AFBC-D7A6-4972-8BC9-4758F9560DE7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" creationId="{CC95C5EF-1BD2-460B-AB15-B3CE8BE67211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8" creationId="{7543ACC0-0E8C-49E9-91BA-99BCA322FD89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9" creationId="{A51FC492-D6F3-443D-97A5-FAD42D6C8DD0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0" creationId="{72E5188A-1ACA-4498-86AD-2C6FAA852848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1" creationId="{75E8F01D-610B-4A5B-BD4A-689AFCADA754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2" creationId="{BDD0559F-9CDF-499D-830D-57ED1C95DFA5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3" creationId="{E71F93B5-B170-4023-B427-D13BE02464BE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4" creationId="{39C649BA-DFB9-40AF-8909-6F2A3EA67FBF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5" creationId="{3B45A1D4-6F76-4266-8845-65F5C43889EA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6" creationId="{E7D5E57B-9197-41D3-BB59-F295EC26BD10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7" creationId="{744D5B5B-E668-48DC-A033-AD9C668CF2E3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8" creationId="{1CECA6C2-BADC-4D26-9ECC-77570F13044E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9" creationId="{4D7C79FA-33F8-4B2F-A268-88F2C27BF276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20" creationId="{6BEDD939-B5ED-4738-AE3F-DCEC6131C427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21" creationId="{3859706A-7447-47AE-AA05-148425D832CF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22" creationId="{713EF907-67AD-4E51-AF5C-C22D6D1ADBEB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23" creationId="{2F80A6BF-880E-42AE-B051-B240336FF559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24" creationId="{7B2EA147-DE45-4081-8F7C-693271890590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27" creationId="{AAA61B80-1C1D-4236-BC89-6C14D1A17271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28" creationId="{BA45FBA5-36B8-4DD3-BDC2-16230979E893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29" creationId="{A3D81423-5C45-4A52-BA3C-ABE79DBD2CC1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30" creationId="{2546B7F4-2D68-48AD-91D3-C49FF089F951}"/>
          </ac:spMkLst>
        </pc:spChg>
        <pc:spChg chg="mod">
          <ac:chgData name="Watanabe Satoshi" userId="ca2b3ca5d2e030cf" providerId="LiveId" clId="{C73E2EEB-F248-420B-B050-C3BDD783B668}" dt="2021-08-28T03:55:37.389" v="571" actId="1036"/>
          <ac:spMkLst>
            <pc:docMk/>
            <pc:sldMk cId="2949443104" sldId="256"/>
            <ac:spMk id="31" creationId="{E4E3B8D8-3B28-43CE-9990-9638DC19A6D3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33" creationId="{4649980A-5EA2-4DEB-BCCD-BBDF949D6600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34" creationId="{44E9C58A-E3A4-4136-BE04-1F682C5B37E3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35" creationId="{1B705800-0B9B-41AB-A327-8004E351F945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36" creationId="{C3C65B7A-E7DF-485F-99C7-DCE4A460D7C7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37" creationId="{7C83BCE1-9598-411A-A97D-98312D78FE41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38" creationId="{5CA98F31-3DAA-40BE-8B99-72A0634183E0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39" creationId="{3DFE2C7A-092B-48D2-B0DB-04FCD4748064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40" creationId="{71BD324E-05E7-4467-8E94-69D3DBA460B1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41" creationId="{6DAE1B13-20F9-4C8D-9228-C1F6C2212885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42" creationId="{4D8FEAAA-80C9-4342-9FEA-A1138ABA6766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43" creationId="{881F3BA9-75EE-410C-9A14-9E8D7D42898C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44" creationId="{7939454E-841A-41F6-8533-3432AB050DA4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45" creationId="{49FB971B-1BCB-4419-BA3B-4FA8A5F2AFFC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46" creationId="{523B31F0-7656-4EEA-B331-9FF5CB7A7F65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47" creationId="{2F413CFC-E32A-4F28-BF00-6886EC99C01E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48" creationId="{15E70AFC-361C-4281-8A06-F8BA97544A5D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49" creationId="{880CCFF2-5650-4A29-B733-BDFE966CD7BC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50" creationId="{9454BD80-A770-418E-82A5-BBC2CD7418B0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51" creationId="{D91D477D-BF65-4897-9E6A-135D7E37220D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52" creationId="{E2CFFA1D-638F-41BA-9D47-E92B75B289B3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53" creationId="{6211335F-FDCA-4FAB-A538-60979D01F3C5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54" creationId="{B84AF176-A285-4813-AA7B-249BFD9150F5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55" creationId="{D2BEDBF1-31B2-4E22-9401-9A716904D5B3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58" creationId="{6E9CCF52-F1E4-4D36-83D4-B0B3DC19C539}"/>
          </ac:spMkLst>
        </pc:spChg>
        <pc:spChg chg="mod">
          <ac:chgData name="Watanabe Satoshi" userId="ca2b3ca5d2e030cf" providerId="LiveId" clId="{C73E2EEB-F248-420B-B050-C3BDD783B668}" dt="2021-08-27T14:18:06.949" v="318" actId="12788"/>
          <ac:spMkLst>
            <pc:docMk/>
            <pc:sldMk cId="2949443104" sldId="256"/>
            <ac:spMk id="60" creationId="{196DA8F9-A673-468F-9C55-520840258CF5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61" creationId="{043DB8AE-BF23-487A-AC19-7755EC9AFA70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62" creationId="{A60A4499-2754-4CF7-A904-3DE23E60590E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65" creationId="{511BEC2A-CEC2-43E4-99E7-3271EA004CCE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66" creationId="{0FC4359E-CA08-48C0-9DBD-905682E01018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67" creationId="{6F06BC66-2A0A-4FB6-8AD0-4B30C5F65826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68" creationId="{B01A3DAB-1F1B-4A78-BB88-1C86AEDBB4A4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69" creationId="{72808A2E-C696-4CE4-987A-DFCB146CDC8D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0" creationId="{BF37E56E-61A7-4004-B1C8-1850D46AAB85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1" creationId="{2A9F2464-61EB-4BA6-8408-E126FEDB54B6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2" creationId="{BD1DBDC4-626B-4625-8D0A-32F3EB9D3890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3" creationId="{21401597-D248-4E69-9E5A-71B55D7A8539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4" creationId="{E9F01313-8AB4-4E9F-9756-49BC66499F21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5" creationId="{5C4218E2-70AD-4308-A201-450CC701977D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6" creationId="{D924F5DA-B271-484D-AD94-069C2B6D20B2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7" creationId="{622B4850-727A-4EEE-9DD5-C34F7FFE69E9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8" creationId="{5503C213-707B-49F2-B023-3DCA5B2233CE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79" creationId="{2C833F6C-CEDC-4B56-8292-A30A54CD4FAE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80" creationId="{D5A70594-748A-48CB-B472-8E9265E4A650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81" creationId="{1CB2606A-EBBE-462F-BD9F-8AED656C992F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82" creationId="{C008ADDC-A52B-41C2-9698-7A25B4156801}"/>
          </ac:spMkLst>
        </pc:spChg>
        <pc:spChg chg="mod">
          <ac:chgData name="Watanabe Satoshi" userId="ca2b3ca5d2e030cf" providerId="LiveId" clId="{C73E2EEB-F248-420B-B050-C3BDD783B668}" dt="2021-08-28T03:55:37.389" v="571" actId="1036"/>
          <ac:spMkLst>
            <pc:docMk/>
            <pc:sldMk cId="2949443104" sldId="256"/>
            <ac:spMk id="83" creationId="{A2323C8C-AA05-4D1F-AF1F-5695C4938940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85" creationId="{173F44B3-4D75-4BCC-9CCA-83492857CAC7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86" creationId="{167979A4-BA3C-4CD5-B156-E1F2B832A2FC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87" creationId="{ED247230-24E8-4A9C-AF80-094A13D4D8A2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88" creationId="{B472A12B-2062-4140-9C86-28259691E2D5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89" creationId="{DA2F71FD-9AB0-4801-942F-3000FE73DF61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90" creationId="{B2D2D87D-2FAD-445C-B304-A2B006960ABA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91" creationId="{52AA0A7B-48BF-401E-BA54-AD7E13F67039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92" creationId="{AC273EA1-BF03-43A6-B1BD-ADFF1E83ED84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93" creationId="{6BD85167-3B88-4F8F-A4F1-F485E4DC1297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94" creationId="{3CF4B4FE-C6DB-4634-9D15-B55832318642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95" creationId="{C2257529-8FA8-4834-93C4-C524EC619CE5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96" creationId="{3A77727F-CF71-4E9C-9346-FD1F14291929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97" creationId="{2A9773D3-85DB-4725-8860-3D0E08F3AAA3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98" creationId="{4626329D-2866-476C-A586-3538E092CFB1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99" creationId="{CD89A867-6B7C-4120-A54F-90DA62DD265F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100" creationId="{40CA8479-6A4D-4D32-AC7C-64ACBC27C2FE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101" creationId="{330890A9-70E7-40C0-860C-D6498C0A9160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102" creationId="{A16DA729-16E3-426A-98AF-470C5C9C7124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103" creationId="{0D6B3C1F-2173-4D71-AE3F-71E1975530F8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104" creationId="{2D91AA44-C99F-4507-90B9-3896489C53AF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105" creationId="{B0F6533B-64D7-4C9F-B290-21CC24AD7CCA}"/>
          </ac:spMkLst>
        </pc:spChg>
        <pc:spChg chg="mod">
          <ac:chgData name="Watanabe Satoshi" userId="ca2b3ca5d2e030cf" providerId="LiveId" clId="{C73E2EEB-F248-420B-B050-C3BDD783B668}" dt="2021-08-27T14:14:01.768" v="75" actId="1035"/>
          <ac:spMkLst>
            <pc:docMk/>
            <pc:sldMk cId="2949443104" sldId="256"/>
            <ac:spMk id="108" creationId="{F67A2E1F-E360-4A50-80B5-BDCC5A346DEE}"/>
          </ac:spMkLst>
        </pc:spChg>
        <pc:spChg chg="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109" creationId="{5C71C283-8484-4356-8CDD-308B37B0CF59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14" creationId="{34B91B78-6E34-4070-B94D-E2DFF3586DE7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15" creationId="{6E82E08D-9F70-4962-A42A-249618A8B60A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16" creationId="{11A04D80-0308-49BB-A8DE-232AB4381C49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17" creationId="{7FB038E1-7C20-4B87-9773-BB29F88E2CB7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18" creationId="{61946CFD-A7B3-4241-861B-E7AFC71D11A4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21" creationId="{CCABC704-B5AC-4901-95EB-6F4B5A9D3844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22" creationId="{A732B967-AFE6-4ABB-AEFE-53840C3B0BBC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23" creationId="{00887E2F-9078-4B90-ABE1-38F07F21B73E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24" creationId="{6030E776-1608-4438-A664-8F2F26948978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25" creationId="{EFC8E749-CC2D-4B8F-B2B2-3B5684744E19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26" creationId="{19887FD8-4B79-4DB3-9116-96D45B62B3FC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27" creationId="{3E85D322-4ED4-48DE-B6CD-A0D8DE7CEF90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28" creationId="{DC44FF83-19C1-4A91-9D8C-74015989AC91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29" creationId="{467575F4-E943-4B51-B70E-DB516FE1E67E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30" creationId="{DB513877-127C-49D6-BEE3-FE741D96C764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31" creationId="{C2C3C880-E790-472E-A614-3A6E1BA58ED5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32" creationId="{4855C08F-00F2-4C4D-8738-CD3DE0DA6CB5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33" creationId="{4089D2CD-E4FF-4095-BC1A-351D2753370C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34" creationId="{E2B6E284-66DB-431F-B8F7-E6FDB9C4B5E4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35" creationId="{7917105F-5ED6-4F06-8352-7C4B33578F17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36" creationId="{6E127BDC-A9E4-4FD0-9357-E9B94B0674CE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37" creationId="{11C67A07-DC6E-4ABF-8B1E-8501173CF45B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38" creationId="{F6EAB8D0-4558-4947-A5CA-8158F0DDB26B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39" creationId="{94FDDFFD-F5E7-43C2-9173-9891F1484A19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40" creationId="{7ACB6188-E7B1-4E24-B360-DC14D15D73DB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41" creationId="{0892F144-EFBF-48A7-AD84-7B5DE97F213F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42" creationId="{B52AA66F-2C49-4D00-8721-5CC032058584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43" creationId="{4F4186D2-3C7A-44C3-9906-B08F1A317620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44" creationId="{FBAACBF6-14C4-420D-B212-2F1128AC4F41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45" creationId="{78CFEF76-3359-44D3-8276-1F6D42DB2078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46" creationId="{A2C42260-BDA4-4405-B075-46F52AF5AC89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47" creationId="{8FC3CEAD-47C3-4C01-AC79-2580CB8A87B0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48" creationId="{2B29CCE6-2011-4EA1-BF34-70969C4CA170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49" creationId="{BF062832-B2BC-435E-ACC7-C568A0209C8D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50" creationId="{B4A38193-B48E-4922-BC33-94F5FFA7B8C0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51" creationId="{CE3178FD-F8A7-4A21-9E70-09CDF61582E7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52" creationId="{59BBBCC8-3300-4A53-925C-ED5297738797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53" creationId="{193543EE-5548-456C-BA6C-7BF0AF254DF3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54" creationId="{D4517A3C-0438-46BE-A9D3-C7240905F7A7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55" creationId="{5C08DCBE-AD2D-482B-8A36-6AA4F4179EB9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56" creationId="{C4795C8F-8552-4F57-88AB-D0AE2C8F1A21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57" creationId="{DC9DF1F5-125D-4C6B-987D-FBB0FC6262CD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58" creationId="{4C497DCA-79E5-40F3-980A-BF74CECA73E2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59" creationId="{C9626F79-794C-464D-B889-C367D61E5FA7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60" creationId="{AAB36402-56AE-4DFC-8E6A-FE867071AD4A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61" creationId="{5B24D218-2CF4-44E5-AF95-335701CA0FE2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62" creationId="{4F620676-F3AF-43AD-B327-7BF8A5523AF5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63" creationId="{4AF64B38-5F07-4156-B160-E051862893EC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64" creationId="{6AC2DB94-2367-4232-B88B-D49568FA1043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67" creationId="{9822BF06-B622-44E5-BFBB-A8F904F2AB1F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68" creationId="{15A803FC-3482-4AFB-BF92-93AB489E78C7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69" creationId="{C7244E7B-9468-4C44-A247-47CDD83F73D0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72" creationId="{B12F38D0-6B09-4B12-A742-4B7E6A1BD8AB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73" creationId="{CB9EC03C-EDDC-4E83-82DE-F09FD4B3C2C6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74" creationId="{B4157399-4612-419C-A223-47091CCAFA87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75" creationId="{12CBB072-EF21-4D85-84B8-708C25CF24F3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76" creationId="{3DAABCAF-0D32-4DDC-9DDA-AE99DFBD613E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77" creationId="{C1B63659-9460-4BD9-85D5-2B13354D8ADB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78" creationId="{685E2451-FBB9-49E2-A02D-E7322CC61EF1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79" creationId="{32A0A5C4-F51B-4A5C-9B1C-9128558C4305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80" creationId="{2BF5F005-7D0F-4429-BF27-A465553E6986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81" creationId="{00D95D77-2EBE-4C87-A59E-3342036DC9E5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82" creationId="{3AE9E97B-B27F-463E-8110-CC450B85D6BE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83" creationId="{36596BB1-C578-4167-8B00-F3922BCB97B6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84" creationId="{95CB3ABE-A0A9-47EC-B1EA-3D39EB02DA27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85" creationId="{80A42783-853C-4E29-AE4E-3B85ACE31C76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86" creationId="{15C810B8-B3AC-4BF4-9086-7EA3C34C4D04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87" creationId="{2895F1DA-D329-45F5-8449-78572E8FBD93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88" creationId="{D83910C7-D5F7-4A58-8C44-2CCAB23EA779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89" creationId="{920495C1-FC8A-43DA-A275-FEC913636277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90" creationId="{E9D75669-5C81-4988-8B03-E8F7C5AAC942}"/>
          </ac:spMkLst>
        </pc:spChg>
        <pc:spChg chg="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191" creationId="{2785B96C-3563-4052-A88E-26FD0985B443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92" creationId="{B06807FF-3B3E-40B4-9C81-8686D6C361C7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93" creationId="{9159AA64-A914-49AD-8009-1A603E3CE76D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94" creationId="{5FE16149-30D1-4F09-9312-75907A833C61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95" creationId="{C90C3A5F-026B-4CDF-897E-FD8CFBBA3B6C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96" creationId="{8054EE86-CBC0-4030-B1CA-0ADE181FF1A3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97" creationId="{EF91881C-62BF-476B-871B-B03AE8974FA1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98" creationId="{8CAFC6A0-E931-4061-8823-F394107D107B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199" creationId="{64F8C3A8-F5B8-4E62-B2DD-4A898C511D68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00" creationId="{66145C1B-D57E-4B11-B5AB-71A4639140B1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01" creationId="{70A49A46-73FA-4A29-AE9D-30638F7B96DC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02" creationId="{13FE8A25-CD61-4061-A4A1-DC465B4F86EB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03" creationId="{0C89E9CF-B667-4A09-AA14-01E47D6AE2A6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04" creationId="{B331D8C1-5BA2-4BDA-961D-51AF3243E0AA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05" creationId="{50892535-0FF7-4704-B88D-9D975D2B36F8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06" creationId="{3F814245-9E72-46F8-B90D-5F33EB0922AB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07" creationId="{AB1B75C6-010C-44EA-8FB3-CE8C2AE19A4A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08" creationId="{6CF443C0-0597-4614-96B2-8E17B6803DC0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09" creationId="{A073A2C9-09A5-4DFA-83E3-EDC4E43CCD02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10" creationId="{F7375D17-C9AE-4BDB-96AB-71F467B1349D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11" creationId="{0C0C40AB-6819-42F4-84C6-EB6A723A057F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12" creationId="{885A31BB-BE68-4275-9C31-748F327601D5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13" creationId="{1E03D66B-E3F2-44A3-A174-FF697E736FF2}"/>
          </ac:spMkLst>
        </pc:spChg>
        <pc:spChg chg="add 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216" creationId="{4D7FB3C4-DE86-4121-AF9D-891799E1CE71}"/>
          </ac:spMkLst>
        </pc:spChg>
        <pc:spChg chg="add mod">
          <ac:chgData name="Watanabe Satoshi" userId="ca2b3ca5d2e030cf" providerId="LiveId" clId="{C73E2EEB-F248-420B-B050-C3BDD783B668}" dt="2021-08-27T14:17:28.468" v="310" actId="554"/>
          <ac:spMkLst>
            <pc:docMk/>
            <pc:sldMk cId="2949443104" sldId="256"/>
            <ac:spMk id="217" creationId="{8E2DD971-B9C9-4112-A052-5EA01DB6990D}"/>
          </ac:spMkLst>
        </pc:spChg>
        <pc:spChg chg="add 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218" creationId="{FE513D52-6205-493B-BF67-F7C32A7B3407}"/>
          </ac:spMkLst>
        </pc:spChg>
        <pc:spChg chg="add 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219" creationId="{26A400D2-47EF-4221-92C0-96FDA851E0E4}"/>
          </ac:spMkLst>
        </pc:spChg>
        <pc:spChg chg="add mod">
          <ac:chgData name="Watanabe Satoshi" userId="ca2b3ca5d2e030cf" providerId="LiveId" clId="{C73E2EEB-F248-420B-B050-C3BDD783B668}" dt="2021-08-29T02:35:27.757" v="1132" actId="1036"/>
          <ac:spMkLst>
            <pc:docMk/>
            <pc:sldMk cId="2949443104" sldId="256"/>
            <ac:spMk id="220" creationId="{3D62DFBD-5EED-407A-A81D-B86BCD9D97B2}"/>
          </ac:spMkLst>
        </pc:spChg>
        <pc:spChg chg="add 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221" creationId="{36D70BA5-57C1-4D74-AEC8-F911DCAC9D58}"/>
          </ac:spMkLst>
        </pc:spChg>
        <pc:spChg chg="add 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22" creationId="{39B589B3-13F1-4CDE-BA66-263782F0BE45}"/>
          </ac:spMkLst>
        </pc:spChg>
        <pc:spChg chg="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23" creationId="{7D5ECED7-E042-4A7D-BF21-7A0D1251E475}"/>
          </ac:spMkLst>
        </pc:spChg>
        <pc:spChg chg="add mod">
          <ac:chgData name="Watanabe Satoshi" userId="ca2b3ca5d2e030cf" providerId="LiveId" clId="{C73E2EEB-F248-420B-B050-C3BDD783B668}" dt="2021-08-29T02:35:06.349" v="1126" actId="1035"/>
          <ac:spMkLst>
            <pc:docMk/>
            <pc:sldMk cId="2949443104" sldId="256"/>
            <ac:spMk id="224" creationId="{C1100F32-F13E-4269-BF18-DC93CE2C36F0}"/>
          </ac:spMkLst>
        </pc:spChg>
        <pc:spChg chg="add 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25" creationId="{D9535DE2-F727-4D3D-A310-C4B77D14DB48}"/>
          </ac:spMkLst>
        </pc:spChg>
        <pc:spChg chg="add del mod">
          <ac:chgData name="Watanabe Satoshi" userId="ca2b3ca5d2e030cf" providerId="LiveId" clId="{C73E2EEB-F248-420B-B050-C3BDD783B668}" dt="2021-08-27T15:34:21.665" v="455" actId="478"/>
          <ac:spMkLst>
            <pc:docMk/>
            <pc:sldMk cId="2949443104" sldId="256"/>
            <ac:spMk id="226" creationId="{891A8E72-A243-41E1-A424-7632BDDB627D}"/>
          </ac:spMkLst>
        </pc:spChg>
        <pc:spChg chg="add del mod">
          <ac:chgData name="Watanabe Satoshi" userId="ca2b3ca5d2e030cf" providerId="LiveId" clId="{C73E2EEB-F248-420B-B050-C3BDD783B668}" dt="2021-08-27T15:34:21.665" v="455" actId="478"/>
          <ac:spMkLst>
            <pc:docMk/>
            <pc:sldMk cId="2949443104" sldId="256"/>
            <ac:spMk id="227" creationId="{3B346FBF-F910-49B0-B6BF-153F2ACAFB8F}"/>
          </ac:spMkLst>
        </pc:spChg>
        <pc:spChg chg="add 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28" creationId="{9D7171CA-EFD2-43E8-816B-2688972B9B94}"/>
          </ac:spMkLst>
        </pc:spChg>
        <pc:spChg chg="add mod">
          <ac:chgData name="Watanabe Satoshi" userId="ca2b3ca5d2e030cf" providerId="LiveId" clId="{C73E2EEB-F248-420B-B050-C3BDD783B668}" dt="2021-08-29T02:35:16.984" v="1130" actId="1035"/>
          <ac:spMkLst>
            <pc:docMk/>
            <pc:sldMk cId="2949443104" sldId="256"/>
            <ac:spMk id="229" creationId="{C28C4DD6-FF4C-42B2-B972-DEB5E3D1A7BA}"/>
          </ac:spMkLst>
        </pc:spChg>
        <pc:graphicFrameChg chg="mod">
          <ac:chgData name="Watanabe Satoshi" userId="ca2b3ca5d2e030cf" providerId="LiveId" clId="{C73E2EEB-F248-420B-B050-C3BDD783B668}" dt="2021-08-28T03:55:12.266" v="563" actId="552"/>
          <ac:graphicFrameMkLst>
            <pc:docMk/>
            <pc:sldMk cId="2949443104" sldId="256"/>
            <ac:graphicFrameMk id="4" creationId="{F8819F86-1CBA-4FFB-8B55-6973D43E9070}"/>
          </ac:graphicFrameMkLst>
        </pc:graphicFrameChg>
        <pc:graphicFrameChg chg="mod">
          <ac:chgData name="Watanabe Satoshi" userId="ca2b3ca5d2e030cf" providerId="LiveId" clId="{C73E2EEB-F248-420B-B050-C3BDD783B668}" dt="2021-08-29T02:35:27.757" v="1132" actId="1036"/>
          <ac:graphicFrameMkLst>
            <pc:docMk/>
            <pc:sldMk cId="2949443104" sldId="256"/>
            <ac:graphicFrameMk id="32" creationId="{9F9EF7E9-B4EF-41BD-9AFB-C5F865606BB9}"/>
          </ac:graphicFrameMkLst>
        </pc:graphicFrameChg>
        <pc:graphicFrameChg chg="mod">
          <ac:chgData name="Watanabe Satoshi" userId="ca2b3ca5d2e030cf" providerId="LiveId" clId="{C73E2EEB-F248-420B-B050-C3BDD783B668}" dt="2021-08-28T03:55:17.701" v="564" actId="552"/>
          <ac:graphicFrameMkLst>
            <pc:docMk/>
            <pc:sldMk cId="2949443104" sldId="256"/>
            <ac:graphicFrameMk id="59" creationId="{D33BA302-83FF-4955-98B1-A5BC28A3215A}"/>
          </ac:graphicFrameMkLst>
        </pc:graphicFrameChg>
        <pc:graphicFrameChg chg="mod">
          <ac:chgData name="Watanabe Satoshi" userId="ca2b3ca5d2e030cf" providerId="LiveId" clId="{C73E2EEB-F248-420B-B050-C3BDD783B668}" dt="2021-08-29T02:35:27.757" v="1132" actId="1036"/>
          <ac:graphicFrameMkLst>
            <pc:docMk/>
            <pc:sldMk cId="2949443104" sldId="256"/>
            <ac:graphicFrameMk id="84" creationId="{57BDEF6B-D96D-4218-B489-C1DC06386EEE}"/>
          </ac:graphicFrameMkLst>
        </pc:graphicFrameChg>
        <pc:graphicFrameChg chg="mod">
          <ac:chgData name="Watanabe Satoshi" userId="ca2b3ca5d2e030cf" providerId="LiveId" clId="{C73E2EEB-F248-420B-B050-C3BDD783B668}" dt="2021-08-29T02:35:16.984" v="1130" actId="1035"/>
          <ac:graphicFrameMkLst>
            <pc:docMk/>
            <pc:sldMk cId="2949443104" sldId="256"/>
            <ac:graphicFrameMk id="110" creationId="{C1945521-166F-4C79-9F6C-EC0D45C15B44}"/>
          </ac:graphicFrameMkLst>
        </pc:graphicFrameChg>
        <pc:graphicFrameChg chg="mod">
          <ac:chgData name="Watanabe Satoshi" userId="ca2b3ca5d2e030cf" providerId="LiveId" clId="{C73E2EEB-F248-420B-B050-C3BDD783B668}" dt="2021-08-29T02:35:06.349" v="1126" actId="1035"/>
          <ac:graphicFrameMkLst>
            <pc:docMk/>
            <pc:sldMk cId="2949443104" sldId="256"/>
            <ac:graphicFrameMk id="111" creationId="{3BA802FD-D1C5-4CA4-B997-F4B3AC2F2434}"/>
          </ac:graphicFrameMkLst>
        </pc:graphicFrameChg>
        <pc:graphicFrameChg chg="mod">
          <ac:chgData name="Watanabe Satoshi" userId="ca2b3ca5d2e030cf" providerId="LiveId" clId="{C73E2EEB-F248-420B-B050-C3BDD783B668}" dt="2021-08-29T02:35:16.984" v="1130" actId="1035"/>
          <ac:graphicFrameMkLst>
            <pc:docMk/>
            <pc:sldMk cId="2949443104" sldId="256"/>
            <ac:graphicFrameMk id="112" creationId="{CF31A5DF-EF60-4778-9AA9-F257A17223A5}"/>
          </ac:graphicFrameMkLst>
        </pc:graphicFrameChg>
        <pc:graphicFrameChg chg="mod">
          <ac:chgData name="Watanabe Satoshi" userId="ca2b3ca5d2e030cf" providerId="LiveId" clId="{C73E2EEB-F248-420B-B050-C3BDD783B668}" dt="2021-08-29T02:35:06.349" v="1126" actId="1035"/>
          <ac:graphicFrameMkLst>
            <pc:docMk/>
            <pc:sldMk cId="2949443104" sldId="256"/>
            <ac:graphicFrameMk id="113" creationId="{E89DEC1B-1276-42B5-8BBA-3472C2914346}"/>
          </ac:graphicFrameMkLst>
        </pc:graphicFrameChg>
        <pc:cxnChg chg="mod">
          <ac:chgData name="Watanabe Satoshi" userId="ca2b3ca5d2e030cf" providerId="LiveId" clId="{C73E2EEB-F248-420B-B050-C3BDD783B668}" dt="2021-08-27T14:14:01.768" v="75" actId="1035"/>
          <ac:cxnSpMkLst>
            <pc:docMk/>
            <pc:sldMk cId="2949443104" sldId="256"/>
            <ac:cxnSpMk id="25" creationId="{057B4630-20E7-4ED9-90F8-3F288F076A07}"/>
          </ac:cxnSpMkLst>
        </pc:cxnChg>
        <pc:cxnChg chg="mod">
          <ac:chgData name="Watanabe Satoshi" userId="ca2b3ca5d2e030cf" providerId="LiveId" clId="{C73E2EEB-F248-420B-B050-C3BDD783B668}" dt="2021-08-27T14:14:01.768" v="75" actId="1035"/>
          <ac:cxnSpMkLst>
            <pc:docMk/>
            <pc:sldMk cId="2949443104" sldId="256"/>
            <ac:cxnSpMk id="26" creationId="{A1C1A65C-84C3-4FA0-9FBA-C07D6D0DF825}"/>
          </ac:cxnSpMkLst>
        </pc:cxnChg>
        <pc:cxnChg chg="mod">
          <ac:chgData name="Watanabe Satoshi" userId="ca2b3ca5d2e030cf" providerId="LiveId" clId="{C73E2EEB-F248-420B-B050-C3BDD783B668}" dt="2021-08-29T02:35:27.757" v="1132" actId="1036"/>
          <ac:cxnSpMkLst>
            <pc:docMk/>
            <pc:sldMk cId="2949443104" sldId="256"/>
            <ac:cxnSpMk id="56" creationId="{2728A18C-3117-4529-B411-03D1EDD45CD1}"/>
          </ac:cxnSpMkLst>
        </pc:cxnChg>
        <pc:cxnChg chg="mod">
          <ac:chgData name="Watanabe Satoshi" userId="ca2b3ca5d2e030cf" providerId="LiveId" clId="{C73E2EEB-F248-420B-B050-C3BDD783B668}" dt="2021-08-29T02:35:27.757" v="1132" actId="1036"/>
          <ac:cxnSpMkLst>
            <pc:docMk/>
            <pc:sldMk cId="2949443104" sldId="256"/>
            <ac:cxnSpMk id="57" creationId="{33002B35-352C-4AF3-ADE1-B45D29FA091D}"/>
          </ac:cxnSpMkLst>
        </pc:cxnChg>
        <pc:cxnChg chg="mod">
          <ac:chgData name="Watanabe Satoshi" userId="ca2b3ca5d2e030cf" providerId="LiveId" clId="{C73E2EEB-F248-420B-B050-C3BDD783B668}" dt="2021-08-27T14:14:01.768" v="75" actId="1035"/>
          <ac:cxnSpMkLst>
            <pc:docMk/>
            <pc:sldMk cId="2949443104" sldId="256"/>
            <ac:cxnSpMk id="63" creationId="{7FC72F69-F136-4621-96ED-B83DADA20C2E}"/>
          </ac:cxnSpMkLst>
        </pc:cxnChg>
        <pc:cxnChg chg="mod">
          <ac:chgData name="Watanabe Satoshi" userId="ca2b3ca5d2e030cf" providerId="LiveId" clId="{C73E2EEB-F248-420B-B050-C3BDD783B668}" dt="2021-08-27T14:14:01.768" v="75" actId="1035"/>
          <ac:cxnSpMkLst>
            <pc:docMk/>
            <pc:sldMk cId="2949443104" sldId="256"/>
            <ac:cxnSpMk id="64" creationId="{4DCEBFD5-125C-4C7A-A6FE-5CFC9DE52261}"/>
          </ac:cxnSpMkLst>
        </pc:cxnChg>
        <pc:cxnChg chg="mod">
          <ac:chgData name="Watanabe Satoshi" userId="ca2b3ca5d2e030cf" providerId="LiveId" clId="{C73E2EEB-F248-420B-B050-C3BDD783B668}" dt="2021-08-29T02:35:27.757" v="1132" actId="1036"/>
          <ac:cxnSpMkLst>
            <pc:docMk/>
            <pc:sldMk cId="2949443104" sldId="256"/>
            <ac:cxnSpMk id="106" creationId="{56357728-D0F2-4EFB-B46F-40C4D49ADD64}"/>
          </ac:cxnSpMkLst>
        </pc:cxnChg>
        <pc:cxnChg chg="mod">
          <ac:chgData name="Watanabe Satoshi" userId="ca2b3ca5d2e030cf" providerId="LiveId" clId="{C73E2EEB-F248-420B-B050-C3BDD783B668}" dt="2021-08-29T02:35:27.757" v="1132" actId="1036"/>
          <ac:cxnSpMkLst>
            <pc:docMk/>
            <pc:sldMk cId="2949443104" sldId="256"/>
            <ac:cxnSpMk id="107" creationId="{5BD5BE12-A42A-4EEC-80F5-68B8A3ADE0DB}"/>
          </ac:cxnSpMkLst>
        </pc:cxnChg>
        <pc:cxnChg chg="mod">
          <ac:chgData name="Watanabe Satoshi" userId="ca2b3ca5d2e030cf" providerId="LiveId" clId="{C73E2EEB-F248-420B-B050-C3BDD783B668}" dt="2021-08-29T02:35:06.349" v="1126" actId="1035"/>
          <ac:cxnSpMkLst>
            <pc:docMk/>
            <pc:sldMk cId="2949443104" sldId="256"/>
            <ac:cxnSpMk id="119" creationId="{4C053926-39D5-49FB-8717-213BADA78BB2}"/>
          </ac:cxnSpMkLst>
        </pc:cxnChg>
        <pc:cxnChg chg="mod">
          <ac:chgData name="Watanabe Satoshi" userId="ca2b3ca5d2e030cf" providerId="LiveId" clId="{C73E2EEB-F248-420B-B050-C3BDD783B668}" dt="2021-08-29T02:35:06.349" v="1126" actId="1035"/>
          <ac:cxnSpMkLst>
            <pc:docMk/>
            <pc:sldMk cId="2949443104" sldId="256"/>
            <ac:cxnSpMk id="120" creationId="{837E3B79-DC9E-4A8A-B9F2-760C76CD050C}"/>
          </ac:cxnSpMkLst>
        </pc:cxnChg>
        <pc:cxnChg chg="mod">
          <ac:chgData name="Watanabe Satoshi" userId="ca2b3ca5d2e030cf" providerId="LiveId" clId="{C73E2EEB-F248-420B-B050-C3BDD783B668}" dt="2021-08-29T02:35:16.984" v="1130" actId="1035"/>
          <ac:cxnSpMkLst>
            <pc:docMk/>
            <pc:sldMk cId="2949443104" sldId="256"/>
            <ac:cxnSpMk id="165" creationId="{65713F41-B066-4774-B326-BF22582B7312}"/>
          </ac:cxnSpMkLst>
        </pc:cxnChg>
        <pc:cxnChg chg="mod">
          <ac:chgData name="Watanabe Satoshi" userId="ca2b3ca5d2e030cf" providerId="LiveId" clId="{C73E2EEB-F248-420B-B050-C3BDD783B668}" dt="2021-08-29T02:35:16.984" v="1130" actId="1035"/>
          <ac:cxnSpMkLst>
            <pc:docMk/>
            <pc:sldMk cId="2949443104" sldId="256"/>
            <ac:cxnSpMk id="166" creationId="{5E0327FA-623F-40D8-9E64-8EF8A06E0972}"/>
          </ac:cxnSpMkLst>
        </pc:cxnChg>
        <pc:cxnChg chg="mod">
          <ac:chgData name="Watanabe Satoshi" userId="ca2b3ca5d2e030cf" providerId="LiveId" clId="{C73E2EEB-F248-420B-B050-C3BDD783B668}" dt="2021-08-29T02:35:06.349" v="1126" actId="1035"/>
          <ac:cxnSpMkLst>
            <pc:docMk/>
            <pc:sldMk cId="2949443104" sldId="256"/>
            <ac:cxnSpMk id="170" creationId="{5D043A8C-78D8-4D0A-8573-E74E2DB975B2}"/>
          </ac:cxnSpMkLst>
        </pc:cxnChg>
        <pc:cxnChg chg="mod">
          <ac:chgData name="Watanabe Satoshi" userId="ca2b3ca5d2e030cf" providerId="LiveId" clId="{C73E2EEB-F248-420B-B050-C3BDD783B668}" dt="2021-08-29T02:35:06.349" v="1126" actId="1035"/>
          <ac:cxnSpMkLst>
            <pc:docMk/>
            <pc:sldMk cId="2949443104" sldId="256"/>
            <ac:cxnSpMk id="171" creationId="{35CD6A5C-4F12-4B44-9290-E024F8BFAAB0}"/>
          </ac:cxnSpMkLst>
        </pc:cxnChg>
        <pc:cxnChg chg="mod">
          <ac:chgData name="Watanabe Satoshi" userId="ca2b3ca5d2e030cf" providerId="LiveId" clId="{C73E2EEB-F248-420B-B050-C3BDD783B668}" dt="2021-08-29T02:35:16.984" v="1130" actId="1035"/>
          <ac:cxnSpMkLst>
            <pc:docMk/>
            <pc:sldMk cId="2949443104" sldId="256"/>
            <ac:cxnSpMk id="214" creationId="{29571E4E-3B0B-42F6-B39D-8294070ECD56}"/>
          </ac:cxnSpMkLst>
        </pc:cxnChg>
        <pc:cxnChg chg="mod">
          <ac:chgData name="Watanabe Satoshi" userId="ca2b3ca5d2e030cf" providerId="LiveId" clId="{C73E2EEB-F248-420B-B050-C3BDD783B668}" dt="2021-08-29T02:35:16.984" v="1130" actId="1035"/>
          <ac:cxnSpMkLst>
            <pc:docMk/>
            <pc:sldMk cId="2949443104" sldId="256"/>
            <ac:cxnSpMk id="215" creationId="{DC537852-A962-477F-B443-BE54B2897EA8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0</c:v>
          </c:tx>
          <c:spPr>
            <a:ln w="38100">
              <a:solidFill>
                <a:schemeClr val="accent1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4569-488C-B951-E32A42FB6F2C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4569-488C-B951-E32A42FB6F2C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2-4569-488C-B951-E32A42FB6F2C}"/>
              </c:ext>
            </c:extLst>
          </c:dPt>
          <c:dPt>
            <c:idx val="4"/>
            <c:bubble3D val="0"/>
            <c:extLst>
              <c:ext xmlns:c16="http://schemas.microsoft.com/office/drawing/2014/chart" uri="{C3380CC4-5D6E-409C-BE32-E72D297353CC}">
                <c16:uniqueId val="{00000003-4569-488C-B951-E32A42FB6F2C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04-4569-488C-B951-E32A42FB6F2C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05-4569-488C-B951-E32A42FB6F2C}"/>
              </c:ext>
            </c:extLst>
          </c:dPt>
          <c:dPt>
            <c:idx val="10"/>
            <c:bubble3D val="0"/>
            <c:extLst>
              <c:ext xmlns:c16="http://schemas.microsoft.com/office/drawing/2014/chart" uri="{C3380CC4-5D6E-409C-BE32-E72D297353CC}">
                <c16:uniqueId val="{00000006-4569-488C-B951-E32A42FB6F2C}"/>
              </c:ext>
            </c:extLst>
          </c:dPt>
          <c:dPt>
            <c:idx val="12"/>
            <c:bubble3D val="0"/>
            <c:extLst>
              <c:ext xmlns:c16="http://schemas.microsoft.com/office/drawing/2014/chart" uri="{C3380CC4-5D6E-409C-BE32-E72D297353CC}">
                <c16:uniqueId val="{00000007-4569-488C-B951-E32A42FB6F2C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08-4569-488C-B951-E32A42FB6F2C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09-4569-488C-B951-E32A42FB6F2C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0A-4569-488C-B951-E32A42FB6F2C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0B-4569-488C-B951-E32A42FB6F2C}"/>
              </c:ext>
            </c:extLst>
          </c:dPt>
          <c:dPt>
            <c:idx val="20"/>
            <c:bubble3D val="0"/>
            <c:extLst>
              <c:ext xmlns:c16="http://schemas.microsoft.com/office/drawing/2014/chart" uri="{C3380CC4-5D6E-409C-BE32-E72D297353CC}">
                <c16:uniqueId val="{0000000C-4569-488C-B951-E32A42FB6F2C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0D-4569-488C-B951-E32A42FB6F2C}"/>
              </c:ext>
            </c:extLst>
          </c:dPt>
          <c:dPt>
            <c:idx val="24"/>
            <c:bubble3D val="0"/>
            <c:extLst>
              <c:ext xmlns:c16="http://schemas.microsoft.com/office/drawing/2014/chart" uri="{C3380CC4-5D6E-409C-BE32-E72D297353CC}">
                <c16:uniqueId val="{0000000E-4569-488C-B951-E32A42FB6F2C}"/>
              </c:ext>
            </c:extLst>
          </c:dPt>
          <c:dPt>
            <c:idx val="25"/>
            <c:bubble3D val="0"/>
            <c:extLst>
              <c:ext xmlns:c16="http://schemas.microsoft.com/office/drawing/2014/chart" uri="{C3380CC4-5D6E-409C-BE32-E72D297353CC}">
                <c16:uniqueId val="{0000000F-4569-488C-B951-E32A42FB6F2C}"/>
              </c:ext>
            </c:extLst>
          </c:dPt>
          <c:dPt>
            <c:idx val="26"/>
            <c:bubble3D val="0"/>
            <c:extLst>
              <c:ext xmlns:c16="http://schemas.microsoft.com/office/drawing/2014/chart" uri="{C3380CC4-5D6E-409C-BE32-E72D297353CC}">
                <c16:uniqueId val="{00000010-4569-488C-B951-E32A42FB6F2C}"/>
              </c:ext>
            </c:extLst>
          </c:dPt>
          <c:dPt>
            <c:idx val="27"/>
            <c:bubble3D val="0"/>
            <c:extLst>
              <c:ext xmlns:c16="http://schemas.microsoft.com/office/drawing/2014/chart" uri="{C3380CC4-5D6E-409C-BE32-E72D297353CC}">
                <c16:uniqueId val="{00000011-4569-488C-B951-E32A42FB6F2C}"/>
              </c:ext>
            </c:extLst>
          </c:dPt>
          <c:dPt>
            <c:idx val="28"/>
            <c:bubble3D val="0"/>
            <c:extLst>
              <c:ext xmlns:c16="http://schemas.microsoft.com/office/drawing/2014/chart" uri="{C3380CC4-5D6E-409C-BE32-E72D297353CC}">
                <c16:uniqueId val="{00000012-4569-488C-B951-E32A42FB6F2C}"/>
              </c:ext>
            </c:extLst>
          </c:dPt>
          <c:dPt>
            <c:idx val="29"/>
            <c:bubble3D val="0"/>
            <c:extLst>
              <c:ext xmlns:c16="http://schemas.microsoft.com/office/drawing/2014/chart" uri="{C3380CC4-5D6E-409C-BE32-E72D297353CC}">
                <c16:uniqueId val="{00000013-4569-488C-B951-E32A42FB6F2C}"/>
              </c:ext>
            </c:extLst>
          </c:dPt>
          <c:dPt>
            <c:idx val="30"/>
            <c:bubble3D val="0"/>
            <c:extLst>
              <c:ext xmlns:c16="http://schemas.microsoft.com/office/drawing/2014/chart" uri="{C3380CC4-5D6E-409C-BE32-E72D297353CC}">
                <c16:uniqueId val="{00000014-4569-488C-B951-E32A42FB6F2C}"/>
              </c:ext>
            </c:extLst>
          </c:dPt>
          <c:dPt>
            <c:idx val="31"/>
            <c:bubble3D val="0"/>
            <c:extLst>
              <c:ext xmlns:c16="http://schemas.microsoft.com/office/drawing/2014/chart" uri="{C3380CC4-5D6E-409C-BE32-E72D297353CC}">
                <c16:uniqueId val="{00000015-4569-488C-B951-E32A42FB6F2C}"/>
              </c:ext>
            </c:extLst>
          </c:dPt>
          <c:dPt>
            <c:idx val="32"/>
            <c:bubble3D val="0"/>
            <c:extLst>
              <c:ext xmlns:c16="http://schemas.microsoft.com/office/drawing/2014/chart" uri="{C3380CC4-5D6E-409C-BE32-E72D297353CC}">
                <c16:uniqueId val="{00000016-4569-488C-B951-E32A42FB6F2C}"/>
              </c:ext>
            </c:extLst>
          </c:dPt>
          <c:dPt>
            <c:idx val="33"/>
            <c:bubble3D val="0"/>
            <c:extLst>
              <c:ext xmlns:c16="http://schemas.microsoft.com/office/drawing/2014/chart" uri="{C3380CC4-5D6E-409C-BE32-E72D297353CC}">
                <c16:uniqueId val="{00000017-4569-488C-B951-E32A42FB6F2C}"/>
              </c:ext>
            </c:extLst>
          </c:dPt>
          <c:dPt>
            <c:idx val="34"/>
            <c:bubble3D val="0"/>
            <c:extLst>
              <c:ext xmlns:c16="http://schemas.microsoft.com/office/drawing/2014/chart" uri="{C3380CC4-5D6E-409C-BE32-E72D297353CC}">
                <c16:uniqueId val="{00000018-4569-488C-B951-E32A42FB6F2C}"/>
              </c:ext>
            </c:extLst>
          </c:dPt>
          <c:dPt>
            <c:idx val="35"/>
            <c:bubble3D val="0"/>
            <c:extLst>
              <c:ext xmlns:c16="http://schemas.microsoft.com/office/drawing/2014/chart" uri="{C3380CC4-5D6E-409C-BE32-E72D297353CC}">
                <c16:uniqueId val="{00000019-4569-488C-B951-E32A42FB6F2C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1!$I$7:$I$42</c:f>
                <c:numCache>
                  <c:formatCode>General</c:formatCode>
                  <c:ptCount val="3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3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</c:v>
                  </c:pt>
                  <c:pt idx="23">
                    <c:v>0</c:v>
                  </c:pt>
                  <c:pt idx="24">
                    <c:v>3</c:v>
                  </c:pt>
                  <c:pt idx="25">
                    <c:v>0</c:v>
                  </c:pt>
                  <c:pt idx="26">
                    <c:v>3</c:v>
                  </c:pt>
                  <c:pt idx="27">
                    <c:v>0</c:v>
                  </c:pt>
                  <c:pt idx="28">
                    <c:v>3</c:v>
                  </c:pt>
                  <c:pt idx="29">
                    <c:v>0</c:v>
                  </c:pt>
                  <c:pt idx="30">
                    <c:v>3</c:v>
                  </c:pt>
                  <c:pt idx="31">
                    <c:v>0</c:v>
                  </c:pt>
                  <c:pt idx="32">
                    <c:v>3</c:v>
                  </c:pt>
                  <c:pt idx="33">
                    <c:v>0</c:v>
                  </c:pt>
                  <c:pt idx="34">
                    <c:v>3</c:v>
                  </c:pt>
                  <c:pt idx="35">
                    <c:v>0</c:v>
                  </c:pt>
                </c:numCache>
              </c:numRef>
            </c:plus>
          </c:errBars>
          <c:xVal>
            <c:numRef>
              <c:f>Kaplan1!$G$7:$G$42</c:f>
              <c:numCache>
                <c:formatCode>0.000</c:formatCode>
                <c:ptCount val="36"/>
                <c:pt idx="0">
                  <c:v>0</c:v>
                </c:pt>
                <c:pt idx="1">
                  <c:v>1.5357142857142858</c:v>
                </c:pt>
                <c:pt idx="2">
                  <c:v>1.5357142857142858</c:v>
                </c:pt>
                <c:pt idx="3">
                  <c:v>1.5714285714285714</c:v>
                </c:pt>
                <c:pt idx="4">
                  <c:v>1.9285714285714286</c:v>
                </c:pt>
                <c:pt idx="5">
                  <c:v>1.9285714285714286</c:v>
                </c:pt>
                <c:pt idx="6">
                  <c:v>2.1428571428571428</c:v>
                </c:pt>
                <c:pt idx="7">
                  <c:v>2.1428571428571428</c:v>
                </c:pt>
                <c:pt idx="8">
                  <c:v>2.2857142857142856</c:v>
                </c:pt>
                <c:pt idx="9">
                  <c:v>2.2857142857142856</c:v>
                </c:pt>
                <c:pt idx="10">
                  <c:v>3.5</c:v>
                </c:pt>
                <c:pt idx="11">
                  <c:v>3.5</c:v>
                </c:pt>
                <c:pt idx="12">
                  <c:v>4.6071428571428568</c:v>
                </c:pt>
                <c:pt idx="13">
                  <c:v>4.6071428571428568</c:v>
                </c:pt>
                <c:pt idx="14">
                  <c:v>5.0357142857142856</c:v>
                </c:pt>
                <c:pt idx="15">
                  <c:v>5.0357142857142856</c:v>
                </c:pt>
                <c:pt idx="16">
                  <c:v>10.607142857142858</c:v>
                </c:pt>
                <c:pt idx="17">
                  <c:v>10.607142857142858</c:v>
                </c:pt>
                <c:pt idx="18">
                  <c:v>14.285714285714286</c:v>
                </c:pt>
                <c:pt idx="19">
                  <c:v>14.285714285714286</c:v>
                </c:pt>
                <c:pt idx="20">
                  <c:v>15.5</c:v>
                </c:pt>
                <c:pt idx="21">
                  <c:v>15.5</c:v>
                </c:pt>
                <c:pt idx="22">
                  <c:v>15.535714285714286</c:v>
                </c:pt>
                <c:pt idx="23">
                  <c:v>15.535714285714286</c:v>
                </c:pt>
                <c:pt idx="24">
                  <c:v>17</c:v>
                </c:pt>
                <c:pt idx="25">
                  <c:v>17</c:v>
                </c:pt>
                <c:pt idx="26">
                  <c:v>20.25</c:v>
                </c:pt>
                <c:pt idx="27">
                  <c:v>20.25</c:v>
                </c:pt>
                <c:pt idx="28">
                  <c:v>24.75</c:v>
                </c:pt>
                <c:pt idx="29">
                  <c:v>24.75</c:v>
                </c:pt>
                <c:pt idx="30">
                  <c:v>25.607142857142858</c:v>
                </c:pt>
                <c:pt idx="31">
                  <c:v>25.607142857142858</c:v>
                </c:pt>
                <c:pt idx="32">
                  <c:v>26</c:v>
                </c:pt>
                <c:pt idx="33">
                  <c:v>26</c:v>
                </c:pt>
                <c:pt idx="34">
                  <c:v>26.428571428571427</c:v>
                </c:pt>
                <c:pt idx="35">
                  <c:v>26.428571428571427</c:v>
                </c:pt>
              </c:numCache>
            </c:numRef>
          </c:xVal>
          <c:yVal>
            <c:numRef>
              <c:f>Kaplan1!$H$7:$H$42</c:f>
              <c:numCache>
                <c:formatCode>0.000</c:formatCode>
                <c:ptCount val="36"/>
                <c:pt idx="0">
                  <c:v>100</c:v>
                </c:pt>
                <c:pt idx="1">
                  <c:v>100</c:v>
                </c:pt>
                <c:pt idx="2">
                  <c:v>94.444444444444443</c:v>
                </c:pt>
                <c:pt idx="3">
                  <c:v>94.444444444444443</c:v>
                </c:pt>
                <c:pt idx="4">
                  <c:v>94.444444444444443</c:v>
                </c:pt>
                <c:pt idx="5">
                  <c:v>88.541666666666657</c:v>
                </c:pt>
                <c:pt idx="6">
                  <c:v>88.541666666666657</c:v>
                </c:pt>
                <c:pt idx="7">
                  <c:v>82.638888888888886</c:v>
                </c:pt>
                <c:pt idx="8">
                  <c:v>82.638888888888886</c:v>
                </c:pt>
                <c:pt idx="9">
                  <c:v>76.7361111111111</c:v>
                </c:pt>
                <c:pt idx="10">
                  <c:v>76.7361111111111</c:v>
                </c:pt>
                <c:pt idx="11">
                  <c:v>70.833333333333343</c:v>
                </c:pt>
                <c:pt idx="12">
                  <c:v>70.833333333333343</c:v>
                </c:pt>
                <c:pt idx="13">
                  <c:v>64.930555555555557</c:v>
                </c:pt>
                <c:pt idx="14">
                  <c:v>64.930555555555557</c:v>
                </c:pt>
                <c:pt idx="15">
                  <c:v>59.027777777777779</c:v>
                </c:pt>
                <c:pt idx="16">
                  <c:v>59.027777777777779</c:v>
                </c:pt>
                <c:pt idx="17">
                  <c:v>53.125</c:v>
                </c:pt>
                <c:pt idx="18">
                  <c:v>53.125</c:v>
                </c:pt>
                <c:pt idx="19">
                  <c:v>53.125</c:v>
                </c:pt>
                <c:pt idx="20">
                  <c:v>53.125</c:v>
                </c:pt>
                <c:pt idx="21">
                  <c:v>46.484375</c:v>
                </c:pt>
                <c:pt idx="22">
                  <c:v>46.484375</c:v>
                </c:pt>
                <c:pt idx="23">
                  <c:v>39.84375</c:v>
                </c:pt>
                <c:pt idx="24">
                  <c:v>39.84375</c:v>
                </c:pt>
                <c:pt idx="25">
                  <c:v>39.84375</c:v>
                </c:pt>
                <c:pt idx="26">
                  <c:v>39.84375</c:v>
                </c:pt>
                <c:pt idx="27">
                  <c:v>39.84375</c:v>
                </c:pt>
                <c:pt idx="28">
                  <c:v>39.84375</c:v>
                </c:pt>
                <c:pt idx="29">
                  <c:v>39.84375</c:v>
                </c:pt>
                <c:pt idx="30">
                  <c:v>39.84375</c:v>
                </c:pt>
                <c:pt idx="31">
                  <c:v>39.84375</c:v>
                </c:pt>
                <c:pt idx="32">
                  <c:v>39.84375</c:v>
                </c:pt>
                <c:pt idx="33">
                  <c:v>39.84375</c:v>
                </c:pt>
                <c:pt idx="34">
                  <c:v>39.84375</c:v>
                </c:pt>
                <c:pt idx="35">
                  <c:v>39.843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4569-488C-B951-E32A42FB6F2C}"/>
            </c:ext>
          </c:extLst>
        </c:ser>
        <c:ser>
          <c:idx val="1"/>
          <c:order val="1"/>
          <c:tx>
            <c:v>1</c:v>
          </c:tx>
          <c:spPr>
            <a:ln w="38100">
              <a:solidFill>
                <a:schemeClr val="accent2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1B-4569-488C-B951-E32A42FB6F2C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1C-4569-488C-B951-E32A42FB6F2C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1D-4569-488C-B951-E32A42FB6F2C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1E-4569-488C-B951-E32A42FB6F2C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1F-4569-488C-B951-E32A42FB6F2C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2!$I$7:$I$1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</c:numCache>
              </c:numRef>
            </c:plus>
          </c:errBars>
          <c:xVal>
            <c:numRef>
              <c:f>Kaplan2!$G$7:$G$13</c:f>
              <c:numCache>
                <c:formatCode>0.000</c:formatCode>
                <c:ptCount val="7"/>
                <c:pt idx="0">
                  <c:v>0</c:v>
                </c:pt>
                <c:pt idx="1">
                  <c:v>8.4642857142857135</c:v>
                </c:pt>
                <c:pt idx="2">
                  <c:v>8.4642857142857135</c:v>
                </c:pt>
                <c:pt idx="3">
                  <c:v>10.928571428571429</c:v>
                </c:pt>
                <c:pt idx="4">
                  <c:v>10.928571428571429</c:v>
                </c:pt>
                <c:pt idx="5">
                  <c:v>31.642857142857142</c:v>
                </c:pt>
                <c:pt idx="6">
                  <c:v>31.642857142857142</c:v>
                </c:pt>
              </c:numCache>
            </c:numRef>
          </c:xVal>
          <c:yVal>
            <c:numRef>
              <c:f>Kaplan2!$H$7:$H$13</c:f>
              <c:numCache>
                <c:formatCode>0.000</c:formatCode>
                <c:ptCount val="7"/>
                <c:pt idx="0">
                  <c:v>100</c:v>
                </c:pt>
                <c:pt idx="1">
                  <c:v>100</c:v>
                </c:pt>
                <c:pt idx="2">
                  <c:v>66.666666666666657</c:v>
                </c:pt>
                <c:pt idx="3">
                  <c:v>66.666666666666657</c:v>
                </c:pt>
                <c:pt idx="4">
                  <c:v>33.333333333333329</c:v>
                </c:pt>
                <c:pt idx="5">
                  <c:v>33.333333333333329</c:v>
                </c:pt>
                <c:pt idx="6">
                  <c:v>33.3333333333333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4569-488C-B951-E32A42FB6F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31337264"/>
        <c:axId val="2031338512"/>
      </c:scatterChart>
      <c:valAx>
        <c:axId val="2031337264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2031338512"/>
        <c:crosses val="autoZero"/>
        <c:crossBetween val="midCat"/>
      </c:valAx>
      <c:valAx>
        <c:axId val="2031338512"/>
        <c:scaling>
          <c:orientation val="minMax"/>
          <c:max val="10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2031337264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2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0</c:v>
          </c:tx>
          <c:spPr>
            <a:ln w="38100">
              <a:solidFill>
                <a:schemeClr val="accent1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E421-467E-9AFB-3EAFF1F59B94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E421-467E-9AFB-3EAFF1F59B94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2-E421-467E-9AFB-3EAFF1F59B94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03-E421-467E-9AFB-3EAFF1F59B94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04-E421-467E-9AFB-3EAFF1F59B94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05-E421-467E-9AFB-3EAFF1F59B94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06-E421-467E-9AFB-3EAFF1F59B94}"/>
              </c:ext>
            </c:extLst>
          </c:dPt>
          <c:dPt>
            <c:idx val="10"/>
            <c:bubble3D val="0"/>
            <c:extLst>
              <c:ext xmlns:c16="http://schemas.microsoft.com/office/drawing/2014/chart" uri="{C3380CC4-5D6E-409C-BE32-E72D297353CC}">
                <c16:uniqueId val="{00000007-E421-467E-9AFB-3EAFF1F59B94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08-E421-467E-9AFB-3EAFF1F59B94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09-E421-467E-9AFB-3EAFF1F59B94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0A-E421-467E-9AFB-3EAFF1F59B94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0B-E421-467E-9AFB-3EAFF1F59B94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0C-E421-467E-9AFB-3EAFF1F59B94}"/>
              </c:ext>
            </c:extLst>
          </c:dPt>
          <c:dPt>
            <c:idx val="21"/>
            <c:bubble3D val="0"/>
            <c:extLst>
              <c:ext xmlns:c16="http://schemas.microsoft.com/office/drawing/2014/chart" uri="{C3380CC4-5D6E-409C-BE32-E72D297353CC}">
                <c16:uniqueId val="{0000000D-E421-467E-9AFB-3EAFF1F59B94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0E-E421-467E-9AFB-3EAFF1F59B94}"/>
              </c:ext>
            </c:extLst>
          </c:dPt>
          <c:dPt>
            <c:idx val="23"/>
            <c:bubble3D val="0"/>
            <c:extLst>
              <c:ext xmlns:c16="http://schemas.microsoft.com/office/drawing/2014/chart" uri="{C3380CC4-5D6E-409C-BE32-E72D297353CC}">
                <c16:uniqueId val="{0000000F-E421-467E-9AFB-3EAFF1F59B94}"/>
              </c:ext>
            </c:extLst>
          </c:dPt>
          <c:dPt>
            <c:idx val="25"/>
            <c:bubble3D val="0"/>
            <c:extLst>
              <c:ext xmlns:c16="http://schemas.microsoft.com/office/drawing/2014/chart" uri="{C3380CC4-5D6E-409C-BE32-E72D297353CC}">
                <c16:uniqueId val="{00000010-E421-467E-9AFB-3EAFF1F59B94}"/>
              </c:ext>
            </c:extLst>
          </c:dPt>
          <c:dPt>
            <c:idx val="27"/>
            <c:bubble3D val="0"/>
            <c:extLst>
              <c:ext xmlns:c16="http://schemas.microsoft.com/office/drawing/2014/chart" uri="{C3380CC4-5D6E-409C-BE32-E72D297353CC}">
                <c16:uniqueId val="{00000011-E421-467E-9AFB-3EAFF1F59B94}"/>
              </c:ext>
            </c:extLst>
          </c:dPt>
          <c:dPt>
            <c:idx val="28"/>
            <c:bubble3D val="0"/>
            <c:extLst>
              <c:ext xmlns:c16="http://schemas.microsoft.com/office/drawing/2014/chart" uri="{C3380CC4-5D6E-409C-BE32-E72D297353CC}">
                <c16:uniqueId val="{00000012-E421-467E-9AFB-3EAFF1F59B94}"/>
              </c:ext>
            </c:extLst>
          </c:dPt>
          <c:dPt>
            <c:idx val="29"/>
            <c:bubble3D val="0"/>
            <c:extLst>
              <c:ext xmlns:c16="http://schemas.microsoft.com/office/drawing/2014/chart" uri="{C3380CC4-5D6E-409C-BE32-E72D297353CC}">
                <c16:uniqueId val="{00000013-E421-467E-9AFB-3EAFF1F59B94}"/>
              </c:ext>
            </c:extLst>
          </c:dPt>
          <c:dPt>
            <c:idx val="30"/>
            <c:bubble3D val="0"/>
            <c:extLst>
              <c:ext xmlns:c16="http://schemas.microsoft.com/office/drawing/2014/chart" uri="{C3380CC4-5D6E-409C-BE32-E72D297353CC}">
                <c16:uniqueId val="{00000014-E421-467E-9AFB-3EAFF1F59B94}"/>
              </c:ext>
            </c:extLst>
          </c:dPt>
          <c:dPt>
            <c:idx val="31"/>
            <c:bubble3D val="0"/>
            <c:extLst>
              <c:ext xmlns:c16="http://schemas.microsoft.com/office/drawing/2014/chart" uri="{C3380CC4-5D6E-409C-BE32-E72D297353CC}">
                <c16:uniqueId val="{00000015-E421-467E-9AFB-3EAFF1F59B94}"/>
              </c:ext>
            </c:extLst>
          </c:dPt>
          <c:dPt>
            <c:idx val="32"/>
            <c:bubble3D val="0"/>
            <c:extLst>
              <c:ext xmlns:c16="http://schemas.microsoft.com/office/drawing/2014/chart" uri="{C3380CC4-5D6E-409C-BE32-E72D297353CC}">
                <c16:uniqueId val="{00000016-E421-467E-9AFB-3EAFF1F59B94}"/>
              </c:ext>
            </c:extLst>
          </c:dPt>
          <c:dPt>
            <c:idx val="33"/>
            <c:bubble3D val="0"/>
            <c:extLst>
              <c:ext xmlns:c16="http://schemas.microsoft.com/office/drawing/2014/chart" uri="{C3380CC4-5D6E-409C-BE32-E72D297353CC}">
                <c16:uniqueId val="{00000017-E421-467E-9AFB-3EAFF1F59B94}"/>
              </c:ext>
            </c:extLst>
          </c:dPt>
          <c:dPt>
            <c:idx val="34"/>
            <c:bubble3D val="0"/>
            <c:extLst>
              <c:ext xmlns:c16="http://schemas.microsoft.com/office/drawing/2014/chart" uri="{C3380CC4-5D6E-409C-BE32-E72D297353CC}">
                <c16:uniqueId val="{00000018-E421-467E-9AFB-3EAFF1F59B94}"/>
              </c:ext>
            </c:extLst>
          </c:dPt>
          <c:dPt>
            <c:idx val="35"/>
            <c:bubble3D val="0"/>
            <c:extLst>
              <c:ext xmlns:c16="http://schemas.microsoft.com/office/drawing/2014/chart" uri="{C3380CC4-5D6E-409C-BE32-E72D297353CC}">
                <c16:uniqueId val="{00000019-E421-467E-9AFB-3EAFF1F59B94}"/>
              </c:ext>
            </c:extLst>
          </c:dPt>
          <c:dPt>
            <c:idx val="36"/>
            <c:bubble3D val="0"/>
            <c:extLst>
              <c:ext xmlns:c16="http://schemas.microsoft.com/office/drawing/2014/chart" uri="{C3380CC4-5D6E-409C-BE32-E72D297353CC}">
                <c16:uniqueId val="{0000001A-E421-467E-9AFB-3EAFF1F59B94}"/>
              </c:ext>
            </c:extLst>
          </c:dPt>
          <c:dPt>
            <c:idx val="37"/>
            <c:bubble3D val="0"/>
            <c:extLst>
              <c:ext xmlns:c16="http://schemas.microsoft.com/office/drawing/2014/chart" uri="{C3380CC4-5D6E-409C-BE32-E72D297353CC}">
                <c16:uniqueId val="{0000001B-E421-467E-9AFB-3EAFF1F59B94}"/>
              </c:ext>
            </c:extLst>
          </c:dPt>
          <c:dPt>
            <c:idx val="38"/>
            <c:bubble3D val="0"/>
            <c:extLst>
              <c:ext xmlns:c16="http://schemas.microsoft.com/office/drawing/2014/chart" uri="{C3380CC4-5D6E-409C-BE32-E72D297353CC}">
                <c16:uniqueId val="{0000001C-E421-467E-9AFB-3EAFF1F59B94}"/>
              </c:ext>
            </c:extLst>
          </c:dPt>
          <c:dPt>
            <c:idx val="39"/>
            <c:bubble3D val="0"/>
            <c:extLst>
              <c:ext xmlns:c16="http://schemas.microsoft.com/office/drawing/2014/chart" uri="{C3380CC4-5D6E-409C-BE32-E72D297353CC}">
                <c16:uniqueId val="{0000001D-E421-467E-9AFB-3EAFF1F59B94}"/>
              </c:ext>
            </c:extLst>
          </c:dPt>
          <c:dPt>
            <c:idx val="40"/>
            <c:bubble3D val="0"/>
            <c:extLst>
              <c:ext xmlns:c16="http://schemas.microsoft.com/office/drawing/2014/chart" uri="{C3380CC4-5D6E-409C-BE32-E72D297353CC}">
                <c16:uniqueId val="{0000001E-E421-467E-9AFB-3EAFF1F59B94}"/>
              </c:ext>
            </c:extLst>
          </c:dPt>
          <c:dPt>
            <c:idx val="41"/>
            <c:bubble3D val="0"/>
            <c:extLst>
              <c:ext xmlns:c16="http://schemas.microsoft.com/office/drawing/2014/chart" uri="{C3380CC4-5D6E-409C-BE32-E72D297353CC}">
                <c16:uniqueId val="{0000001F-E421-467E-9AFB-3EAFF1F59B94}"/>
              </c:ext>
            </c:extLst>
          </c:dPt>
          <c:dPt>
            <c:idx val="42"/>
            <c:bubble3D val="0"/>
            <c:extLst>
              <c:ext xmlns:c16="http://schemas.microsoft.com/office/drawing/2014/chart" uri="{C3380CC4-5D6E-409C-BE32-E72D297353CC}">
                <c16:uniqueId val="{00000020-E421-467E-9AFB-3EAFF1F59B94}"/>
              </c:ext>
            </c:extLst>
          </c:dPt>
          <c:dPt>
            <c:idx val="43"/>
            <c:bubble3D val="0"/>
            <c:extLst>
              <c:ext xmlns:c16="http://schemas.microsoft.com/office/drawing/2014/chart" uri="{C3380CC4-5D6E-409C-BE32-E72D297353CC}">
                <c16:uniqueId val="{00000021-E421-467E-9AFB-3EAFF1F59B94}"/>
              </c:ext>
            </c:extLst>
          </c:dPt>
          <c:dPt>
            <c:idx val="44"/>
            <c:bubble3D val="0"/>
            <c:extLst>
              <c:ext xmlns:c16="http://schemas.microsoft.com/office/drawing/2014/chart" uri="{C3380CC4-5D6E-409C-BE32-E72D297353CC}">
                <c16:uniqueId val="{00000022-E421-467E-9AFB-3EAFF1F59B94}"/>
              </c:ext>
            </c:extLst>
          </c:dPt>
          <c:dPt>
            <c:idx val="45"/>
            <c:bubble3D val="0"/>
            <c:extLst>
              <c:ext xmlns:c16="http://schemas.microsoft.com/office/drawing/2014/chart" uri="{C3380CC4-5D6E-409C-BE32-E72D297353CC}">
                <c16:uniqueId val="{00000023-E421-467E-9AFB-3EAFF1F59B94}"/>
              </c:ext>
            </c:extLst>
          </c:dPt>
          <c:dPt>
            <c:idx val="46"/>
            <c:bubble3D val="0"/>
            <c:extLst>
              <c:ext xmlns:c16="http://schemas.microsoft.com/office/drawing/2014/chart" uri="{C3380CC4-5D6E-409C-BE32-E72D297353CC}">
                <c16:uniqueId val="{00000024-E421-467E-9AFB-3EAFF1F59B94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1!$I$7:$I$53</c:f>
                <c:numCache>
                  <c:formatCode>General</c:formatCode>
                  <c:ptCount val="4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3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3</c:v>
                  </c:pt>
                  <c:pt idx="22">
                    <c:v>0</c:v>
                  </c:pt>
                  <c:pt idx="23">
                    <c:v>0</c:v>
                  </c:pt>
                  <c:pt idx="24">
                    <c:v>0</c:v>
                  </c:pt>
                  <c:pt idx="25">
                    <c:v>0</c:v>
                  </c:pt>
                  <c:pt idx="26">
                    <c:v>0</c:v>
                  </c:pt>
                  <c:pt idx="27">
                    <c:v>3</c:v>
                  </c:pt>
                  <c:pt idx="28">
                    <c:v>0</c:v>
                  </c:pt>
                  <c:pt idx="29">
                    <c:v>3</c:v>
                  </c:pt>
                  <c:pt idx="30">
                    <c:v>0</c:v>
                  </c:pt>
                  <c:pt idx="31">
                    <c:v>3</c:v>
                  </c:pt>
                  <c:pt idx="32">
                    <c:v>0</c:v>
                  </c:pt>
                  <c:pt idx="33">
                    <c:v>3</c:v>
                  </c:pt>
                  <c:pt idx="34">
                    <c:v>0</c:v>
                  </c:pt>
                  <c:pt idx="35">
                    <c:v>3</c:v>
                  </c:pt>
                  <c:pt idx="36">
                    <c:v>0</c:v>
                  </c:pt>
                  <c:pt idx="37">
                    <c:v>3</c:v>
                  </c:pt>
                  <c:pt idx="38">
                    <c:v>0</c:v>
                  </c:pt>
                  <c:pt idx="39">
                    <c:v>3</c:v>
                  </c:pt>
                  <c:pt idx="40">
                    <c:v>0</c:v>
                  </c:pt>
                  <c:pt idx="41">
                    <c:v>3</c:v>
                  </c:pt>
                  <c:pt idx="42">
                    <c:v>0</c:v>
                  </c:pt>
                  <c:pt idx="43">
                    <c:v>3</c:v>
                  </c:pt>
                  <c:pt idx="44">
                    <c:v>0</c:v>
                  </c:pt>
                  <c:pt idx="45">
                    <c:v>3</c:v>
                  </c:pt>
                  <c:pt idx="46">
                    <c:v>0</c:v>
                  </c:pt>
                </c:numCache>
              </c:numRef>
            </c:plus>
          </c:errBars>
          <c:xVal>
            <c:numRef>
              <c:f>Kaplan1!$G$7:$G$53</c:f>
              <c:numCache>
                <c:formatCode>0.000</c:formatCode>
                <c:ptCount val="47"/>
                <c:pt idx="0">
                  <c:v>0</c:v>
                </c:pt>
                <c:pt idx="1">
                  <c:v>1.9285714285714286</c:v>
                </c:pt>
                <c:pt idx="2">
                  <c:v>1.9285714285714286</c:v>
                </c:pt>
                <c:pt idx="3">
                  <c:v>2.3214285714285716</c:v>
                </c:pt>
                <c:pt idx="4">
                  <c:v>2.3214285714285716</c:v>
                </c:pt>
                <c:pt idx="5">
                  <c:v>3.3571428571428572</c:v>
                </c:pt>
                <c:pt idx="6">
                  <c:v>3.3571428571428572</c:v>
                </c:pt>
                <c:pt idx="7">
                  <c:v>3.5</c:v>
                </c:pt>
                <c:pt idx="8">
                  <c:v>3.5</c:v>
                </c:pt>
                <c:pt idx="9">
                  <c:v>4.25</c:v>
                </c:pt>
                <c:pt idx="10">
                  <c:v>4.25</c:v>
                </c:pt>
                <c:pt idx="11">
                  <c:v>4.3214285714285712</c:v>
                </c:pt>
                <c:pt idx="12">
                  <c:v>4.3214285714285712</c:v>
                </c:pt>
                <c:pt idx="13">
                  <c:v>5</c:v>
                </c:pt>
                <c:pt idx="14">
                  <c:v>5</c:v>
                </c:pt>
                <c:pt idx="15">
                  <c:v>5.4285714285714288</c:v>
                </c:pt>
                <c:pt idx="16">
                  <c:v>5.4285714285714288</c:v>
                </c:pt>
                <c:pt idx="17">
                  <c:v>8.1785714285714288</c:v>
                </c:pt>
                <c:pt idx="18">
                  <c:v>8.1785714285714288</c:v>
                </c:pt>
                <c:pt idx="19">
                  <c:v>8.3571428571428577</c:v>
                </c:pt>
                <c:pt idx="20">
                  <c:v>8.3571428571428577</c:v>
                </c:pt>
                <c:pt idx="21">
                  <c:v>9.5</c:v>
                </c:pt>
                <c:pt idx="22">
                  <c:v>9.5</c:v>
                </c:pt>
                <c:pt idx="23">
                  <c:v>10.607142857142858</c:v>
                </c:pt>
                <c:pt idx="24">
                  <c:v>10.607142857142858</c:v>
                </c:pt>
                <c:pt idx="25">
                  <c:v>13.214285714285714</c:v>
                </c:pt>
                <c:pt idx="26">
                  <c:v>13.214285714285714</c:v>
                </c:pt>
                <c:pt idx="27">
                  <c:v>14.285714285714286</c:v>
                </c:pt>
                <c:pt idx="28">
                  <c:v>14.285714285714286</c:v>
                </c:pt>
                <c:pt idx="29">
                  <c:v>17</c:v>
                </c:pt>
                <c:pt idx="30">
                  <c:v>17</c:v>
                </c:pt>
                <c:pt idx="31">
                  <c:v>20.25</c:v>
                </c:pt>
                <c:pt idx="32">
                  <c:v>20.25</c:v>
                </c:pt>
                <c:pt idx="33">
                  <c:v>21.607142857142858</c:v>
                </c:pt>
                <c:pt idx="34">
                  <c:v>21.607142857142858</c:v>
                </c:pt>
                <c:pt idx="35">
                  <c:v>22</c:v>
                </c:pt>
                <c:pt idx="36">
                  <c:v>22</c:v>
                </c:pt>
                <c:pt idx="37">
                  <c:v>24.75</c:v>
                </c:pt>
                <c:pt idx="38">
                  <c:v>24.75</c:v>
                </c:pt>
                <c:pt idx="39">
                  <c:v>25.607142857142858</c:v>
                </c:pt>
                <c:pt idx="40">
                  <c:v>25.607142857142858</c:v>
                </c:pt>
                <c:pt idx="41">
                  <c:v>26</c:v>
                </c:pt>
                <c:pt idx="42">
                  <c:v>26</c:v>
                </c:pt>
                <c:pt idx="43">
                  <c:v>26.428571428571427</c:v>
                </c:pt>
                <c:pt idx="44">
                  <c:v>26.428571428571427</c:v>
                </c:pt>
                <c:pt idx="45">
                  <c:v>27.5</c:v>
                </c:pt>
                <c:pt idx="46">
                  <c:v>27.5</c:v>
                </c:pt>
              </c:numCache>
            </c:numRef>
          </c:xVal>
          <c:yVal>
            <c:numRef>
              <c:f>Kaplan1!$H$7:$H$53</c:f>
              <c:numCache>
                <c:formatCode>0.000</c:formatCode>
                <c:ptCount val="47"/>
                <c:pt idx="0">
                  <c:v>100</c:v>
                </c:pt>
                <c:pt idx="1">
                  <c:v>100</c:v>
                </c:pt>
                <c:pt idx="2">
                  <c:v>95.652173913043484</c:v>
                </c:pt>
                <c:pt idx="3">
                  <c:v>95.652173913043484</c:v>
                </c:pt>
                <c:pt idx="4">
                  <c:v>91.304347826086968</c:v>
                </c:pt>
                <c:pt idx="5">
                  <c:v>91.304347826086968</c:v>
                </c:pt>
                <c:pt idx="6">
                  <c:v>91.304347826086968</c:v>
                </c:pt>
                <c:pt idx="7">
                  <c:v>91.304347826086968</c:v>
                </c:pt>
                <c:pt idx="8">
                  <c:v>86.739130434782609</c:v>
                </c:pt>
                <c:pt idx="9">
                  <c:v>86.739130434782609</c:v>
                </c:pt>
                <c:pt idx="10">
                  <c:v>86.739130434782609</c:v>
                </c:pt>
                <c:pt idx="11">
                  <c:v>86.739130434782609</c:v>
                </c:pt>
                <c:pt idx="12">
                  <c:v>81.920289855072454</c:v>
                </c:pt>
                <c:pt idx="13">
                  <c:v>81.920289855072454</c:v>
                </c:pt>
                <c:pt idx="14">
                  <c:v>77.101449275362313</c:v>
                </c:pt>
                <c:pt idx="15">
                  <c:v>77.101449275362313</c:v>
                </c:pt>
                <c:pt idx="16">
                  <c:v>72.282608695652158</c:v>
                </c:pt>
                <c:pt idx="17">
                  <c:v>72.282608695652158</c:v>
                </c:pt>
                <c:pt idx="18">
                  <c:v>67.463768115942017</c:v>
                </c:pt>
                <c:pt idx="19">
                  <c:v>67.463768115942017</c:v>
                </c:pt>
                <c:pt idx="20">
                  <c:v>62.644927536231876</c:v>
                </c:pt>
                <c:pt idx="21">
                  <c:v>62.644927536231876</c:v>
                </c:pt>
                <c:pt idx="22">
                  <c:v>62.644927536231876</c:v>
                </c:pt>
                <c:pt idx="23">
                  <c:v>62.644927536231876</c:v>
                </c:pt>
                <c:pt idx="24">
                  <c:v>57.424516908212553</c:v>
                </c:pt>
                <c:pt idx="25">
                  <c:v>57.424516908212553</c:v>
                </c:pt>
                <c:pt idx="26">
                  <c:v>52.20410628019323</c:v>
                </c:pt>
                <c:pt idx="27">
                  <c:v>52.20410628019323</c:v>
                </c:pt>
                <c:pt idx="28">
                  <c:v>52.20410628019323</c:v>
                </c:pt>
                <c:pt idx="29">
                  <c:v>52.20410628019323</c:v>
                </c:pt>
                <c:pt idx="30">
                  <c:v>52.20410628019323</c:v>
                </c:pt>
                <c:pt idx="31">
                  <c:v>52.20410628019323</c:v>
                </c:pt>
                <c:pt idx="32">
                  <c:v>52.20410628019323</c:v>
                </c:pt>
                <c:pt idx="33">
                  <c:v>52.20410628019323</c:v>
                </c:pt>
                <c:pt idx="34">
                  <c:v>52.20410628019323</c:v>
                </c:pt>
                <c:pt idx="35">
                  <c:v>52.20410628019323</c:v>
                </c:pt>
                <c:pt idx="36">
                  <c:v>52.20410628019323</c:v>
                </c:pt>
                <c:pt idx="37">
                  <c:v>52.20410628019323</c:v>
                </c:pt>
                <c:pt idx="38">
                  <c:v>52.20410628019323</c:v>
                </c:pt>
                <c:pt idx="39">
                  <c:v>52.20410628019323</c:v>
                </c:pt>
                <c:pt idx="40">
                  <c:v>52.20410628019323</c:v>
                </c:pt>
                <c:pt idx="41">
                  <c:v>52.20410628019323</c:v>
                </c:pt>
                <c:pt idx="42">
                  <c:v>52.20410628019323</c:v>
                </c:pt>
                <c:pt idx="43">
                  <c:v>52.20410628019323</c:v>
                </c:pt>
                <c:pt idx="44">
                  <c:v>52.20410628019323</c:v>
                </c:pt>
                <c:pt idx="45">
                  <c:v>52.20410628019323</c:v>
                </c:pt>
                <c:pt idx="46">
                  <c:v>52.204106280193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E421-467E-9AFB-3EAFF1F59B94}"/>
            </c:ext>
          </c:extLst>
        </c:ser>
        <c:ser>
          <c:idx val="1"/>
          <c:order val="1"/>
          <c:tx>
            <c:v>1</c:v>
          </c:tx>
          <c:spPr>
            <a:ln w="38100">
              <a:solidFill>
                <a:schemeClr val="accent2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26-E421-467E-9AFB-3EAFF1F59B94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27-E421-467E-9AFB-3EAFF1F59B94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28-E421-467E-9AFB-3EAFF1F59B94}"/>
              </c:ext>
            </c:extLst>
          </c:dPt>
          <c:dPt>
            <c:idx val="4"/>
            <c:bubble3D val="0"/>
            <c:extLst>
              <c:ext xmlns:c16="http://schemas.microsoft.com/office/drawing/2014/chart" uri="{C3380CC4-5D6E-409C-BE32-E72D297353CC}">
                <c16:uniqueId val="{00000029-E421-467E-9AFB-3EAFF1F59B94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2A-E421-467E-9AFB-3EAFF1F59B94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2B-E421-467E-9AFB-3EAFF1F59B94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2!$I$7:$I$1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</c:numCache>
              </c:numRef>
            </c:plus>
          </c:errBars>
          <c:xVal>
            <c:numRef>
              <c:f>Kaplan2!$G$7:$G$13</c:f>
              <c:numCache>
                <c:formatCode>0.000</c:formatCode>
                <c:ptCount val="7"/>
                <c:pt idx="0">
                  <c:v>0</c:v>
                </c:pt>
                <c:pt idx="1">
                  <c:v>10.964285714285714</c:v>
                </c:pt>
                <c:pt idx="2">
                  <c:v>10.964285714285714</c:v>
                </c:pt>
                <c:pt idx="3">
                  <c:v>26.642857142857142</c:v>
                </c:pt>
                <c:pt idx="4">
                  <c:v>26.642857142857142</c:v>
                </c:pt>
                <c:pt idx="5">
                  <c:v>31.642857142857142</c:v>
                </c:pt>
                <c:pt idx="6">
                  <c:v>31.642857142857142</c:v>
                </c:pt>
              </c:numCache>
            </c:numRef>
          </c:xVal>
          <c:yVal>
            <c:numRef>
              <c:f>Kaplan2!$H$7:$H$13</c:f>
              <c:numCache>
                <c:formatCode>0.000</c:formatCode>
                <c:ptCount val="7"/>
                <c:pt idx="0">
                  <c:v>100</c:v>
                </c:pt>
                <c:pt idx="1">
                  <c:v>100</c:v>
                </c:pt>
                <c:pt idx="2">
                  <c:v>66.666666666666657</c:v>
                </c:pt>
                <c:pt idx="3">
                  <c:v>66.666666666666657</c:v>
                </c:pt>
                <c:pt idx="4">
                  <c:v>66.666666666666657</c:v>
                </c:pt>
                <c:pt idx="5">
                  <c:v>66.666666666666657</c:v>
                </c:pt>
                <c:pt idx="6">
                  <c:v>66.6666666666666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C-E421-467E-9AFB-3EAFF1F59B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6419232"/>
        <c:axId val="696419648"/>
      </c:scatterChart>
      <c:valAx>
        <c:axId val="696419232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crossAx val="696419648"/>
        <c:crosses val="autoZero"/>
        <c:crossBetween val="midCat"/>
      </c:valAx>
      <c:valAx>
        <c:axId val="696419648"/>
        <c:scaling>
          <c:orientation val="minMax"/>
          <c:max val="10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crossAx val="696419232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4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1988359102996406E-2"/>
          <c:y val="1.5248821932286759E-2"/>
          <c:w val="0.92798244441702993"/>
          <c:h val="0.91445756431918601"/>
        </c:manualLayout>
      </c:layout>
      <c:scatterChart>
        <c:scatterStyle val="lineMarker"/>
        <c:varyColors val="0"/>
        <c:ser>
          <c:idx val="0"/>
          <c:order val="0"/>
          <c:tx>
            <c:v>0</c:v>
          </c:tx>
          <c:spPr>
            <a:ln w="38100">
              <a:solidFill>
                <a:schemeClr val="accent1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A438-4890-B675-EB9F45557FCA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A438-4890-B675-EB9F45557FCA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02-A438-4890-B675-EB9F45557FCA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3-A438-4890-B675-EB9F45557FCA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04-A438-4890-B675-EB9F45557FCA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05-A438-4890-B675-EB9F45557FCA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06-A438-4890-B675-EB9F45557FCA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07-A438-4890-B675-EB9F45557FCA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08-A438-4890-B675-EB9F45557FCA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09-A438-4890-B675-EB9F45557FCA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0A-A438-4890-B675-EB9F45557FCA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0B-A438-4890-B675-EB9F45557FCA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0C-A438-4890-B675-EB9F45557FCA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0D-A438-4890-B675-EB9F45557FCA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1!$I$7:$I$25</c:f>
                <c:numCache>
                  <c:formatCode>General</c:formatCode>
                  <c:ptCount val="19"/>
                  <c:pt idx="0">
                    <c:v>0</c:v>
                  </c:pt>
                  <c:pt idx="1">
                    <c:v>3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3</c:v>
                  </c:pt>
                  <c:pt idx="14">
                    <c:v>0</c:v>
                  </c:pt>
                  <c:pt idx="15">
                    <c:v>3</c:v>
                  </c:pt>
                  <c:pt idx="16">
                    <c:v>0</c:v>
                  </c:pt>
                  <c:pt idx="17">
                    <c:v>3</c:v>
                  </c:pt>
                  <c:pt idx="18">
                    <c:v>0</c:v>
                  </c:pt>
                </c:numCache>
              </c:numRef>
            </c:plus>
          </c:errBars>
          <c:xVal>
            <c:numRef>
              <c:f>Kaplan1!$G$7:$G$25</c:f>
              <c:numCache>
                <c:formatCode>0.000</c:formatCode>
                <c:ptCount val="19"/>
                <c:pt idx="0">
                  <c:v>0</c:v>
                </c:pt>
                <c:pt idx="1">
                  <c:v>1.8214285714285714</c:v>
                </c:pt>
                <c:pt idx="2">
                  <c:v>1.8214285714285714</c:v>
                </c:pt>
                <c:pt idx="3">
                  <c:v>1.9642857142857142</c:v>
                </c:pt>
                <c:pt idx="4">
                  <c:v>1.9642857142857142</c:v>
                </c:pt>
                <c:pt idx="5">
                  <c:v>3.0714285714285716</c:v>
                </c:pt>
                <c:pt idx="6">
                  <c:v>3.0714285714285716</c:v>
                </c:pt>
                <c:pt idx="7">
                  <c:v>3.6071428571428572</c:v>
                </c:pt>
                <c:pt idx="8">
                  <c:v>3.6071428571428572</c:v>
                </c:pt>
                <c:pt idx="9">
                  <c:v>6.3214285714285712</c:v>
                </c:pt>
                <c:pt idx="10">
                  <c:v>6.3214285714285712</c:v>
                </c:pt>
                <c:pt idx="11">
                  <c:v>11.321428571428571</c:v>
                </c:pt>
                <c:pt idx="12">
                  <c:v>11.321428571428571</c:v>
                </c:pt>
                <c:pt idx="13">
                  <c:v>13.785714285714286</c:v>
                </c:pt>
                <c:pt idx="14">
                  <c:v>13.785714285714286</c:v>
                </c:pt>
                <c:pt idx="15">
                  <c:v>21.571428571428573</c:v>
                </c:pt>
                <c:pt idx="16">
                  <c:v>21.571428571428573</c:v>
                </c:pt>
                <c:pt idx="17">
                  <c:v>27</c:v>
                </c:pt>
                <c:pt idx="18">
                  <c:v>27</c:v>
                </c:pt>
              </c:numCache>
            </c:numRef>
          </c:xVal>
          <c:yVal>
            <c:numRef>
              <c:f>Kaplan1!$H$7:$H$25</c:f>
              <c:numCache>
                <c:formatCode>0.000</c:formatCode>
                <c:ptCount val="19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88.888888888888886</c:v>
                </c:pt>
                <c:pt idx="5">
                  <c:v>88.888888888888886</c:v>
                </c:pt>
                <c:pt idx="6">
                  <c:v>66.666666666666657</c:v>
                </c:pt>
                <c:pt idx="7">
                  <c:v>66.666666666666657</c:v>
                </c:pt>
                <c:pt idx="8">
                  <c:v>55.555555555555557</c:v>
                </c:pt>
                <c:pt idx="9">
                  <c:v>55.555555555555557</c:v>
                </c:pt>
                <c:pt idx="10">
                  <c:v>44.44444444444445</c:v>
                </c:pt>
                <c:pt idx="11">
                  <c:v>44.44444444444445</c:v>
                </c:pt>
                <c:pt idx="12">
                  <c:v>33.333333333333336</c:v>
                </c:pt>
                <c:pt idx="13">
                  <c:v>33.333333333333336</c:v>
                </c:pt>
                <c:pt idx="14">
                  <c:v>33.333333333333336</c:v>
                </c:pt>
                <c:pt idx="15">
                  <c:v>33.333333333333336</c:v>
                </c:pt>
                <c:pt idx="16">
                  <c:v>33.333333333333336</c:v>
                </c:pt>
                <c:pt idx="17">
                  <c:v>33.333333333333336</c:v>
                </c:pt>
                <c:pt idx="18">
                  <c:v>33.3333333333333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A438-4890-B675-EB9F45557FCA}"/>
            </c:ext>
          </c:extLst>
        </c:ser>
        <c:ser>
          <c:idx val="1"/>
          <c:order val="1"/>
          <c:tx>
            <c:v>1</c:v>
          </c:tx>
          <c:spPr>
            <a:ln w="38100">
              <a:solidFill>
                <a:schemeClr val="accent2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F-A438-4890-B675-EB9F45557FCA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10-A438-4890-B675-EB9F45557FCA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11-A438-4890-B675-EB9F45557FCA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12-A438-4890-B675-EB9F45557FCA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13-A438-4890-B675-EB9F45557FCA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14-A438-4890-B675-EB9F45557FCA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15-A438-4890-B675-EB9F45557FCA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16-A438-4890-B675-EB9F45557FCA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17-A438-4890-B675-EB9F45557FCA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18-A438-4890-B675-EB9F45557FCA}"/>
              </c:ext>
            </c:extLst>
          </c:dPt>
          <c:dPt>
            <c:idx val="12"/>
            <c:bubble3D val="0"/>
            <c:extLst>
              <c:ext xmlns:c16="http://schemas.microsoft.com/office/drawing/2014/chart" uri="{C3380CC4-5D6E-409C-BE32-E72D297353CC}">
                <c16:uniqueId val="{00000019-A438-4890-B675-EB9F45557FCA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1A-A438-4890-B675-EB9F45557FCA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1B-A438-4890-B675-EB9F45557FCA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1C-A438-4890-B675-EB9F45557FCA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1D-A438-4890-B675-EB9F45557FCA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1E-A438-4890-B675-EB9F45557FCA}"/>
              </c:ext>
            </c:extLst>
          </c:dPt>
          <c:dPt>
            <c:idx val="20"/>
            <c:bubble3D val="0"/>
            <c:extLst>
              <c:ext xmlns:c16="http://schemas.microsoft.com/office/drawing/2014/chart" uri="{C3380CC4-5D6E-409C-BE32-E72D297353CC}">
                <c16:uniqueId val="{0000001F-A438-4890-B675-EB9F45557FCA}"/>
              </c:ext>
            </c:extLst>
          </c:dPt>
          <c:dPt>
            <c:idx val="21"/>
            <c:bubble3D val="0"/>
            <c:extLst>
              <c:ext xmlns:c16="http://schemas.microsoft.com/office/drawing/2014/chart" uri="{C3380CC4-5D6E-409C-BE32-E72D297353CC}">
                <c16:uniqueId val="{00000020-A438-4890-B675-EB9F45557FCA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21-A438-4890-B675-EB9F45557FCA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2!$I$7:$I$29</c:f>
                <c:numCache>
                  <c:formatCode>General</c:formatCode>
                  <c:ptCount val="23"/>
                  <c:pt idx="0">
                    <c:v>0</c:v>
                  </c:pt>
                  <c:pt idx="1">
                    <c:v>3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  <c:pt idx="7">
                    <c:v>3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3</c:v>
                  </c:pt>
                  <c:pt idx="12">
                    <c:v>0</c:v>
                  </c:pt>
                  <c:pt idx="13">
                    <c:v>3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3</c:v>
                  </c:pt>
                  <c:pt idx="20">
                    <c:v>0</c:v>
                  </c:pt>
                  <c:pt idx="21">
                    <c:v>3</c:v>
                  </c:pt>
                  <c:pt idx="22">
                    <c:v>0</c:v>
                  </c:pt>
                </c:numCache>
              </c:numRef>
            </c:plus>
          </c:errBars>
          <c:xVal>
            <c:numRef>
              <c:f>Kaplan2!$G$7:$G$29</c:f>
              <c:numCache>
                <c:formatCode>0.000</c:formatCode>
                <c:ptCount val="23"/>
                <c:pt idx="0">
                  <c:v>0</c:v>
                </c:pt>
                <c:pt idx="1">
                  <c:v>5.6071428571428568</c:v>
                </c:pt>
                <c:pt idx="2">
                  <c:v>5.6071428571428568</c:v>
                </c:pt>
                <c:pt idx="3">
                  <c:v>6</c:v>
                </c:pt>
                <c:pt idx="4">
                  <c:v>6</c:v>
                </c:pt>
                <c:pt idx="5">
                  <c:v>7.1071428571428568</c:v>
                </c:pt>
                <c:pt idx="6">
                  <c:v>7.1071428571428568</c:v>
                </c:pt>
                <c:pt idx="7">
                  <c:v>8.1785714285714288</c:v>
                </c:pt>
                <c:pt idx="8">
                  <c:v>8.1785714285714288</c:v>
                </c:pt>
                <c:pt idx="9">
                  <c:v>8.3214285714285712</c:v>
                </c:pt>
                <c:pt idx="10">
                  <c:v>8.3214285714285712</c:v>
                </c:pt>
                <c:pt idx="11">
                  <c:v>12.464285714285714</c:v>
                </c:pt>
                <c:pt idx="12">
                  <c:v>12.464285714285714</c:v>
                </c:pt>
                <c:pt idx="13">
                  <c:v>13.928571428571429</c:v>
                </c:pt>
                <c:pt idx="14">
                  <c:v>13.928571428571429</c:v>
                </c:pt>
                <c:pt idx="15">
                  <c:v>15.285714285714286</c:v>
                </c:pt>
                <c:pt idx="16">
                  <c:v>15.285714285714286</c:v>
                </c:pt>
                <c:pt idx="17">
                  <c:v>15.321428571428571</c:v>
                </c:pt>
                <c:pt idx="18">
                  <c:v>15.321428571428571</c:v>
                </c:pt>
                <c:pt idx="19">
                  <c:v>15.75</c:v>
                </c:pt>
                <c:pt idx="20">
                  <c:v>15.75</c:v>
                </c:pt>
                <c:pt idx="21">
                  <c:v>24.107142857142858</c:v>
                </c:pt>
                <c:pt idx="22">
                  <c:v>24.107142857142858</c:v>
                </c:pt>
              </c:numCache>
            </c:numRef>
          </c:xVal>
          <c:yVal>
            <c:numRef>
              <c:f>Kaplan2!$H$7:$H$29</c:f>
              <c:numCache>
                <c:formatCode>0.000</c:formatCode>
                <c:ptCount val="2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90</c:v>
                </c:pt>
                <c:pt idx="5">
                  <c:v>90</c:v>
                </c:pt>
                <c:pt idx="6">
                  <c:v>90</c:v>
                </c:pt>
                <c:pt idx="7">
                  <c:v>90</c:v>
                </c:pt>
                <c:pt idx="8">
                  <c:v>90</c:v>
                </c:pt>
                <c:pt idx="9">
                  <c:v>90</c:v>
                </c:pt>
                <c:pt idx="10">
                  <c:v>77.142857142857139</c:v>
                </c:pt>
                <c:pt idx="11">
                  <c:v>77.142857142857139</c:v>
                </c:pt>
                <c:pt idx="12">
                  <c:v>77.142857142857139</c:v>
                </c:pt>
                <c:pt idx="13">
                  <c:v>77.142857142857139</c:v>
                </c:pt>
                <c:pt idx="14">
                  <c:v>77.142857142857139</c:v>
                </c:pt>
                <c:pt idx="15">
                  <c:v>77.142857142857139</c:v>
                </c:pt>
                <c:pt idx="16">
                  <c:v>57.857142857142854</c:v>
                </c:pt>
                <c:pt idx="17">
                  <c:v>57.857142857142854</c:v>
                </c:pt>
                <c:pt idx="18">
                  <c:v>38.571428571428569</c:v>
                </c:pt>
                <c:pt idx="19">
                  <c:v>38.571428571428569</c:v>
                </c:pt>
                <c:pt idx="20">
                  <c:v>38.571428571428569</c:v>
                </c:pt>
                <c:pt idx="21">
                  <c:v>38.571428571428569</c:v>
                </c:pt>
                <c:pt idx="22">
                  <c:v>38.5714285714285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A438-4890-B675-EB9F45557F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44809888"/>
        <c:axId val="1844816128"/>
      </c:scatterChart>
      <c:valAx>
        <c:axId val="1844809888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1844816128"/>
        <c:crosses val="autoZero"/>
        <c:crossBetween val="midCat"/>
      </c:valAx>
      <c:valAx>
        <c:axId val="1844816128"/>
        <c:scaling>
          <c:orientation val="minMax"/>
          <c:max val="10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1844809888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2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0</c:v>
          </c:tx>
          <c:spPr>
            <a:ln w="38100">
              <a:solidFill>
                <a:schemeClr val="accent1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F33A-4A03-A879-4258CAEDDEBB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F33A-4A03-A879-4258CAEDDEBB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2-F33A-4A03-A879-4258CAEDDEBB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03-F33A-4A03-A879-4258CAEDDEBB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04-F33A-4A03-A879-4258CAEDDEBB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05-F33A-4A03-A879-4258CAEDDEBB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06-F33A-4A03-A879-4258CAEDDEBB}"/>
              </c:ext>
            </c:extLst>
          </c:dPt>
          <c:dPt>
            <c:idx val="10"/>
            <c:bubble3D val="0"/>
            <c:extLst>
              <c:ext xmlns:c16="http://schemas.microsoft.com/office/drawing/2014/chart" uri="{C3380CC4-5D6E-409C-BE32-E72D297353CC}">
                <c16:uniqueId val="{00000007-F33A-4A03-A879-4258CAEDDEBB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08-F33A-4A03-A879-4258CAEDDEBB}"/>
              </c:ext>
            </c:extLst>
          </c:dPt>
          <c:dPt>
            <c:idx val="12"/>
            <c:bubble3D val="0"/>
            <c:extLst>
              <c:ext xmlns:c16="http://schemas.microsoft.com/office/drawing/2014/chart" uri="{C3380CC4-5D6E-409C-BE32-E72D297353CC}">
                <c16:uniqueId val="{00000009-F33A-4A03-A879-4258CAEDDEBB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0A-F33A-4A03-A879-4258CAEDDEBB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0B-F33A-4A03-A879-4258CAEDDEBB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0C-F33A-4A03-A879-4258CAEDDEBB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0D-F33A-4A03-A879-4258CAEDDEBB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0E-F33A-4A03-A879-4258CAEDDEBB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0F-F33A-4A03-A879-4258CAEDDEBB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10-F33A-4A03-A879-4258CAEDDEBB}"/>
              </c:ext>
            </c:extLst>
          </c:dPt>
          <c:dPt>
            <c:idx val="20"/>
            <c:bubble3D val="0"/>
            <c:extLst>
              <c:ext xmlns:c16="http://schemas.microsoft.com/office/drawing/2014/chart" uri="{C3380CC4-5D6E-409C-BE32-E72D297353CC}">
                <c16:uniqueId val="{00000011-F33A-4A03-A879-4258CAEDDEBB}"/>
              </c:ext>
            </c:extLst>
          </c:dPt>
          <c:dPt>
            <c:idx val="21"/>
            <c:bubble3D val="0"/>
            <c:extLst>
              <c:ext xmlns:c16="http://schemas.microsoft.com/office/drawing/2014/chart" uri="{C3380CC4-5D6E-409C-BE32-E72D297353CC}">
                <c16:uniqueId val="{00000012-F33A-4A03-A879-4258CAEDDEBB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13-F33A-4A03-A879-4258CAEDDEBB}"/>
              </c:ext>
            </c:extLst>
          </c:dPt>
          <c:dPt>
            <c:idx val="23"/>
            <c:bubble3D val="0"/>
            <c:extLst>
              <c:ext xmlns:c16="http://schemas.microsoft.com/office/drawing/2014/chart" uri="{C3380CC4-5D6E-409C-BE32-E72D297353CC}">
                <c16:uniqueId val="{00000014-F33A-4A03-A879-4258CAEDDEBB}"/>
              </c:ext>
            </c:extLst>
          </c:dPt>
          <c:dPt>
            <c:idx val="25"/>
            <c:bubble3D val="0"/>
            <c:extLst>
              <c:ext xmlns:c16="http://schemas.microsoft.com/office/drawing/2014/chart" uri="{C3380CC4-5D6E-409C-BE32-E72D297353CC}">
                <c16:uniqueId val="{00000015-F33A-4A03-A879-4258CAEDDEBB}"/>
              </c:ext>
            </c:extLst>
          </c:dPt>
          <c:dPt>
            <c:idx val="26"/>
            <c:bubble3D val="0"/>
            <c:extLst>
              <c:ext xmlns:c16="http://schemas.microsoft.com/office/drawing/2014/chart" uri="{C3380CC4-5D6E-409C-BE32-E72D297353CC}">
                <c16:uniqueId val="{00000016-F33A-4A03-A879-4258CAEDDEBB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1!$I$7:$I$33</c:f>
                <c:numCache>
                  <c:formatCode>General</c:formatCode>
                  <c:ptCount val="2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3</c:v>
                  </c:pt>
                  <c:pt idx="8">
                    <c:v>0</c:v>
                  </c:pt>
                  <c:pt idx="9">
                    <c:v>3</c:v>
                  </c:pt>
                  <c:pt idx="10">
                    <c:v>0</c:v>
                  </c:pt>
                  <c:pt idx="11">
                    <c:v>3</c:v>
                  </c:pt>
                  <c:pt idx="12">
                    <c:v>0</c:v>
                  </c:pt>
                  <c:pt idx="13">
                    <c:v>3</c:v>
                  </c:pt>
                  <c:pt idx="14">
                    <c:v>0</c:v>
                  </c:pt>
                  <c:pt idx="15">
                    <c:v>3</c:v>
                  </c:pt>
                  <c:pt idx="16">
                    <c:v>0</c:v>
                  </c:pt>
                  <c:pt idx="17">
                    <c:v>3</c:v>
                  </c:pt>
                  <c:pt idx="18">
                    <c:v>0</c:v>
                  </c:pt>
                  <c:pt idx="19">
                    <c:v>3</c:v>
                  </c:pt>
                  <c:pt idx="20">
                    <c:v>0</c:v>
                  </c:pt>
                  <c:pt idx="21">
                    <c:v>3</c:v>
                  </c:pt>
                  <c:pt idx="22">
                    <c:v>0</c:v>
                  </c:pt>
                  <c:pt idx="23">
                    <c:v>0</c:v>
                  </c:pt>
                  <c:pt idx="24">
                    <c:v>0</c:v>
                  </c:pt>
                  <c:pt idx="25">
                    <c:v>3</c:v>
                  </c:pt>
                  <c:pt idx="26">
                    <c:v>0</c:v>
                  </c:pt>
                </c:numCache>
              </c:numRef>
            </c:plus>
          </c:errBars>
          <c:xVal>
            <c:numRef>
              <c:f>Kaplan1!$G$7:$G$33</c:f>
              <c:numCache>
                <c:formatCode>0.000</c:formatCode>
                <c:ptCount val="27"/>
                <c:pt idx="0">
                  <c:v>0</c:v>
                </c:pt>
                <c:pt idx="1">
                  <c:v>2.25</c:v>
                </c:pt>
                <c:pt idx="2">
                  <c:v>2.25</c:v>
                </c:pt>
                <c:pt idx="3">
                  <c:v>2.4642857142857144</c:v>
                </c:pt>
                <c:pt idx="4">
                  <c:v>2.4642857142857144</c:v>
                </c:pt>
                <c:pt idx="5">
                  <c:v>3.0714285714285716</c:v>
                </c:pt>
                <c:pt idx="6">
                  <c:v>3.0714285714285716</c:v>
                </c:pt>
                <c:pt idx="7">
                  <c:v>7.1071428571428568</c:v>
                </c:pt>
                <c:pt idx="8">
                  <c:v>7.1071428571428568</c:v>
                </c:pt>
                <c:pt idx="9">
                  <c:v>7.3214285714285712</c:v>
                </c:pt>
                <c:pt idx="10">
                  <c:v>7.3214285714285712</c:v>
                </c:pt>
                <c:pt idx="11">
                  <c:v>8.3214285714285712</c:v>
                </c:pt>
                <c:pt idx="12">
                  <c:v>8.3214285714285712</c:v>
                </c:pt>
                <c:pt idx="13">
                  <c:v>9</c:v>
                </c:pt>
                <c:pt idx="14">
                  <c:v>9</c:v>
                </c:pt>
                <c:pt idx="15">
                  <c:v>11.964285714285714</c:v>
                </c:pt>
                <c:pt idx="16">
                  <c:v>11.964285714285714</c:v>
                </c:pt>
                <c:pt idx="17">
                  <c:v>12.392857142857142</c:v>
                </c:pt>
                <c:pt idx="18">
                  <c:v>12.392857142857142</c:v>
                </c:pt>
                <c:pt idx="19">
                  <c:v>13.785714285714286</c:v>
                </c:pt>
                <c:pt idx="20">
                  <c:v>13.785714285714286</c:v>
                </c:pt>
                <c:pt idx="21">
                  <c:v>21.571428571428573</c:v>
                </c:pt>
                <c:pt idx="22">
                  <c:v>21.571428571428573</c:v>
                </c:pt>
                <c:pt idx="23">
                  <c:v>22.428571428571427</c:v>
                </c:pt>
                <c:pt idx="24">
                  <c:v>22.428571428571427</c:v>
                </c:pt>
                <c:pt idx="25">
                  <c:v>27</c:v>
                </c:pt>
                <c:pt idx="26">
                  <c:v>27</c:v>
                </c:pt>
              </c:numCache>
            </c:numRef>
          </c:xVal>
          <c:yVal>
            <c:numRef>
              <c:f>Kaplan1!$H$7:$H$33</c:f>
              <c:numCache>
                <c:formatCode>0.000</c:formatCode>
                <c:ptCount val="27"/>
                <c:pt idx="0">
                  <c:v>100</c:v>
                </c:pt>
                <c:pt idx="1">
                  <c:v>100</c:v>
                </c:pt>
                <c:pt idx="2">
                  <c:v>92.307692307692307</c:v>
                </c:pt>
                <c:pt idx="3">
                  <c:v>92.307692307692307</c:v>
                </c:pt>
                <c:pt idx="4">
                  <c:v>84.615384615384613</c:v>
                </c:pt>
                <c:pt idx="5">
                  <c:v>84.615384615384613</c:v>
                </c:pt>
                <c:pt idx="6">
                  <c:v>76.92307692307692</c:v>
                </c:pt>
                <c:pt idx="7">
                  <c:v>76.92307692307692</c:v>
                </c:pt>
                <c:pt idx="8">
                  <c:v>76.92307692307692</c:v>
                </c:pt>
                <c:pt idx="9">
                  <c:v>76.92307692307692</c:v>
                </c:pt>
                <c:pt idx="10">
                  <c:v>76.92307692307692</c:v>
                </c:pt>
                <c:pt idx="11">
                  <c:v>76.92307692307692</c:v>
                </c:pt>
                <c:pt idx="12">
                  <c:v>76.92307692307692</c:v>
                </c:pt>
                <c:pt idx="13">
                  <c:v>76.92307692307692</c:v>
                </c:pt>
                <c:pt idx="14">
                  <c:v>76.92307692307692</c:v>
                </c:pt>
                <c:pt idx="15">
                  <c:v>76.92307692307692</c:v>
                </c:pt>
                <c:pt idx="16">
                  <c:v>76.92307692307692</c:v>
                </c:pt>
                <c:pt idx="17">
                  <c:v>76.92307692307692</c:v>
                </c:pt>
                <c:pt idx="18">
                  <c:v>76.92307692307692</c:v>
                </c:pt>
                <c:pt idx="19">
                  <c:v>76.92307692307692</c:v>
                </c:pt>
                <c:pt idx="20">
                  <c:v>76.92307692307692</c:v>
                </c:pt>
                <c:pt idx="21">
                  <c:v>76.92307692307692</c:v>
                </c:pt>
                <c:pt idx="22">
                  <c:v>76.92307692307692</c:v>
                </c:pt>
                <c:pt idx="23">
                  <c:v>76.92307692307692</c:v>
                </c:pt>
                <c:pt idx="24">
                  <c:v>38.46153846153846</c:v>
                </c:pt>
                <c:pt idx="25">
                  <c:v>38.46153846153846</c:v>
                </c:pt>
                <c:pt idx="26">
                  <c:v>38.461538461538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F33A-4A03-A879-4258CAEDDEBB}"/>
            </c:ext>
          </c:extLst>
        </c:ser>
        <c:ser>
          <c:idx val="1"/>
          <c:order val="1"/>
          <c:tx>
            <c:v>1</c:v>
          </c:tx>
          <c:spPr>
            <a:ln w="38100">
              <a:solidFill>
                <a:schemeClr val="accent2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18-F33A-4A03-A879-4258CAEDDEBB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19-F33A-4A03-A879-4258CAEDDEBB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1A-F33A-4A03-A879-4258CAEDDEBB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1B-F33A-4A03-A879-4258CAEDDEBB}"/>
              </c:ext>
            </c:extLst>
          </c:dPt>
          <c:dPt>
            <c:idx val="4"/>
            <c:bubble3D val="0"/>
            <c:extLst>
              <c:ext xmlns:c16="http://schemas.microsoft.com/office/drawing/2014/chart" uri="{C3380CC4-5D6E-409C-BE32-E72D297353CC}">
                <c16:uniqueId val="{0000001C-F33A-4A03-A879-4258CAEDDEBB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1D-F33A-4A03-A879-4258CAEDDEBB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1E-F33A-4A03-A879-4258CAEDDEBB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1F-F33A-4A03-A879-4258CAEDDEBB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20-F33A-4A03-A879-4258CAEDDEBB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21-F33A-4A03-A879-4258CAEDDEBB}"/>
              </c:ext>
            </c:extLst>
          </c:dPt>
          <c:dPt>
            <c:idx val="10"/>
            <c:bubble3D val="0"/>
            <c:extLst>
              <c:ext xmlns:c16="http://schemas.microsoft.com/office/drawing/2014/chart" uri="{C3380CC4-5D6E-409C-BE32-E72D297353CC}">
                <c16:uniqueId val="{00000022-F33A-4A03-A879-4258CAEDDEBB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23-F33A-4A03-A879-4258CAEDDEBB}"/>
              </c:ext>
            </c:extLst>
          </c:dPt>
          <c:dPt>
            <c:idx val="12"/>
            <c:bubble3D val="0"/>
            <c:extLst>
              <c:ext xmlns:c16="http://schemas.microsoft.com/office/drawing/2014/chart" uri="{C3380CC4-5D6E-409C-BE32-E72D297353CC}">
                <c16:uniqueId val="{00000024-F33A-4A03-A879-4258CAEDDEBB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25-F33A-4A03-A879-4258CAEDDEBB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26-F33A-4A03-A879-4258CAEDDEBB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27-F33A-4A03-A879-4258CAEDDEBB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28-F33A-4A03-A879-4258CAEDDEBB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29-F33A-4A03-A879-4258CAEDDEBB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2A-F33A-4A03-A879-4258CAEDDEBB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2B-F33A-4A03-A879-4258CAEDDEBB}"/>
              </c:ext>
            </c:extLst>
          </c:dPt>
          <c:dPt>
            <c:idx val="20"/>
            <c:bubble3D val="0"/>
            <c:extLst>
              <c:ext xmlns:c16="http://schemas.microsoft.com/office/drawing/2014/chart" uri="{C3380CC4-5D6E-409C-BE32-E72D297353CC}">
                <c16:uniqueId val="{0000002C-F33A-4A03-A879-4258CAEDDEBB}"/>
              </c:ext>
            </c:extLst>
          </c:dPt>
          <c:dPt>
            <c:idx val="21"/>
            <c:bubble3D val="0"/>
            <c:extLst>
              <c:ext xmlns:c16="http://schemas.microsoft.com/office/drawing/2014/chart" uri="{C3380CC4-5D6E-409C-BE32-E72D297353CC}">
                <c16:uniqueId val="{0000002D-F33A-4A03-A879-4258CAEDDEBB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2E-F33A-4A03-A879-4258CAEDDEBB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2!$I$7:$I$29</c:f>
                <c:numCache>
                  <c:formatCode>General</c:formatCode>
                  <c:ptCount val="23"/>
                  <c:pt idx="0">
                    <c:v>0</c:v>
                  </c:pt>
                  <c:pt idx="1">
                    <c:v>3</c:v>
                  </c:pt>
                  <c:pt idx="2">
                    <c:v>0</c:v>
                  </c:pt>
                  <c:pt idx="3">
                    <c:v>3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  <c:pt idx="7">
                    <c:v>3</c:v>
                  </c:pt>
                  <c:pt idx="8">
                    <c:v>0</c:v>
                  </c:pt>
                  <c:pt idx="9">
                    <c:v>3</c:v>
                  </c:pt>
                  <c:pt idx="10">
                    <c:v>0</c:v>
                  </c:pt>
                  <c:pt idx="11">
                    <c:v>3</c:v>
                  </c:pt>
                  <c:pt idx="12">
                    <c:v>0</c:v>
                  </c:pt>
                  <c:pt idx="13">
                    <c:v>3</c:v>
                  </c:pt>
                  <c:pt idx="14">
                    <c:v>0</c:v>
                  </c:pt>
                  <c:pt idx="15">
                    <c:v>3</c:v>
                  </c:pt>
                  <c:pt idx="16">
                    <c:v>0</c:v>
                  </c:pt>
                  <c:pt idx="17">
                    <c:v>3</c:v>
                  </c:pt>
                  <c:pt idx="18">
                    <c:v>0</c:v>
                  </c:pt>
                  <c:pt idx="19">
                    <c:v>3</c:v>
                  </c:pt>
                  <c:pt idx="20">
                    <c:v>0</c:v>
                  </c:pt>
                  <c:pt idx="21">
                    <c:v>3</c:v>
                  </c:pt>
                  <c:pt idx="22">
                    <c:v>0</c:v>
                  </c:pt>
                </c:numCache>
              </c:numRef>
            </c:plus>
          </c:errBars>
          <c:xVal>
            <c:numRef>
              <c:f>Kaplan2!$G$7:$G$29</c:f>
              <c:numCache>
                <c:formatCode>0.000</c:formatCode>
                <c:ptCount val="23"/>
                <c:pt idx="0">
                  <c:v>0</c:v>
                </c:pt>
                <c:pt idx="1">
                  <c:v>5.6071428571428568</c:v>
                </c:pt>
                <c:pt idx="2">
                  <c:v>5.6071428571428568</c:v>
                </c:pt>
                <c:pt idx="3">
                  <c:v>7.1071428571428568</c:v>
                </c:pt>
                <c:pt idx="4">
                  <c:v>7.1071428571428568</c:v>
                </c:pt>
                <c:pt idx="5">
                  <c:v>8.1785714285714288</c:v>
                </c:pt>
                <c:pt idx="6">
                  <c:v>8.1785714285714288</c:v>
                </c:pt>
                <c:pt idx="7">
                  <c:v>10.964285714285714</c:v>
                </c:pt>
                <c:pt idx="8">
                  <c:v>10.964285714285714</c:v>
                </c:pt>
                <c:pt idx="9">
                  <c:v>12.464285714285714</c:v>
                </c:pt>
                <c:pt idx="10">
                  <c:v>12.464285714285714</c:v>
                </c:pt>
                <c:pt idx="11">
                  <c:v>13.928571428571429</c:v>
                </c:pt>
                <c:pt idx="12">
                  <c:v>13.928571428571429</c:v>
                </c:pt>
                <c:pt idx="13">
                  <c:v>14.142857142857142</c:v>
                </c:pt>
                <c:pt idx="14">
                  <c:v>14.142857142857142</c:v>
                </c:pt>
                <c:pt idx="15">
                  <c:v>15.75</c:v>
                </c:pt>
                <c:pt idx="16">
                  <c:v>15.75</c:v>
                </c:pt>
                <c:pt idx="17">
                  <c:v>17.964285714285715</c:v>
                </c:pt>
                <c:pt idx="18">
                  <c:v>17.964285714285715</c:v>
                </c:pt>
                <c:pt idx="19">
                  <c:v>18.214285714285715</c:v>
                </c:pt>
                <c:pt idx="20">
                  <c:v>18.214285714285715</c:v>
                </c:pt>
                <c:pt idx="21">
                  <c:v>24.107142857142858</c:v>
                </c:pt>
                <c:pt idx="22">
                  <c:v>24.107142857142858</c:v>
                </c:pt>
              </c:numCache>
            </c:numRef>
          </c:xVal>
          <c:yVal>
            <c:numRef>
              <c:f>Kaplan2!$H$7:$H$29</c:f>
              <c:numCache>
                <c:formatCode>0.000</c:formatCode>
                <c:ptCount val="2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F-F33A-4A03-A879-4258CAEDDE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4836880"/>
        <c:axId val="1884837296"/>
      </c:scatterChart>
      <c:valAx>
        <c:axId val="1884836880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1884837296"/>
        <c:crosses val="autoZero"/>
        <c:crossBetween val="midCat"/>
      </c:valAx>
      <c:valAx>
        <c:axId val="1884837296"/>
        <c:scaling>
          <c:orientation val="minMax"/>
          <c:max val="10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1884836880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2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0</c:v>
          </c:tx>
          <c:spPr>
            <a:ln w="38100">
              <a:solidFill>
                <a:schemeClr val="accent1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7A0B-45EC-A8E8-F9A0A5F0C7EF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7A0B-45EC-A8E8-F9A0A5F0C7EF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2-7A0B-45EC-A8E8-F9A0A5F0C7EF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03-7A0B-45EC-A8E8-F9A0A5F0C7EF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04-7A0B-45EC-A8E8-F9A0A5F0C7EF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05-7A0B-45EC-A8E8-F9A0A5F0C7EF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06-7A0B-45EC-A8E8-F9A0A5F0C7EF}"/>
              </c:ext>
            </c:extLst>
          </c:dPt>
          <c:dPt>
            <c:idx val="10"/>
            <c:bubble3D val="0"/>
            <c:extLst>
              <c:ext xmlns:c16="http://schemas.microsoft.com/office/drawing/2014/chart" uri="{C3380CC4-5D6E-409C-BE32-E72D297353CC}">
                <c16:uniqueId val="{00000007-7A0B-45EC-A8E8-F9A0A5F0C7EF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08-7A0B-45EC-A8E8-F9A0A5F0C7EF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09-7A0B-45EC-A8E8-F9A0A5F0C7EF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0A-7A0B-45EC-A8E8-F9A0A5F0C7EF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0B-7A0B-45EC-A8E8-F9A0A5F0C7EF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0C-7A0B-45EC-A8E8-F9A0A5F0C7EF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0D-7A0B-45EC-A8E8-F9A0A5F0C7EF}"/>
              </c:ext>
            </c:extLst>
          </c:dPt>
          <c:dPt>
            <c:idx val="20"/>
            <c:bubble3D val="0"/>
            <c:extLst>
              <c:ext xmlns:c16="http://schemas.microsoft.com/office/drawing/2014/chart" uri="{C3380CC4-5D6E-409C-BE32-E72D297353CC}">
                <c16:uniqueId val="{0000000E-7A0B-45EC-A8E8-F9A0A5F0C7EF}"/>
              </c:ext>
            </c:extLst>
          </c:dPt>
          <c:dPt>
            <c:idx val="21"/>
            <c:bubble3D val="0"/>
            <c:extLst>
              <c:ext xmlns:c16="http://schemas.microsoft.com/office/drawing/2014/chart" uri="{C3380CC4-5D6E-409C-BE32-E72D297353CC}">
                <c16:uniqueId val="{0000000F-7A0B-45EC-A8E8-F9A0A5F0C7EF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10-7A0B-45EC-A8E8-F9A0A5F0C7EF}"/>
              </c:ext>
            </c:extLst>
          </c:dPt>
          <c:dPt>
            <c:idx val="23"/>
            <c:bubble3D val="0"/>
            <c:extLst>
              <c:ext xmlns:c16="http://schemas.microsoft.com/office/drawing/2014/chart" uri="{C3380CC4-5D6E-409C-BE32-E72D297353CC}">
                <c16:uniqueId val="{00000011-7A0B-45EC-A8E8-F9A0A5F0C7EF}"/>
              </c:ext>
            </c:extLst>
          </c:dPt>
          <c:dPt>
            <c:idx val="25"/>
            <c:bubble3D val="0"/>
            <c:extLst>
              <c:ext xmlns:c16="http://schemas.microsoft.com/office/drawing/2014/chart" uri="{C3380CC4-5D6E-409C-BE32-E72D297353CC}">
                <c16:uniqueId val="{00000012-7A0B-45EC-A8E8-F9A0A5F0C7EF}"/>
              </c:ext>
            </c:extLst>
          </c:dPt>
          <c:dPt>
            <c:idx val="26"/>
            <c:bubble3D val="0"/>
            <c:extLst>
              <c:ext xmlns:c16="http://schemas.microsoft.com/office/drawing/2014/chart" uri="{C3380CC4-5D6E-409C-BE32-E72D297353CC}">
                <c16:uniqueId val="{00000013-7A0B-45EC-A8E8-F9A0A5F0C7EF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1!$I$7:$I$33</c:f>
                <c:numCache>
                  <c:formatCode>General</c:formatCode>
                  <c:ptCount val="2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3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3</c:v>
                  </c:pt>
                  <c:pt idx="18">
                    <c:v>0</c:v>
                  </c:pt>
                  <c:pt idx="19">
                    <c:v>3</c:v>
                  </c:pt>
                  <c:pt idx="20">
                    <c:v>0</c:v>
                  </c:pt>
                  <c:pt idx="21">
                    <c:v>3</c:v>
                  </c:pt>
                  <c:pt idx="22">
                    <c:v>0</c:v>
                  </c:pt>
                  <c:pt idx="23">
                    <c:v>0</c:v>
                  </c:pt>
                  <c:pt idx="24">
                    <c:v>0</c:v>
                  </c:pt>
                  <c:pt idx="25">
                    <c:v>3</c:v>
                  </c:pt>
                  <c:pt idx="26">
                    <c:v>0</c:v>
                  </c:pt>
                </c:numCache>
              </c:numRef>
            </c:plus>
          </c:errBars>
          <c:xVal>
            <c:numRef>
              <c:f>Kaplan1!$G$7:$G$33</c:f>
              <c:numCache>
                <c:formatCode>0.000</c:formatCode>
                <c:ptCount val="27"/>
                <c:pt idx="0">
                  <c:v>0</c:v>
                </c:pt>
                <c:pt idx="1">
                  <c:v>1.9285714285714286</c:v>
                </c:pt>
                <c:pt idx="2">
                  <c:v>1.9285714285714286</c:v>
                </c:pt>
                <c:pt idx="3">
                  <c:v>3.0714285714285716</c:v>
                </c:pt>
                <c:pt idx="4">
                  <c:v>3.0714285714285716</c:v>
                </c:pt>
                <c:pt idx="5">
                  <c:v>3.3571428571428572</c:v>
                </c:pt>
                <c:pt idx="6">
                  <c:v>3.3571428571428572</c:v>
                </c:pt>
                <c:pt idx="7">
                  <c:v>3.5</c:v>
                </c:pt>
                <c:pt idx="8">
                  <c:v>3.5</c:v>
                </c:pt>
                <c:pt idx="9">
                  <c:v>4.25</c:v>
                </c:pt>
                <c:pt idx="10">
                  <c:v>4.25</c:v>
                </c:pt>
                <c:pt idx="11">
                  <c:v>5</c:v>
                </c:pt>
                <c:pt idx="12">
                  <c:v>5</c:v>
                </c:pt>
                <c:pt idx="13">
                  <c:v>8.1785714285714288</c:v>
                </c:pt>
                <c:pt idx="14">
                  <c:v>8.1785714285714288</c:v>
                </c:pt>
                <c:pt idx="15">
                  <c:v>8.3571428571428577</c:v>
                </c:pt>
                <c:pt idx="16">
                  <c:v>8.3571428571428577</c:v>
                </c:pt>
                <c:pt idx="17">
                  <c:v>9.5</c:v>
                </c:pt>
                <c:pt idx="18">
                  <c:v>9.5</c:v>
                </c:pt>
                <c:pt idx="19">
                  <c:v>12.392857142857142</c:v>
                </c:pt>
                <c:pt idx="20">
                  <c:v>12.392857142857142</c:v>
                </c:pt>
                <c:pt idx="21">
                  <c:v>20.25</c:v>
                </c:pt>
                <c:pt idx="22">
                  <c:v>20.25</c:v>
                </c:pt>
                <c:pt idx="23">
                  <c:v>22.428571428571427</c:v>
                </c:pt>
                <c:pt idx="24">
                  <c:v>22.428571428571427</c:v>
                </c:pt>
                <c:pt idx="25">
                  <c:v>27</c:v>
                </c:pt>
                <c:pt idx="26">
                  <c:v>27</c:v>
                </c:pt>
              </c:numCache>
            </c:numRef>
          </c:xVal>
          <c:yVal>
            <c:numRef>
              <c:f>Kaplan1!$H$7:$H$33</c:f>
              <c:numCache>
                <c:formatCode>0.000</c:formatCode>
                <c:ptCount val="27"/>
                <c:pt idx="0">
                  <c:v>100</c:v>
                </c:pt>
                <c:pt idx="1">
                  <c:v>100</c:v>
                </c:pt>
                <c:pt idx="2">
                  <c:v>92.307692307692307</c:v>
                </c:pt>
                <c:pt idx="3">
                  <c:v>92.307692307692307</c:v>
                </c:pt>
                <c:pt idx="4">
                  <c:v>84.615384615384613</c:v>
                </c:pt>
                <c:pt idx="5">
                  <c:v>84.615384615384613</c:v>
                </c:pt>
                <c:pt idx="6">
                  <c:v>84.615384615384613</c:v>
                </c:pt>
                <c:pt idx="7">
                  <c:v>84.615384615384613</c:v>
                </c:pt>
                <c:pt idx="8">
                  <c:v>76.153846153846146</c:v>
                </c:pt>
                <c:pt idx="9">
                  <c:v>76.153846153846146</c:v>
                </c:pt>
                <c:pt idx="10">
                  <c:v>76.153846153846146</c:v>
                </c:pt>
                <c:pt idx="11">
                  <c:v>76.153846153846146</c:v>
                </c:pt>
                <c:pt idx="12">
                  <c:v>66.634615384615387</c:v>
                </c:pt>
                <c:pt idx="13">
                  <c:v>66.634615384615387</c:v>
                </c:pt>
                <c:pt idx="14">
                  <c:v>57.115384615384613</c:v>
                </c:pt>
                <c:pt idx="15">
                  <c:v>57.115384615384613</c:v>
                </c:pt>
                <c:pt idx="16">
                  <c:v>47.596153846153847</c:v>
                </c:pt>
                <c:pt idx="17">
                  <c:v>47.596153846153847</c:v>
                </c:pt>
                <c:pt idx="18">
                  <c:v>47.596153846153847</c:v>
                </c:pt>
                <c:pt idx="19">
                  <c:v>47.596153846153847</c:v>
                </c:pt>
                <c:pt idx="20">
                  <c:v>47.596153846153847</c:v>
                </c:pt>
                <c:pt idx="21">
                  <c:v>47.596153846153847</c:v>
                </c:pt>
                <c:pt idx="22">
                  <c:v>47.596153846153847</c:v>
                </c:pt>
                <c:pt idx="23">
                  <c:v>47.596153846153847</c:v>
                </c:pt>
                <c:pt idx="24">
                  <c:v>23.798076923076923</c:v>
                </c:pt>
                <c:pt idx="25">
                  <c:v>23.798076923076923</c:v>
                </c:pt>
                <c:pt idx="26">
                  <c:v>23.7980769230769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7A0B-45EC-A8E8-F9A0A5F0C7EF}"/>
            </c:ext>
          </c:extLst>
        </c:ser>
        <c:ser>
          <c:idx val="1"/>
          <c:order val="1"/>
          <c:tx>
            <c:v>1</c:v>
          </c:tx>
          <c:spPr>
            <a:ln w="38100">
              <a:solidFill>
                <a:schemeClr val="accent2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15-7A0B-45EC-A8E8-F9A0A5F0C7EF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16-7A0B-45EC-A8E8-F9A0A5F0C7EF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17-7A0B-45EC-A8E8-F9A0A5F0C7EF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18-7A0B-45EC-A8E8-F9A0A5F0C7EF}"/>
              </c:ext>
            </c:extLst>
          </c:dPt>
          <c:dPt>
            <c:idx val="4"/>
            <c:bubble3D val="0"/>
            <c:extLst>
              <c:ext xmlns:c16="http://schemas.microsoft.com/office/drawing/2014/chart" uri="{C3380CC4-5D6E-409C-BE32-E72D297353CC}">
                <c16:uniqueId val="{00000019-7A0B-45EC-A8E8-F9A0A5F0C7EF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1A-7A0B-45EC-A8E8-F9A0A5F0C7EF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1B-7A0B-45EC-A8E8-F9A0A5F0C7EF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1C-7A0B-45EC-A8E8-F9A0A5F0C7EF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1D-7A0B-45EC-A8E8-F9A0A5F0C7EF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2!$I$7:$I$15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3</c:v>
                  </c:pt>
                  <c:pt idx="2">
                    <c:v>0</c:v>
                  </c:pt>
                  <c:pt idx="3">
                    <c:v>3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  <c:pt idx="7">
                    <c:v>3</c:v>
                  </c:pt>
                  <c:pt idx="8">
                    <c:v>0</c:v>
                  </c:pt>
                </c:numCache>
              </c:numRef>
            </c:plus>
          </c:errBars>
          <c:xVal>
            <c:numRef>
              <c:f>Kaplan2!$G$7:$G$15</c:f>
              <c:numCache>
                <c:formatCode>0.000</c:formatCode>
                <c:ptCount val="9"/>
                <c:pt idx="0">
                  <c:v>0</c:v>
                </c:pt>
                <c:pt idx="1">
                  <c:v>12.464285714285714</c:v>
                </c:pt>
                <c:pt idx="2">
                  <c:v>12.464285714285714</c:v>
                </c:pt>
                <c:pt idx="3">
                  <c:v>13.928571428571429</c:v>
                </c:pt>
                <c:pt idx="4">
                  <c:v>13.928571428571429</c:v>
                </c:pt>
                <c:pt idx="5">
                  <c:v>15.75</c:v>
                </c:pt>
                <c:pt idx="6">
                  <c:v>15.75</c:v>
                </c:pt>
                <c:pt idx="7">
                  <c:v>17.964285714285715</c:v>
                </c:pt>
                <c:pt idx="8">
                  <c:v>17.964285714285715</c:v>
                </c:pt>
              </c:numCache>
            </c:numRef>
          </c:xVal>
          <c:yVal>
            <c:numRef>
              <c:f>Kaplan2!$H$7:$H$15</c:f>
              <c:numCache>
                <c:formatCode>0.000</c:formatCode>
                <c:ptCount val="9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7A0B-45EC-A8E8-F9A0A5F0C7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3778576"/>
        <c:axId val="1813780656"/>
      </c:scatterChart>
      <c:valAx>
        <c:axId val="1813778576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1813780656"/>
        <c:crosses val="autoZero"/>
        <c:crossBetween val="midCat"/>
      </c:valAx>
      <c:valAx>
        <c:axId val="1813780656"/>
        <c:scaling>
          <c:orientation val="minMax"/>
          <c:max val="10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1813778576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2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0</c:v>
          </c:tx>
          <c:spPr>
            <a:ln w="38100">
              <a:solidFill>
                <a:schemeClr val="accent1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3696-4211-91CC-505F5022F6CE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3696-4211-91CC-505F5022F6CE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2-3696-4211-91CC-505F5022F6CE}"/>
              </c:ext>
            </c:extLst>
          </c:dPt>
          <c:dPt>
            <c:idx val="4"/>
            <c:bubble3D val="0"/>
            <c:extLst>
              <c:ext xmlns:c16="http://schemas.microsoft.com/office/drawing/2014/chart" uri="{C3380CC4-5D6E-409C-BE32-E72D297353CC}">
                <c16:uniqueId val="{00000003-3696-4211-91CC-505F5022F6CE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04-3696-4211-91CC-505F5022F6CE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05-3696-4211-91CC-505F5022F6CE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06-3696-4211-91CC-505F5022F6CE}"/>
              </c:ext>
            </c:extLst>
          </c:dPt>
          <c:dPt>
            <c:idx val="10"/>
            <c:bubble3D val="0"/>
            <c:extLst>
              <c:ext xmlns:c16="http://schemas.microsoft.com/office/drawing/2014/chart" uri="{C3380CC4-5D6E-409C-BE32-E72D297353CC}">
                <c16:uniqueId val="{00000007-3696-4211-91CC-505F5022F6CE}"/>
              </c:ext>
            </c:extLst>
          </c:dPt>
          <c:dPt>
            <c:idx val="12"/>
            <c:bubble3D val="0"/>
            <c:extLst>
              <c:ext xmlns:c16="http://schemas.microsoft.com/office/drawing/2014/chart" uri="{C3380CC4-5D6E-409C-BE32-E72D297353CC}">
                <c16:uniqueId val="{00000008-3696-4211-91CC-505F5022F6CE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09-3696-4211-91CC-505F5022F6CE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0A-3696-4211-91CC-505F5022F6CE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0B-3696-4211-91CC-505F5022F6CE}"/>
              </c:ext>
            </c:extLst>
          </c:dPt>
          <c:dPt>
            <c:idx val="20"/>
            <c:bubble3D val="0"/>
            <c:extLst>
              <c:ext xmlns:c16="http://schemas.microsoft.com/office/drawing/2014/chart" uri="{C3380CC4-5D6E-409C-BE32-E72D297353CC}">
                <c16:uniqueId val="{0000000C-3696-4211-91CC-505F5022F6CE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0D-3696-4211-91CC-505F5022F6CE}"/>
              </c:ext>
            </c:extLst>
          </c:dPt>
          <c:dPt>
            <c:idx val="23"/>
            <c:bubble3D val="0"/>
            <c:extLst>
              <c:ext xmlns:c16="http://schemas.microsoft.com/office/drawing/2014/chart" uri="{C3380CC4-5D6E-409C-BE32-E72D297353CC}">
                <c16:uniqueId val="{0000000E-3696-4211-91CC-505F5022F6CE}"/>
              </c:ext>
            </c:extLst>
          </c:dPt>
          <c:dPt>
            <c:idx val="24"/>
            <c:bubble3D val="0"/>
            <c:extLst>
              <c:ext xmlns:c16="http://schemas.microsoft.com/office/drawing/2014/chart" uri="{C3380CC4-5D6E-409C-BE32-E72D297353CC}">
                <c16:uniqueId val="{0000000F-3696-4211-91CC-505F5022F6CE}"/>
              </c:ext>
            </c:extLst>
          </c:dPt>
          <c:dPt>
            <c:idx val="25"/>
            <c:bubble3D val="0"/>
            <c:extLst>
              <c:ext xmlns:c16="http://schemas.microsoft.com/office/drawing/2014/chart" uri="{C3380CC4-5D6E-409C-BE32-E72D297353CC}">
                <c16:uniqueId val="{00000010-3696-4211-91CC-505F5022F6CE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1!$I$7:$I$32</c:f>
                <c:numCache>
                  <c:formatCode>General</c:formatCode>
                  <c:ptCount val="2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3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3</c:v>
                  </c:pt>
                  <c:pt idx="23">
                    <c:v>0</c:v>
                  </c:pt>
                  <c:pt idx="24">
                    <c:v>3</c:v>
                  </c:pt>
                  <c:pt idx="25">
                    <c:v>0</c:v>
                  </c:pt>
                </c:numCache>
              </c:numRef>
            </c:plus>
          </c:errBars>
          <c:xVal>
            <c:numRef>
              <c:f>Kaplan1!$G$7:$G$32</c:f>
              <c:numCache>
                <c:formatCode>0.000</c:formatCode>
                <c:ptCount val="26"/>
                <c:pt idx="0">
                  <c:v>0</c:v>
                </c:pt>
                <c:pt idx="1">
                  <c:v>1.5357142857142858</c:v>
                </c:pt>
                <c:pt idx="2">
                  <c:v>1.5357142857142858</c:v>
                </c:pt>
                <c:pt idx="3">
                  <c:v>1.5714285714285714</c:v>
                </c:pt>
                <c:pt idx="4">
                  <c:v>1.8214285714285714</c:v>
                </c:pt>
                <c:pt idx="5">
                  <c:v>1.8214285714285714</c:v>
                </c:pt>
                <c:pt idx="6">
                  <c:v>1.9285714285714286</c:v>
                </c:pt>
                <c:pt idx="7">
                  <c:v>1.9285714285714286</c:v>
                </c:pt>
                <c:pt idx="8">
                  <c:v>2.1428571428571428</c:v>
                </c:pt>
                <c:pt idx="9">
                  <c:v>2.1428571428571428</c:v>
                </c:pt>
                <c:pt idx="10">
                  <c:v>2.2857142857142856</c:v>
                </c:pt>
                <c:pt idx="11">
                  <c:v>2.2857142857142856</c:v>
                </c:pt>
                <c:pt idx="12">
                  <c:v>3.0714285714285716</c:v>
                </c:pt>
                <c:pt idx="13">
                  <c:v>3.0714285714285716</c:v>
                </c:pt>
                <c:pt idx="14">
                  <c:v>3.5</c:v>
                </c:pt>
                <c:pt idx="15">
                  <c:v>3.5</c:v>
                </c:pt>
                <c:pt idx="16">
                  <c:v>4.6071428571428568</c:v>
                </c:pt>
                <c:pt idx="17">
                  <c:v>4.6071428571428568</c:v>
                </c:pt>
                <c:pt idx="18">
                  <c:v>5.0357142857142856</c:v>
                </c:pt>
                <c:pt idx="19">
                  <c:v>5.0357142857142856</c:v>
                </c:pt>
                <c:pt idx="20">
                  <c:v>11.321428571428571</c:v>
                </c:pt>
                <c:pt idx="21">
                  <c:v>11.321428571428571</c:v>
                </c:pt>
                <c:pt idx="22">
                  <c:v>20.25</c:v>
                </c:pt>
                <c:pt idx="23">
                  <c:v>20.25</c:v>
                </c:pt>
                <c:pt idx="24">
                  <c:v>27</c:v>
                </c:pt>
                <c:pt idx="25">
                  <c:v>27</c:v>
                </c:pt>
              </c:numCache>
            </c:numRef>
          </c:xVal>
          <c:yVal>
            <c:numRef>
              <c:f>Kaplan1!$H$7:$H$32</c:f>
              <c:numCache>
                <c:formatCode>0.000</c:formatCode>
                <c:ptCount val="26"/>
                <c:pt idx="0">
                  <c:v>100</c:v>
                </c:pt>
                <c:pt idx="1">
                  <c:v>100</c:v>
                </c:pt>
                <c:pt idx="2">
                  <c:v>92.307692307692307</c:v>
                </c:pt>
                <c:pt idx="3">
                  <c:v>92.307692307692307</c:v>
                </c:pt>
                <c:pt idx="4">
                  <c:v>92.307692307692307</c:v>
                </c:pt>
                <c:pt idx="5">
                  <c:v>92.307692307692307</c:v>
                </c:pt>
                <c:pt idx="6">
                  <c:v>92.307692307692307</c:v>
                </c:pt>
                <c:pt idx="7">
                  <c:v>83.07692307692308</c:v>
                </c:pt>
                <c:pt idx="8">
                  <c:v>83.07692307692308</c:v>
                </c:pt>
                <c:pt idx="9">
                  <c:v>73.846153846153854</c:v>
                </c:pt>
                <c:pt idx="10">
                  <c:v>73.846153846153854</c:v>
                </c:pt>
                <c:pt idx="11">
                  <c:v>64.615384615384613</c:v>
                </c:pt>
                <c:pt idx="12">
                  <c:v>64.615384615384613</c:v>
                </c:pt>
                <c:pt idx="13">
                  <c:v>55.384615384615387</c:v>
                </c:pt>
                <c:pt idx="14">
                  <c:v>55.384615384615387</c:v>
                </c:pt>
                <c:pt idx="15">
                  <c:v>46.153846153846153</c:v>
                </c:pt>
                <c:pt idx="16">
                  <c:v>46.153846153846153</c:v>
                </c:pt>
                <c:pt idx="17">
                  <c:v>36.923076923076927</c:v>
                </c:pt>
                <c:pt idx="18">
                  <c:v>36.923076923076927</c:v>
                </c:pt>
                <c:pt idx="19">
                  <c:v>27.692307692307693</c:v>
                </c:pt>
                <c:pt idx="20">
                  <c:v>27.692307692307693</c:v>
                </c:pt>
                <c:pt idx="21">
                  <c:v>18.461538461538463</c:v>
                </c:pt>
                <c:pt idx="22">
                  <c:v>18.461538461538463</c:v>
                </c:pt>
                <c:pt idx="23">
                  <c:v>18.461538461538463</c:v>
                </c:pt>
                <c:pt idx="24">
                  <c:v>18.461538461538463</c:v>
                </c:pt>
                <c:pt idx="25">
                  <c:v>18.4615384615384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3696-4211-91CC-505F5022F6CE}"/>
            </c:ext>
          </c:extLst>
        </c:ser>
        <c:ser>
          <c:idx val="1"/>
          <c:order val="1"/>
          <c:tx>
            <c:v>1</c:v>
          </c:tx>
          <c:spPr>
            <a:ln w="38100">
              <a:solidFill>
                <a:schemeClr val="accent2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12-3696-4211-91CC-505F5022F6CE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13-3696-4211-91CC-505F5022F6CE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14-3696-4211-91CC-505F5022F6CE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15-3696-4211-91CC-505F5022F6CE}"/>
              </c:ext>
            </c:extLst>
          </c:dPt>
          <c:dPt>
            <c:idx val="4"/>
            <c:bubble3D val="0"/>
            <c:extLst>
              <c:ext xmlns:c16="http://schemas.microsoft.com/office/drawing/2014/chart" uri="{C3380CC4-5D6E-409C-BE32-E72D297353CC}">
                <c16:uniqueId val="{00000016-3696-4211-91CC-505F5022F6CE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17-3696-4211-91CC-505F5022F6CE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18-3696-4211-91CC-505F5022F6CE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19-3696-4211-91CC-505F5022F6CE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2!$I$7:$I$15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3</c:v>
                  </c:pt>
                  <c:pt idx="2">
                    <c:v>0</c:v>
                  </c:pt>
                  <c:pt idx="3">
                    <c:v>3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3</c:v>
                  </c:pt>
                  <c:pt idx="8">
                    <c:v>0</c:v>
                  </c:pt>
                </c:numCache>
              </c:numRef>
            </c:plus>
          </c:errBars>
          <c:xVal>
            <c:numRef>
              <c:f>Kaplan2!$G$7:$G$15</c:f>
              <c:numCache>
                <c:formatCode>0.000</c:formatCode>
                <c:ptCount val="9"/>
                <c:pt idx="0">
                  <c:v>0</c:v>
                </c:pt>
                <c:pt idx="1">
                  <c:v>12.464285714285714</c:v>
                </c:pt>
                <c:pt idx="2">
                  <c:v>12.464285714285714</c:v>
                </c:pt>
                <c:pt idx="3">
                  <c:v>13.928571428571429</c:v>
                </c:pt>
                <c:pt idx="4">
                  <c:v>13.928571428571429</c:v>
                </c:pt>
                <c:pt idx="5">
                  <c:v>15.285714285714286</c:v>
                </c:pt>
                <c:pt idx="6">
                  <c:v>15.285714285714286</c:v>
                </c:pt>
                <c:pt idx="7">
                  <c:v>15.75</c:v>
                </c:pt>
                <c:pt idx="8">
                  <c:v>15.75</c:v>
                </c:pt>
              </c:numCache>
            </c:numRef>
          </c:xVal>
          <c:yVal>
            <c:numRef>
              <c:f>Kaplan2!$H$7:$H$15</c:f>
              <c:numCache>
                <c:formatCode>0.000</c:formatCode>
                <c:ptCount val="9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50</c:v>
                </c:pt>
                <c:pt idx="7">
                  <c:v>50</c:v>
                </c:pt>
                <c:pt idx="8">
                  <c:v>5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3696-4211-91CC-505F5022F6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44049728"/>
        <c:axId val="1644050144"/>
      </c:scatterChart>
      <c:valAx>
        <c:axId val="1644049728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1644050144"/>
        <c:crosses val="autoZero"/>
        <c:crossBetween val="midCat"/>
      </c:valAx>
      <c:valAx>
        <c:axId val="1644050144"/>
        <c:scaling>
          <c:orientation val="minMax"/>
          <c:max val="10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1644049728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2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0</c:v>
          </c:tx>
          <c:spPr>
            <a:ln w="38100">
              <a:solidFill>
                <a:schemeClr val="accent1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5261-47C0-A4C7-F51ADE6287D7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5261-47C0-A4C7-F51ADE6287D7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2-5261-47C0-A4C7-F51ADE6287D7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03-5261-47C0-A4C7-F51ADE6287D7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04-5261-47C0-A4C7-F51ADE6287D7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05-5261-47C0-A4C7-F51ADE6287D7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06-5261-47C0-A4C7-F51ADE6287D7}"/>
              </c:ext>
            </c:extLst>
          </c:dPt>
          <c:dPt>
            <c:idx val="12"/>
            <c:bubble3D val="0"/>
            <c:extLst>
              <c:ext xmlns:c16="http://schemas.microsoft.com/office/drawing/2014/chart" uri="{C3380CC4-5D6E-409C-BE32-E72D297353CC}">
                <c16:uniqueId val="{00000007-5261-47C0-A4C7-F51ADE6287D7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08-5261-47C0-A4C7-F51ADE6287D7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09-5261-47C0-A4C7-F51ADE6287D7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0A-5261-47C0-A4C7-F51ADE6287D7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0B-5261-47C0-A4C7-F51ADE6287D7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0C-5261-47C0-A4C7-F51ADE6287D7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0D-5261-47C0-A4C7-F51ADE6287D7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0E-5261-47C0-A4C7-F51ADE6287D7}"/>
              </c:ext>
            </c:extLst>
          </c:dPt>
          <c:dPt>
            <c:idx val="21"/>
            <c:bubble3D val="0"/>
            <c:extLst>
              <c:ext xmlns:c16="http://schemas.microsoft.com/office/drawing/2014/chart" uri="{C3380CC4-5D6E-409C-BE32-E72D297353CC}">
                <c16:uniqueId val="{0000000F-5261-47C0-A4C7-F51ADE6287D7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10-5261-47C0-A4C7-F51ADE6287D7}"/>
              </c:ext>
            </c:extLst>
          </c:dPt>
          <c:dPt>
            <c:idx val="23"/>
            <c:bubble3D val="0"/>
            <c:extLst>
              <c:ext xmlns:c16="http://schemas.microsoft.com/office/drawing/2014/chart" uri="{C3380CC4-5D6E-409C-BE32-E72D297353CC}">
                <c16:uniqueId val="{00000011-5261-47C0-A4C7-F51ADE6287D7}"/>
              </c:ext>
            </c:extLst>
          </c:dPt>
          <c:dPt>
            <c:idx val="25"/>
            <c:bubble3D val="0"/>
            <c:extLst>
              <c:ext xmlns:c16="http://schemas.microsoft.com/office/drawing/2014/chart" uri="{C3380CC4-5D6E-409C-BE32-E72D297353CC}">
                <c16:uniqueId val="{00000012-5261-47C0-A4C7-F51ADE6287D7}"/>
              </c:ext>
            </c:extLst>
          </c:dPt>
          <c:dPt>
            <c:idx val="26"/>
            <c:bubble3D val="0"/>
            <c:extLst>
              <c:ext xmlns:c16="http://schemas.microsoft.com/office/drawing/2014/chart" uri="{C3380CC4-5D6E-409C-BE32-E72D297353CC}">
                <c16:uniqueId val="{00000013-5261-47C0-A4C7-F51ADE6287D7}"/>
              </c:ext>
            </c:extLst>
          </c:dPt>
          <c:dPt>
            <c:idx val="27"/>
            <c:bubble3D val="0"/>
            <c:extLst>
              <c:ext xmlns:c16="http://schemas.microsoft.com/office/drawing/2014/chart" uri="{C3380CC4-5D6E-409C-BE32-E72D297353CC}">
                <c16:uniqueId val="{00000014-5261-47C0-A4C7-F51ADE6287D7}"/>
              </c:ext>
            </c:extLst>
          </c:dPt>
          <c:dPt>
            <c:idx val="28"/>
            <c:bubble3D val="0"/>
            <c:extLst>
              <c:ext xmlns:c16="http://schemas.microsoft.com/office/drawing/2014/chart" uri="{C3380CC4-5D6E-409C-BE32-E72D297353CC}">
                <c16:uniqueId val="{00000015-5261-47C0-A4C7-F51ADE6287D7}"/>
              </c:ext>
            </c:extLst>
          </c:dPt>
          <c:dPt>
            <c:idx val="29"/>
            <c:bubble3D val="0"/>
            <c:extLst>
              <c:ext xmlns:c16="http://schemas.microsoft.com/office/drawing/2014/chart" uri="{C3380CC4-5D6E-409C-BE32-E72D297353CC}">
                <c16:uniqueId val="{00000016-5261-47C0-A4C7-F51ADE6287D7}"/>
              </c:ext>
            </c:extLst>
          </c:dPt>
          <c:dPt>
            <c:idx val="30"/>
            <c:bubble3D val="0"/>
            <c:extLst>
              <c:ext xmlns:c16="http://schemas.microsoft.com/office/drawing/2014/chart" uri="{C3380CC4-5D6E-409C-BE32-E72D297353CC}">
                <c16:uniqueId val="{00000017-5261-47C0-A4C7-F51ADE6287D7}"/>
              </c:ext>
            </c:extLst>
          </c:dPt>
          <c:dPt>
            <c:idx val="31"/>
            <c:bubble3D val="0"/>
            <c:extLst>
              <c:ext xmlns:c16="http://schemas.microsoft.com/office/drawing/2014/chart" uri="{C3380CC4-5D6E-409C-BE32-E72D297353CC}">
                <c16:uniqueId val="{00000018-5261-47C0-A4C7-F51ADE6287D7}"/>
              </c:ext>
            </c:extLst>
          </c:dPt>
          <c:dPt>
            <c:idx val="32"/>
            <c:bubble3D val="0"/>
            <c:extLst>
              <c:ext xmlns:c16="http://schemas.microsoft.com/office/drawing/2014/chart" uri="{C3380CC4-5D6E-409C-BE32-E72D297353CC}">
                <c16:uniqueId val="{00000019-5261-47C0-A4C7-F51ADE6287D7}"/>
              </c:ext>
            </c:extLst>
          </c:dPt>
          <c:dPt>
            <c:idx val="33"/>
            <c:bubble3D val="0"/>
            <c:extLst>
              <c:ext xmlns:c16="http://schemas.microsoft.com/office/drawing/2014/chart" uri="{C3380CC4-5D6E-409C-BE32-E72D297353CC}">
                <c16:uniqueId val="{0000001A-5261-47C0-A4C7-F51ADE6287D7}"/>
              </c:ext>
            </c:extLst>
          </c:dPt>
          <c:dPt>
            <c:idx val="34"/>
            <c:bubble3D val="0"/>
            <c:extLst>
              <c:ext xmlns:c16="http://schemas.microsoft.com/office/drawing/2014/chart" uri="{C3380CC4-5D6E-409C-BE32-E72D297353CC}">
                <c16:uniqueId val="{0000001B-5261-47C0-A4C7-F51ADE6287D7}"/>
              </c:ext>
            </c:extLst>
          </c:dPt>
          <c:dPt>
            <c:idx val="35"/>
            <c:bubble3D val="0"/>
            <c:extLst>
              <c:ext xmlns:c16="http://schemas.microsoft.com/office/drawing/2014/chart" uri="{C3380CC4-5D6E-409C-BE32-E72D297353CC}">
                <c16:uniqueId val="{0000001C-5261-47C0-A4C7-F51ADE6287D7}"/>
              </c:ext>
            </c:extLst>
          </c:dPt>
          <c:dPt>
            <c:idx val="36"/>
            <c:bubble3D val="0"/>
            <c:extLst>
              <c:ext xmlns:c16="http://schemas.microsoft.com/office/drawing/2014/chart" uri="{C3380CC4-5D6E-409C-BE32-E72D297353CC}">
                <c16:uniqueId val="{0000001D-5261-47C0-A4C7-F51ADE6287D7}"/>
              </c:ext>
            </c:extLst>
          </c:dPt>
          <c:dPt>
            <c:idx val="37"/>
            <c:bubble3D val="0"/>
            <c:extLst>
              <c:ext xmlns:c16="http://schemas.microsoft.com/office/drawing/2014/chart" uri="{C3380CC4-5D6E-409C-BE32-E72D297353CC}">
                <c16:uniqueId val="{0000001E-5261-47C0-A4C7-F51ADE6287D7}"/>
              </c:ext>
            </c:extLst>
          </c:dPt>
          <c:dPt>
            <c:idx val="38"/>
            <c:bubble3D val="0"/>
            <c:extLst>
              <c:ext xmlns:c16="http://schemas.microsoft.com/office/drawing/2014/chart" uri="{C3380CC4-5D6E-409C-BE32-E72D297353CC}">
                <c16:uniqueId val="{0000001F-5261-47C0-A4C7-F51ADE6287D7}"/>
              </c:ext>
            </c:extLst>
          </c:dPt>
          <c:dPt>
            <c:idx val="39"/>
            <c:bubble3D val="0"/>
            <c:extLst>
              <c:ext xmlns:c16="http://schemas.microsoft.com/office/drawing/2014/chart" uri="{C3380CC4-5D6E-409C-BE32-E72D297353CC}">
                <c16:uniqueId val="{00000020-5261-47C0-A4C7-F51ADE6287D7}"/>
              </c:ext>
            </c:extLst>
          </c:dPt>
          <c:dPt>
            <c:idx val="40"/>
            <c:bubble3D val="0"/>
            <c:extLst>
              <c:ext xmlns:c16="http://schemas.microsoft.com/office/drawing/2014/chart" uri="{C3380CC4-5D6E-409C-BE32-E72D297353CC}">
                <c16:uniqueId val="{00000021-5261-47C0-A4C7-F51ADE6287D7}"/>
              </c:ext>
            </c:extLst>
          </c:dPt>
          <c:dPt>
            <c:idx val="41"/>
            <c:bubble3D val="0"/>
            <c:extLst>
              <c:ext xmlns:c16="http://schemas.microsoft.com/office/drawing/2014/chart" uri="{C3380CC4-5D6E-409C-BE32-E72D297353CC}">
                <c16:uniqueId val="{00000022-5261-47C0-A4C7-F51ADE6287D7}"/>
              </c:ext>
            </c:extLst>
          </c:dPt>
          <c:dPt>
            <c:idx val="42"/>
            <c:bubble3D val="0"/>
            <c:extLst>
              <c:ext xmlns:c16="http://schemas.microsoft.com/office/drawing/2014/chart" uri="{C3380CC4-5D6E-409C-BE32-E72D297353CC}">
                <c16:uniqueId val="{00000023-5261-47C0-A4C7-F51ADE6287D7}"/>
              </c:ext>
            </c:extLst>
          </c:dPt>
          <c:dPt>
            <c:idx val="43"/>
            <c:bubble3D val="0"/>
            <c:extLst>
              <c:ext xmlns:c16="http://schemas.microsoft.com/office/drawing/2014/chart" uri="{C3380CC4-5D6E-409C-BE32-E72D297353CC}">
                <c16:uniqueId val="{00000024-5261-47C0-A4C7-F51ADE6287D7}"/>
              </c:ext>
            </c:extLst>
          </c:dPt>
          <c:dPt>
            <c:idx val="44"/>
            <c:bubble3D val="0"/>
            <c:extLst>
              <c:ext xmlns:c16="http://schemas.microsoft.com/office/drawing/2014/chart" uri="{C3380CC4-5D6E-409C-BE32-E72D297353CC}">
                <c16:uniqueId val="{00000025-5261-47C0-A4C7-F51ADE6287D7}"/>
              </c:ext>
            </c:extLst>
          </c:dPt>
          <c:dPt>
            <c:idx val="45"/>
            <c:bubble3D val="0"/>
            <c:extLst>
              <c:ext xmlns:c16="http://schemas.microsoft.com/office/drawing/2014/chart" uri="{C3380CC4-5D6E-409C-BE32-E72D297353CC}">
                <c16:uniqueId val="{00000026-5261-47C0-A4C7-F51ADE6287D7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1!$I$7:$I$52</c:f>
                <c:numCache>
                  <c:formatCode>General</c:formatCode>
                  <c:ptCount val="4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3</c:v>
                  </c:pt>
                  <c:pt idx="12">
                    <c:v>0</c:v>
                  </c:pt>
                  <c:pt idx="13">
                    <c:v>3</c:v>
                  </c:pt>
                  <c:pt idx="14">
                    <c:v>0</c:v>
                  </c:pt>
                  <c:pt idx="15">
                    <c:v>3</c:v>
                  </c:pt>
                  <c:pt idx="16">
                    <c:v>0</c:v>
                  </c:pt>
                  <c:pt idx="17">
                    <c:v>3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3</c:v>
                  </c:pt>
                  <c:pt idx="22">
                    <c:v>0</c:v>
                  </c:pt>
                  <c:pt idx="23">
                    <c:v>0</c:v>
                  </c:pt>
                  <c:pt idx="24">
                    <c:v>0</c:v>
                  </c:pt>
                  <c:pt idx="25">
                    <c:v>3</c:v>
                  </c:pt>
                  <c:pt idx="26">
                    <c:v>0</c:v>
                  </c:pt>
                  <c:pt idx="27">
                    <c:v>3</c:v>
                  </c:pt>
                  <c:pt idx="28">
                    <c:v>0</c:v>
                  </c:pt>
                  <c:pt idx="29">
                    <c:v>3</c:v>
                  </c:pt>
                  <c:pt idx="30">
                    <c:v>0</c:v>
                  </c:pt>
                  <c:pt idx="31">
                    <c:v>3</c:v>
                  </c:pt>
                  <c:pt idx="32">
                    <c:v>0</c:v>
                  </c:pt>
                  <c:pt idx="33">
                    <c:v>0</c:v>
                  </c:pt>
                  <c:pt idx="34">
                    <c:v>3</c:v>
                  </c:pt>
                  <c:pt idx="35">
                    <c:v>0</c:v>
                  </c:pt>
                  <c:pt idx="36">
                    <c:v>3</c:v>
                  </c:pt>
                  <c:pt idx="37">
                    <c:v>0</c:v>
                  </c:pt>
                  <c:pt idx="38">
                    <c:v>3</c:v>
                  </c:pt>
                  <c:pt idx="39">
                    <c:v>0</c:v>
                  </c:pt>
                  <c:pt idx="40">
                    <c:v>3</c:v>
                  </c:pt>
                  <c:pt idx="41">
                    <c:v>0</c:v>
                  </c:pt>
                  <c:pt idx="42">
                    <c:v>3</c:v>
                  </c:pt>
                  <c:pt idx="43">
                    <c:v>0</c:v>
                  </c:pt>
                  <c:pt idx="44">
                    <c:v>3</c:v>
                  </c:pt>
                  <c:pt idx="45">
                    <c:v>0</c:v>
                  </c:pt>
                </c:numCache>
              </c:numRef>
            </c:plus>
          </c:errBars>
          <c:xVal>
            <c:numRef>
              <c:f>Kaplan1!$G$7:$G$52</c:f>
              <c:numCache>
                <c:formatCode>0.000</c:formatCode>
                <c:ptCount val="46"/>
                <c:pt idx="0">
                  <c:v>0</c:v>
                </c:pt>
                <c:pt idx="1">
                  <c:v>2.25</c:v>
                </c:pt>
                <c:pt idx="2">
                  <c:v>2.25</c:v>
                </c:pt>
                <c:pt idx="3">
                  <c:v>2.3214285714285716</c:v>
                </c:pt>
                <c:pt idx="4">
                  <c:v>2.3214285714285716</c:v>
                </c:pt>
                <c:pt idx="5">
                  <c:v>2.4642857142857144</c:v>
                </c:pt>
                <c:pt idx="6">
                  <c:v>2.4642857142857144</c:v>
                </c:pt>
                <c:pt idx="7">
                  <c:v>4.3214285714285712</c:v>
                </c:pt>
                <c:pt idx="8">
                  <c:v>4.3214285714285712</c:v>
                </c:pt>
                <c:pt idx="9">
                  <c:v>5.4285714285714288</c:v>
                </c:pt>
                <c:pt idx="10">
                  <c:v>5.4285714285714288</c:v>
                </c:pt>
                <c:pt idx="11">
                  <c:v>7.1071428571428568</c:v>
                </c:pt>
                <c:pt idx="12">
                  <c:v>7.1071428571428568</c:v>
                </c:pt>
                <c:pt idx="13">
                  <c:v>7.3214285714285712</c:v>
                </c:pt>
                <c:pt idx="14">
                  <c:v>7.3214285714285712</c:v>
                </c:pt>
                <c:pt idx="15">
                  <c:v>8.3214285714285712</c:v>
                </c:pt>
                <c:pt idx="16">
                  <c:v>8.3214285714285712</c:v>
                </c:pt>
                <c:pt idx="17">
                  <c:v>9</c:v>
                </c:pt>
                <c:pt idx="18">
                  <c:v>9</c:v>
                </c:pt>
                <c:pt idx="19">
                  <c:v>10.607142857142858</c:v>
                </c:pt>
                <c:pt idx="20">
                  <c:v>10.607142857142858</c:v>
                </c:pt>
                <c:pt idx="21">
                  <c:v>11.964285714285714</c:v>
                </c:pt>
                <c:pt idx="22">
                  <c:v>11.964285714285714</c:v>
                </c:pt>
                <c:pt idx="23">
                  <c:v>13.214285714285714</c:v>
                </c:pt>
                <c:pt idx="24">
                  <c:v>13.214285714285714</c:v>
                </c:pt>
                <c:pt idx="25">
                  <c:v>13.785714285714286</c:v>
                </c:pt>
                <c:pt idx="26">
                  <c:v>13.785714285714286</c:v>
                </c:pt>
                <c:pt idx="27">
                  <c:v>14.285714285714286</c:v>
                </c:pt>
                <c:pt idx="28">
                  <c:v>14.285714285714286</c:v>
                </c:pt>
                <c:pt idx="29">
                  <c:v>17</c:v>
                </c:pt>
                <c:pt idx="30">
                  <c:v>17</c:v>
                </c:pt>
                <c:pt idx="31">
                  <c:v>21.571428571428573</c:v>
                </c:pt>
                <c:pt idx="32">
                  <c:v>21.571428571428573</c:v>
                </c:pt>
                <c:pt idx="33">
                  <c:v>21.607142857142858</c:v>
                </c:pt>
                <c:pt idx="34">
                  <c:v>22</c:v>
                </c:pt>
                <c:pt idx="35">
                  <c:v>22</c:v>
                </c:pt>
                <c:pt idx="36">
                  <c:v>24.75</c:v>
                </c:pt>
                <c:pt idx="37">
                  <c:v>24.75</c:v>
                </c:pt>
                <c:pt idx="38">
                  <c:v>25.607142857142858</c:v>
                </c:pt>
                <c:pt idx="39">
                  <c:v>25.607142857142858</c:v>
                </c:pt>
                <c:pt idx="40">
                  <c:v>26</c:v>
                </c:pt>
                <c:pt idx="41">
                  <c:v>26</c:v>
                </c:pt>
                <c:pt idx="42">
                  <c:v>26.428571428571427</c:v>
                </c:pt>
                <c:pt idx="43">
                  <c:v>26.428571428571427</c:v>
                </c:pt>
                <c:pt idx="44">
                  <c:v>27.5</c:v>
                </c:pt>
                <c:pt idx="45">
                  <c:v>27.5</c:v>
                </c:pt>
              </c:numCache>
            </c:numRef>
          </c:xVal>
          <c:yVal>
            <c:numRef>
              <c:f>Kaplan1!$H$7:$H$52</c:f>
              <c:numCache>
                <c:formatCode>0.000</c:formatCode>
                <c:ptCount val="46"/>
                <c:pt idx="0">
                  <c:v>100</c:v>
                </c:pt>
                <c:pt idx="1">
                  <c:v>100</c:v>
                </c:pt>
                <c:pt idx="2">
                  <c:v>95.652173913043484</c:v>
                </c:pt>
                <c:pt idx="3">
                  <c:v>95.652173913043484</c:v>
                </c:pt>
                <c:pt idx="4">
                  <c:v>91.304347826086968</c:v>
                </c:pt>
                <c:pt idx="5">
                  <c:v>91.304347826086968</c:v>
                </c:pt>
                <c:pt idx="6">
                  <c:v>86.956521739130437</c:v>
                </c:pt>
                <c:pt idx="7">
                  <c:v>86.956521739130437</c:v>
                </c:pt>
                <c:pt idx="8">
                  <c:v>82.608695652173907</c:v>
                </c:pt>
                <c:pt idx="9">
                  <c:v>82.608695652173907</c:v>
                </c:pt>
                <c:pt idx="10">
                  <c:v>78.260869565217376</c:v>
                </c:pt>
                <c:pt idx="11">
                  <c:v>78.260869565217376</c:v>
                </c:pt>
                <c:pt idx="12">
                  <c:v>78.260869565217376</c:v>
                </c:pt>
                <c:pt idx="13">
                  <c:v>78.260869565217376</c:v>
                </c:pt>
                <c:pt idx="14">
                  <c:v>78.260869565217376</c:v>
                </c:pt>
                <c:pt idx="15">
                  <c:v>78.260869565217376</c:v>
                </c:pt>
                <c:pt idx="16">
                  <c:v>78.260869565217376</c:v>
                </c:pt>
                <c:pt idx="17">
                  <c:v>78.260869565217376</c:v>
                </c:pt>
                <c:pt idx="18">
                  <c:v>78.260869565217376</c:v>
                </c:pt>
                <c:pt idx="19">
                  <c:v>78.260869565217376</c:v>
                </c:pt>
                <c:pt idx="20">
                  <c:v>72.670807453416131</c:v>
                </c:pt>
                <c:pt idx="21">
                  <c:v>72.670807453416131</c:v>
                </c:pt>
                <c:pt idx="22">
                  <c:v>72.670807453416131</c:v>
                </c:pt>
                <c:pt idx="23">
                  <c:v>72.670807453416131</c:v>
                </c:pt>
                <c:pt idx="24">
                  <c:v>66.614906832298118</c:v>
                </c:pt>
                <c:pt idx="25">
                  <c:v>66.614906832298118</c:v>
                </c:pt>
                <c:pt idx="26">
                  <c:v>66.614906832298118</c:v>
                </c:pt>
                <c:pt idx="27">
                  <c:v>66.614906832298118</c:v>
                </c:pt>
                <c:pt idx="28">
                  <c:v>66.614906832298118</c:v>
                </c:pt>
                <c:pt idx="29">
                  <c:v>66.614906832298118</c:v>
                </c:pt>
                <c:pt idx="30">
                  <c:v>66.614906832298118</c:v>
                </c:pt>
                <c:pt idx="31">
                  <c:v>66.614906832298118</c:v>
                </c:pt>
                <c:pt idx="32">
                  <c:v>66.614906832298118</c:v>
                </c:pt>
                <c:pt idx="33">
                  <c:v>66.614906832298118</c:v>
                </c:pt>
                <c:pt idx="34">
                  <c:v>66.614906832298118</c:v>
                </c:pt>
                <c:pt idx="35">
                  <c:v>66.614906832298118</c:v>
                </c:pt>
                <c:pt idx="36">
                  <c:v>66.614906832298118</c:v>
                </c:pt>
                <c:pt idx="37">
                  <c:v>66.614906832298118</c:v>
                </c:pt>
                <c:pt idx="38">
                  <c:v>66.614906832298118</c:v>
                </c:pt>
                <c:pt idx="39">
                  <c:v>66.614906832298118</c:v>
                </c:pt>
                <c:pt idx="40">
                  <c:v>66.614906832298118</c:v>
                </c:pt>
                <c:pt idx="41">
                  <c:v>66.614906832298118</c:v>
                </c:pt>
                <c:pt idx="42">
                  <c:v>66.614906832298118</c:v>
                </c:pt>
                <c:pt idx="43">
                  <c:v>66.614906832298118</c:v>
                </c:pt>
                <c:pt idx="44">
                  <c:v>66.614906832298118</c:v>
                </c:pt>
                <c:pt idx="45">
                  <c:v>66.6149068322981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5261-47C0-A4C7-F51ADE6287D7}"/>
            </c:ext>
          </c:extLst>
        </c:ser>
        <c:ser>
          <c:idx val="1"/>
          <c:order val="1"/>
          <c:tx>
            <c:v>1</c:v>
          </c:tx>
          <c:spPr>
            <a:ln w="38100">
              <a:solidFill>
                <a:schemeClr val="accent2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28-5261-47C0-A4C7-F51ADE6287D7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29-5261-47C0-A4C7-F51ADE6287D7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2A-5261-47C0-A4C7-F51ADE6287D7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2B-5261-47C0-A4C7-F51ADE6287D7}"/>
              </c:ext>
            </c:extLst>
          </c:dPt>
          <c:dPt>
            <c:idx val="4"/>
            <c:bubble3D val="0"/>
            <c:extLst>
              <c:ext xmlns:c16="http://schemas.microsoft.com/office/drawing/2014/chart" uri="{C3380CC4-5D6E-409C-BE32-E72D297353CC}">
                <c16:uniqueId val="{0000002C-5261-47C0-A4C7-F51ADE6287D7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2D-5261-47C0-A4C7-F51ADE6287D7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2E-5261-47C0-A4C7-F51ADE6287D7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2F-5261-47C0-A4C7-F51ADE6287D7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30-5261-47C0-A4C7-F51ADE6287D7}"/>
              </c:ext>
            </c:extLst>
          </c:dPt>
          <c:dPt>
            <c:idx val="10"/>
            <c:bubble3D val="0"/>
            <c:extLst>
              <c:ext xmlns:c16="http://schemas.microsoft.com/office/drawing/2014/chart" uri="{C3380CC4-5D6E-409C-BE32-E72D297353CC}">
                <c16:uniqueId val="{00000031-5261-47C0-A4C7-F51ADE6287D7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32-5261-47C0-A4C7-F51ADE6287D7}"/>
              </c:ext>
            </c:extLst>
          </c:dPt>
          <c:dPt>
            <c:idx val="12"/>
            <c:bubble3D val="0"/>
            <c:extLst>
              <c:ext xmlns:c16="http://schemas.microsoft.com/office/drawing/2014/chart" uri="{C3380CC4-5D6E-409C-BE32-E72D297353CC}">
                <c16:uniqueId val="{00000033-5261-47C0-A4C7-F51ADE6287D7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34-5261-47C0-A4C7-F51ADE6287D7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35-5261-47C0-A4C7-F51ADE6287D7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36-5261-47C0-A4C7-F51ADE6287D7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37-5261-47C0-A4C7-F51ADE6287D7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38-5261-47C0-A4C7-F51ADE6287D7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39-5261-47C0-A4C7-F51ADE6287D7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2!$I$7:$I$25</c:f>
                <c:numCache>
                  <c:formatCode>General</c:formatCode>
                  <c:ptCount val="19"/>
                  <c:pt idx="0">
                    <c:v>0</c:v>
                  </c:pt>
                  <c:pt idx="1">
                    <c:v>3</c:v>
                  </c:pt>
                  <c:pt idx="2">
                    <c:v>0</c:v>
                  </c:pt>
                  <c:pt idx="3">
                    <c:v>3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3</c:v>
                  </c:pt>
                  <c:pt idx="10">
                    <c:v>0</c:v>
                  </c:pt>
                  <c:pt idx="11">
                    <c:v>3</c:v>
                  </c:pt>
                  <c:pt idx="12">
                    <c:v>0</c:v>
                  </c:pt>
                  <c:pt idx="13">
                    <c:v>3</c:v>
                  </c:pt>
                  <c:pt idx="14">
                    <c:v>0</c:v>
                  </c:pt>
                  <c:pt idx="15">
                    <c:v>3</c:v>
                  </c:pt>
                  <c:pt idx="16">
                    <c:v>0</c:v>
                  </c:pt>
                  <c:pt idx="17">
                    <c:v>3</c:v>
                  </c:pt>
                  <c:pt idx="18">
                    <c:v>0</c:v>
                  </c:pt>
                </c:numCache>
              </c:numRef>
            </c:plus>
          </c:errBars>
          <c:xVal>
            <c:numRef>
              <c:f>Kaplan2!$G$7:$G$25</c:f>
              <c:numCache>
                <c:formatCode>0.000</c:formatCode>
                <c:ptCount val="19"/>
                <c:pt idx="0">
                  <c:v>0</c:v>
                </c:pt>
                <c:pt idx="1">
                  <c:v>5.6071428571428568</c:v>
                </c:pt>
                <c:pt idx="2">
                  <c:v>5.6071428571428568</c:v>
                </c:pt>
                <c:pt idx="3">
                  <c:v>7.1071428571428568</c:v>
                </c:pt>
                <c:pt idx="4">
                  <c:v>7.1071428571428568</c:v>
                </c:pt>
                <c:pt idx="5">
                  <c:v>8.1785714285714288</c:v>
                </c:pt>
                <c:pt idx="6">
                  <c:v>8.1785714285714288</c:v>
                </c:pt>
                <c:pt idx="7">
                  <c:v>10.964285714285714</c:v>
                </c:pt>
                <c:pt idx="8">
                  <c:v>10.964285714285714</c:v>
                </c:pt>
                <c:pt idx="9">
                  <c:v>14.142857142857142</c:v>
                </c:pt>
                <c:pt idx="10">
                  <c:v>14.142857142857142</c:v>
                </c:pt>
                <c:pt idx="11">
                  <c:v>18.214285714285715</c:v>
                </c:pt>
                <c:pt idx="12">
                  <c:v>18.214285714285715</c:v>
                </c:pt>
                <c:pt idx="13">
                  <c:v>24.107142857142858</c:v>
                </c:pt>
                <c:pt idx="14">
                  <c:v>24.107142857142858</c:v>
                </c:pt>
                <c:pt idx="15">
                  <c:v>26.642857142857142</c:v>
                </c:pt>
                <c:pt idx="16">
                  <c:v>26.642857142857142</c:v>
                </c:pt>
                <c:pt idx="17">
                  <c:v>31.642857142857142</c:v>
                </c:pt>
                <c:pt idx="18">
                  <c:v>31.642857142857142</c:v>
                </c:pt>
              </c:numCache>
            </c:numRef>
          </c:xVal>
          <c:yVal>
            <c:numRef>
              <c:f>Kaplan2!$H$7:$H$25</c:f>
              <c:numCache>
                <c:formatCode>0.000</c:formatCode>
                <c:ptCount val="19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83.333333333333343</c:v>
                </c:pt>
                <c:pt idx="9">
                  <c:v>83.333333333333343</c:v>
                </c:pt>
                <c:pt idx="10">
                  <c:v>83.333333333333343</c:v>
                </c:pt>
                <c:pt idx="11">
                  <c:v>83.333333333333343</c:v>
                </c:pt>
                <c:pt idx="12">
                  <c:v>83.333333333333343</c:v>
                </c:pt>
                <c:pt idx="13">
                  <c:v>83.333333333333343</c:v>
                </c:pt>
                <c:pt idx="14">
                  <c:v>83.333333333333343</c:v>
                </c:pt>
                <c:pt idx="15">
                  <c:v>83.333333333333343</c:v>
                </c:pt>
                <c:pt idx="16">
                  <c:v>83.333333333333343</c:v>
                </c:pt>
                <c:pt idx="17">
                  <c:v>83.333333333333343</c:v>
                </c:pt>
                <c:pt idx="18">
                  <c:v>83.3333333333333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3A-5261-47C0-A4C7-F51ADE6287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7737856"/>
        <c:axId val="1817736608"/>
      </c:scatterChart>
      <c:valAx>
        <c:axId val="1817737856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1817736608"/>
        <c:crosses val="autoZero"/>
        <c:crossBetween val="midCat"/>
      </c:valAx>
      <c:valAx>
        <c:axId val="1817736608"/>
        <c:scaling>
          <c:orientation val="minMax"/>
          <c:max val="10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1817737856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2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2830679765175002E-2"/>
          <c:y val="2.5904340058883375E-2"/>
          <c:w val="0.8834096563941779"/>
          <c:h val="0.86048402381496847"/>
        </c:manualLayout>
      </c:layout>
      <c:scatterChart>
        <c:scatterStyle val="lineMarker"/>
        <c:varyColors val="0"/>
        <c:ser>
          <c:idx val="0"/>
          <c:order val="0"/>
          <c:tx>
            <c:v>0</c:v>
          </c:tx>
          <c:spPr>
            <a:ln w="38100">
              <a:solidFill>
                <a:schemeClr val="accent1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C52C-4CA7-8D37-857E14B29CF6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C52C-4CA7-8D37-857E14B29CF6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2-C52C-4CA7-8D37-857E14B29CF6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03-C52C-4CA7-8D37-857E14B29CF6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04-C52C-4CA7-8D37-857E14B29CF6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05-C52C-4CA7-8D37-857E14B29CF6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06-C52C-4CA7-8D37-857E14B29CF6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07-C52C-4CA7-8D37-857E14B29CF6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08-C52C-4CA7-8D37-857E14B29CF6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09-C52C-4CA7-8D37-857E14B29CF6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0A-C52C-4CA7-8D37-857E14B29CF6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0B-C52C-4CA7-8D37-857E14B29CF6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0C-C52C-4CA7-8D37-857E14B29CF6}"/>
              </c:ext>
            </c:extLst>
          </c:dPt>
          <c:dPt>
            <c:idx val="21"/>
            <c:bubble3D val="0"/>
            <c:extLst>
              <c:ext xmlns:c16="http://schemas.microsoft.com/office/drawing/2014/chart" uri="{C3380CC4-5D6E-409C-BE32-E72D297353CC}">
                <c16:uniqueId val="{0000000D-C52C-4CA7-8D37-857E14B29CF6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0E-C52C-4CA7-8D37-857E14B29CF6}"/>
              </c:ext>
            </c:extLst>
          </c:dPt>
          <c:dPt>
            <c:idx val="23"/>
            <c:bubble3D val="0"/>
            <c:extLst>
              <c:ext xmlns:c16="http://schemas.microsoft.com/office/drawing/2014/chart" uri="{C3380CC4-5D6E-409C-BE32-E72D297353CC}">
                <c16:uniqueId val="{0000000F-C52C-4CA7-8D37-857E14B29CF6}"/>
              </c:ext>
            </c:extLst>
          </c:dPt>
          <c:dPt>
            <c:idx val="24"/>
            <c:bubble3D val="0"/>
            <c:extLst>
              <c:ext xmlns:c16="http://schemas.microsoft.com/office/drawing/2014/chart" uri="{C3380CC4-5D6E-409C-BE32-E72D297353CC}">
                <c16:uniqueId val="{00000010-C52C-4CA7-8D37-857E14B29CF6}"/>
              </c:ext>
            </c:extLst>
          </c:dPt>
          <c:dPt>
            <c:idx val="25"/>
            <c:bubble3D val="0"/>
            <c:extLst>
              <c:ext xmlns:c16="http://schemas.microsoft.com/office/drawing/2014/chart" uri="{C3380CC4-5D6E-409C-BE32-E72D297353CC}">
                <c16:uniqueId val="{00000011-C52C-4CA7-8D37-857E14B29CF6}"/>
              </c:ext>
            </c:extLst>
          </c:dPt>
          <c:dPt>
            <c:idx val="26"/>
            <c:bubble3D val="0"/>
            <c:extLst>
              <c:ext xmlns:c16="http://schemas.microsoft.com/office/drawing/2014/chart" uri="{C3380CC4-5D6E-409C-BE32-E72D297353CC}">
                <c16:uniqueId val="{00000012-C52C-4CA7-8D37-857E14B29CF6}"/>
              </c:ext>
            </c:extLst>
          </c:dPt>
          <c:dPt>
            <c:idx val="27"/>
            <c:bubble3D val="0"/>
            <c:extLst>
              <c:ext xmlns:c16="http://schemas.microsoft.com/office/drawing/2014/chart" uri="{C3380CC4-5D6E-409C-BE32-E72D297353CC}">
                <c16:uniqueId val="{00000013-C52C-4CA7-8D37-857E14B29CF6}"/>
              </c:ext>
            </c:extLst>
          </c:dPt>
          <c:dPt>
            <c:idx val="28"/>
            <c:bubble3D val="0"/>
            <c:extLst>
              <c:ext xmlns:c16="http://schemas.microsoft.com/office/drawing/2014/chart" uri="{C3380CC4-5D6E-409C-BE32-E72D297353CC}">
                <c16:uniqueId val="{00000014-C52C-4CA7-8D37-857E14B29CF6}"/>
              </c:ext>
            </c:extLst>
          </c:dPt>
          <c:dPt>
            <c:idx val="29"/>
            <c:bubble3D val="0"/>
            <c:extLst>
              <c:ext xmlns:c16="http://schemas.microsoft.com/office/drawing/2014/chart" uri="{C3380CC4-5D6E-409C-BE32-E72D297353CC}">
                <c16:uniqueId val="{00000015-C52C-4CA7-8D37-857E14B29CF6}"/>
              </c:ext>
            </c:extLst>
          </c:dPt>
          <c:dPt>
            <c:idx val="30"/>
            <c:bubble3D val="0"/>
            <c:extLst>
              <c:ext xmlns:c16="http://schemas.microsoft.com/office/drawing/2014/chart" uri="{C3380CC4-5D6E-409C-BE32-E72D297353CC}">
                <c16:uniqueId val="{00000016-C52C-4CA7-8D37-857E14B29CF6}"/>
              </c:ext>
            </c:extLst>
          </c:dPt>
          <c:dPt>
            <c:idx val="31"/>
            <c:bubble3D val="0"/>
            <c:extLst>
              <c:ext xmlns:c16="http://schemas.microsoft.com/office/drawing/2014/chart" uri="{C3380CC4-5D6E-409C-BE32-E72D297353CC}">
                <c16:uniqueId val="{00000017-C52C-4CA7-8D37-857E14B29CF6}"/>
              </c:ext>
            </c:extLst>
          </c:dPt>
          <c:dPt>
            <c:idx val="32"/>
            <c:bubble3D val="0"/>
            <c:extLst>
              <c:ext xmlns:c16="http://schemas.microsoft.com/office/drawing/2014/chart" uri="{C3380CC4-5D6E-409C-BE32-E72D297353CC}">
                <c16:uniqueId val="{00000018-C52C-4CA7-8D37-857E14B29CF6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1!$I$7:$I$39</c:f>
                <c:numCache>
                  <c:formatCode>General</c:formatCode>
                  <c:ptCount val="3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3</c:v>
                  </c:pt>
                  <c:pt idx="14">
                    <c:v>0</c:v>
                  </c:pt>
                  <c:pt idx="15">
                    <c:v>3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3</c:v>
                  </c:pt>
                  <c:pt idx="22">
                    <c:v>0</c:v>
                  </c:pt>
                  <c:pt idx="23">
                    <c:v>3</c:v>
                  </c:pt>
                  <c:pt idx="24">
                    <c:v>0</c:v>
                  </c:pt>
                  <c:pt idx="25">
                    <c:v>3</c:v>
                  </c:pt>
                  <c:pt idx="26">
                    <c:v>0</c:v>
                  </c:pt>
                  <c:pt idx="27">
                    <c:v>3</c:v>
                  </c:pt>
                  <c:pt idx="28">
                    <c:v>0</c:v>
                  </c:pt>
                  <c:pt idx="29">
                    <c:v>3</c:v>
                  </c:pt>
                  <c:pt idx="30">
                    <c:v>0</c:v>
                  </c:pt>
                  <c:pt idx="31">
                    <c:v>3</c:v>
                  </c:pt>
                  <c:pt idx="32">
                    <c:v>0</c:v>
                  </c:pt>
                </c:numCache>
              </c:numRef>
            </c:plus>
          </c:errBars>
          <c:xVal>
            <c:numRef>
              <c:f>Kaplan1!$G$7:$G$39</c:f>
              <c:numCache>
                <c:formatCode>0.000</c:formatCode>
                <c:ptCount val="33"/>
                <c:pt idx="0">
                  <c:v>0</c:v>
                </c:pt>
                <c:pt idx="1">
                  <c:v>0.8928571428571429</c:v>
                </c:pt>
                <c:pt idx="2">
                  <c:v>0.8928571428571429</c:v>
                </c:pt>
                <c:pt idx="3">
                  <c:v>1.9642857142857142</c:v>
                </c:pt>
                <c:pt idx="4">
                  <c:v>1.9642857142857142</c:v>
                </c:pt>
                <c:pt idx="5">
                  <c:v>3.0714285714285716</c:v>
                </c:pt>
                <c:pt idx="6">
                  <c:v>3.0714285714285716</c:v>
                </c:pt>
                <c:pt idx="7">
                  <c:v>3.6071428571428572</c:v>
                </c:pt>
                <c:pt idx="8">
                  <c:v>3.6071428571428572</c:v>
                </c:pt>
                <c:pt idx="9">
                  <c:v>6.3214285714285712</c:v>
                </c:pt>
                <c:pt idx="10">
                  <c:v>6.3214285714285712</c:v>
                </c:pt>
                <c:pt idx="11">
                  <c:v>10.607142857142858</c:v>
                </c:pt>
                <c:pt idx="12">
                  <c:v>10.607142857142858</c:v>
                </c:pt>
                <c:pt idx="13">
                  <c:v>13.785714285714286</c:v>
                </c:pt>
                <c:pt idx="14">
                  <c:v>13.785714285714286</c:v>
                </c:pt>
                <c:pt idx="15">
                  <c:v>14.285714285714286</c:v>
                </c:pt>
                <c:pt idx="16">
                  <c:v>14.285714285714286</c:v>
                </c:pt>
                <c:pt idx="17">
                  <c:v>15.5</c:v>
                </c:pt>
                <c:pt idx="18">
                  <c:v>15.5</c:v>
                </c:pt>
                <c:pt idx="19">
                  <c:v>15.535714285714286</c:v>
                </c:pt>
                <c:pt idx="20">
                  <c:v>15.535714285714286</c:v>
                </c:pt>
                <c:pt idx="21">
                  <c:v>17</c:v>
                </c:pt>
                <c:pt idx="22">
                  <c:v>17</c:v>
                </c:pt>
                <c:pt idx="23">
                  <c:v>21.571428571428573</c:v>
                </c:pt>
                <c:pt idx="24">
                  <c:v>21.571428571428573</c:v>
                </c:pt>
                <c:pt idx="25">
                  <c:v>24.75</c:v>
                </c:pt>
                <c:pt idx="26">
                  <c:v>24.75</c:v>
                </c:pt>
                <c:pt idx="27">
                  <c:v>25.607142857142858</c:v>
                </c:pt>
                <c:pt idx="28">
                  <c:v>25.607142857142858</c:v>
                </c:pt>
                <c:pt idx="29">
                  <c:v>26</c:v>
                </c:pt>
                <c:pt idx="30">
                  <c:v>26</c:v>
                </c:pt>
                <c:pt idx="31">
                  <c:v>26.428571428571427</c:v>
                </c:pt>
                <c:pt idx="32">
                  <c:v>26.428571428571427</c:v>
                </c:pt>
              </c:numCache>
            </c:numRef>
          </c:xVal>
          <c:yVal>
            <c:numRef>
              <c:f>Kaplan1!$H$7:$H$39</c:f>
              <c:numCache>
                <c:formatCode>0.000</c:formatCode>
                <c:ptCount val="33"/>
                <c:pt idx="0">
                  <c:v>100</c:v>
                </c:pt>
                <c:pt idx="1">
                  <c:v>100</c:v>
                </c:pt>
                <c:pt idx="2">
                  <c:v>93.75</c:v>
                </c:pt>
                <c:pt idx="3">
                  <c:v>93.75</c:v>
                </c:pt>
                <c:pt idx="4">
                  <c:v>87.5</c:v>
                </c:pt>
                <c:pt idx="5">
                  <c:v>87.5</c:v>
                </c:pt>
                <c:pt idx="6">
                  <c:v>81.25</c:v>
                </c:pt>
                <c:pt idx="7">
                  <c:v>81.25</c:v>
                </c:pt>
                <c:pt idx="8">
                  <c:v>75</c:v>
                </c:pt>
                <c:pt idx="9">
                  <c:v>75</c:v>
                </c:pt>
                <c:pt idx="10">
                  <c:v>68.75</c:v>
                </c:pt>
                <c:pt idx="11">
                  <c:v>68.75</c:v>
                </c:pt>
                <c:pt idx="12">
                  <c:v>62.5</c:v>
                </c:pt>
                <c:pt idx="13">
                  <c:v>62.5</c:v>
                </c:pt>
                <c:pt idx="14">
                  <c:v>62.5</c:v>
                </c:pt>
                <c:pt idx="15">
                  <c:v>62.5</c:v>
                </c:pt>
                <c:pt idx="16">
                  <c:v>62.5</c:v>
                </c:pt>
                <c:pt idx="17">
                  <c:v>62.5</c:v>
                </c:pt>
                <c:pt idx="18">
                  <c:v>54.6875</c:v>
                </c:pt>
                <c:pt idx="19">
                  <c:v>54.6875</c:v>
                </c:pt>
                <c:pt idx="20">
                  <c:v>46.875</c:v>
                </c:pt>
                <c:pt idx="21">
                  <c:v>46.875</c:v>
                </c:pt>
                <c:pt idx="22">
                  <c:v>46.875</c:v>
                </c:pt>
                <c:pt idx="23">
                  <c:v>46.875</c:v>
                </c:pt>
                <c:pt idx="24">
                  <c:v>46.875</c:v>
                </c:pt>
                <c:pt idx="25">
                  <c:v>46.875</c:v>
                </c:pt>
                <c:pt idx="26">
                  <c:v>46.875</c:v>
                </c:pt>
                <c:pt idx="27">
                  <c:v>46.875</c:v>
                </c:pt>
                <c:pt idx="28">
                  <c:v>46.875</c:v>
                </c:pt>
                <c:pt idx="29">
                  <c:v>46.875</c:v>
                </c:pt>
                <c:pt idx="30">
                  <c:v>46.875</c:v>
                </c:pt>
                <c:pt idx="31">
                  <c:v>46.875</c:v>
                </c:pt>
                <c:pt idx="32">
                  <c:v>46.8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C52C-4CA7-8D37-857E14B29CF6}"/>
            </c:ext>
          </c:extLst>
        </c:ser>
        <c:ser>
          <c:idx val="1"/>
          <c:order val="1"/>
          <c:tx>
            <c:v>1</c:v>
          </c:tx>
          <c:spPr>
            <a:ln w="38100">
              <a:solidFill>
                <a:schemeClr val="accent2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1A-C52C-4CA7-8D37-857E14B29CF6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1B-C52C-4CA7-8D37-857E14B29CF6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1C-C52C-4CA7-8D37-857E14B29CF6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1D-C52C-4CA7-8D37-857E14B29CF6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1E-C52C-4CA7-8D37-857E14B29CF6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1F-C52C-4CA7-8D37-857E14B29CF6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20-C52C-4CA7-8D37-857E14B29CF6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21-C52C-4CA7-8D37-857E14B29CF6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22-C52C-4CA7-8D37-857E14B29CF6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23-C52C-4CA7-8D37-857E14B29CF6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24-C52C-4CA7-8D37-857E14B29CF6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25-C52C-4CA7-8D37-857E14B29CF6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26-C52C-4CA7-8D37-857E14B29CF6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27-C52C-4CA7-8D37-857E14B29CF6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28-C52C-4CA7-8D37-857E14B29CF6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2!$I$7:$I$25</c:f>
                <c:numCache>
                  <c:formatCode>General</c:formatCode>
                  <c:ptCount val="19"/>
                  <c:pt idx="0">
                    <c:v>0</c:v>
                  </c:pt>
                  <c:pt idx="1">
                    <c:v>3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  <c:pt idx="7">
                    <c:v>3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3</c:v>
                  </c:pt>
                  <c:pt idx="16">
                    <c:v>0</c:v>
                  </c:pt>
                  <c:pt idx="17">
                    <c:v>3</c:v>
                  </c:pt>
                  <c:pt idx="18">
                    <c:v>0</c:v>
                  </c:pt>
                </c:numCache>
              </c:numRef>
            </c:plus>
          </c:errBars>
          <c:xVal>
            <c:numRef>
              <c:f>Kaplan2!$G$7:$G$25</c:f>
              <c:numCache>
                <c:formatCode>0.000</c:formatCode>
                <c:ptCount val="19"/>
                <c:pt idx="0">
                  <c:v>0</c:v>
                </c:pt>
                <c:pt idx="1">
                  <c:v>5.6071428571428568</c:v>
                </c:pt>
                <c:pt idx="2">
                  <c:v>5.6071428571428568</c:v>
                </c:pt>
                <c:pt idx="3">
                  <c:v>6</c:v>
                </c:pt>
                <c:pt idx="4">
                  <c:v>6</c:v>
                </c:pt>
                <c:pt idx="5">
                  <c:v>7.1071428571428568</c:v>
                </c:pt>
                <c:pt idx="6">
                  <c:v>7.1071428571428568</c:v>
                </c:pt>
                <c:pt idx="7">
                  <c:v>8.1785714285714288</c:v>
                </c:pt>
                <c:pt idx="8">
                  <c:v>8.1785714285714288</c:v>
                </c:pt>
                <c:pt idx="9">
                  <c:v>8.4642857142857135</c:v>
                </c:pt>
                <c:pt idx="10">
                  <c:v>8.4642857142857135</c:v>
                </c:pt>
                <c:pt idx="11">
                  <c:v>10.928571428571429</c:v>
                </c:pt>
                <c:pt idx="12">
                  <c:v>10.928571428571429</c:v>
                </c:pt>
                <c:pt idx="13">
                  <c:v>15.321428571428571</c:v>
                </c:pt>
                <c:pt idx="14">
                  <c:v>15.321428571428571</c:v>
                </c:pt>
                <c:pt idx="15">
                  <c:v>24.107142857142858</c:v>
                </c:pt>
                <c:pt idx="16">
                  <c:v>24.107142857142858</c:v>
                </c:pt>
                <c:pt idx="17">
                  <c:v>31.642857142857142</c:v>
                </c:pt>
                <c:pt idx="18">
                  <c:v>31.642857142857142</c:v>
                </c:pt>
              </c:numCache>
            </c:numRef>
          </c:xVal>
          <c:yVal>
            <c:numRef>
              <c:f>Kaplan2!$H$7:$H$25</c:f>
              <c:numCache>
                <c:formatCode>0.000</c:formatCode>
                <c:ptCount val="19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87.5</c:v>
                </c:pt>
                <c:pt idx="5">
                  <c:v>87.5</c:v>
                </c:pt>
                <c:pt idx="6">
                  <c:v>87.5</c:v>
                </c:pt>
                <c:pt idx="7">
                  <c:v>87.5</c:v>
                </c:pt>
                <c:pt idx="8">
                  <c:v>87.5</c:v>
                </c:pt>
                <c:pt idx="9">
                  <c:v>87.5</c:v>
                </c:pt>
                <c:pt idx="10">
                  <c:v>70</c:v>
                </c:pt>
                <c:pt idx="11">
                  <c:v>70</c:v>
                </c:pt>
                <c:pt idx="12">
                  <c:v>52.5</c:v>
                </c:pt>
                <c:pt idx="13">
                  <c:v>52.5</c:v>
                </c:pt>
                <c:pt idx="14">
                  <c:v>35</c:v>
                </c:pt>
                <c:pt idx="15">
                  <c:v>35</c:v>
                </c:pt>
                <c:pt idx="16">
                  <c:v>35</c:v>
                </c:pt>
                <c:pt idx="17">
                  <c:v>35</c:v>
                </c:pt>
                <c:pt idx="18">
                  <c:v>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C52C-4CA7-8D37-857E14B29C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2515696"/>
        <c:axId val="802514448"/>
      </c:scatterChart>
      <c:valAx>
        <c:axId val="802515696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802514448"/>
        <c:crosses val="autoZero"/>
        <c:crossBetween val="midCat"/>
      </c:valAx>
      <c:valAx>
        <c:axId val="802514448"/>
        <c:scaling>
          <c:orientation val="minMax"/>
          <c:max val="10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802515696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2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3534924"/>
            <a:ext cx="12240181" cy="7519835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11344752"/>
            <a:ext cx="10800160" cy="5214884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0904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0380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1149975"/>
            <a:ext cx="3105046" cy="1830459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1149975"/>
            <a:ext cx="9135135" cy="1830459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8838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8755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5384888"/>
            <a:ext cx="12420184" cy="8984801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14454688"/>
            <a:ext cx="12420184" cy="4724895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9985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5749874"/>
            <a:ext cx="6120091" cy="1370470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5749874"/>
            <a:ext cx="6120091" cy="1370470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818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149979"/>
            <a:ext cx="12420184" cy="417491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5294885"/>
            <a:ext cx="6091964" cy="259494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7889827"/>
            <a:ext cx="6091964" cy="1160474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5294885"/>
            <a:ext cx="6121966" cy="259494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7889827"/>
            <a:ext cx="6121966" cy="1160474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5914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809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958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439968"/>
            <a:ext cx="4644444" cy="5039889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3109937"/>
            <a:ext cx="7290108" cy="15349662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6479857"/>
            <a:ext cx="4644444" cy="12004738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194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439968"/>
            <a:ext cx="4644444" cy="5039889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3109937"/>
            <a:ext cx="7290108" cy="15349662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6479857"/>
            <a:ext cx="4644444" cy="12004738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0717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1149979"/>
            <a:ext cx="12420184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5749874"/>
            <a:ext cx="12420184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20019564"/>
            <a:ext cx="3240048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871D2-27F0-4837-922D-2DC179CBD8D1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20019564"/>
            <a:ext cx="4860072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20019564"/>
            <a:ext cx="3240048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03700-B452-41F4-A927-4FA1609563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781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kumimoji="1"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kumimoji="1"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F8819F86-1CBA-4FFB-8B55-6973D43E9070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684740821"/>
              </p:ext>
            </p:extLst>
          </p:nvPr>
        </p:nvGraphicFramePr>
        <p:xfrm>
          <a:off x="1576105" y="411742"/>
          <a:ext cx="5480016" cy="35801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4901D5D-7ADB-4A36-A7DD-53C81D57D65C}"/>
              </a:ext>
            </a:extLst>
          </p:cNvPr>
          <p:cNvSpPr txBox="1"/>
          <p:nvPr/>
        </p:nvSpPr>
        <p:spPr>
          <a:xfrm rot="16200000">
            <a:off x="-572703" y="1850889"/>
            <a:ext cx="34778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/>
              <a:t>Progression free survival (%)</a:t>
            </a:r>
            <a:endParaRPr kumimoji="1" lang="ja-JP" altLang="en-US" sz="20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B61AFBC-D7A6-4972-8BC9-4758F9560DE7}"/>
              </a:ext>
            </a:extLst>
          </p:cNvPr>
          <p:cNvSpPr txBox="1"/>
          <p:nvPr/>
        </p:nvSpPr>
        <p:spPr>
          <a:xfrm>
            <a:off x="3302922" y="136038"/>
            <a:ext cx="2047274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/>
              <a:t>Pneumonitis</a:t>
            </a:r>
            <a:endParaRPr kumimoji="1" lang="ja-JP" altLang="en-US" sz="2000" b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C95C5EF-1BD2-460B-AB15-B3CE8BE67211}"/>
              </a:ext>
            </a:extLst>
          </p:cNvPr>
          <p:cNvSpPr txBox="1"/>
          <p:nvPr/>
        </p:nvSpPr>
        <p:spPr>
          <a:xfrm>
            <a:off x="1855246" y="418019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543ACC0-0E8C-49E9-91BA-99BCA322FD89}"/>
              </a:ext>
            </a:extLst>
          </p:cNvPr>
          <p:cNvSpPr txBox="1"/>
          <p:nvPr/>
        </p:nvSpPr>
        <p:spPr>
          <a:xfrm>
            <a:off x="2547733" y="418019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51FC492-D6F3-443D-97A5-FAD42D6C8DD0}"/>
              </a:ext>
            </a:extLst>
          </p:cNvPr>
          <p:cNvSpPr txBox="1"/>
          <p:nvPr/>
        </p:nvSpPr>
        <p:spPr>
          <a:xfrm>
            <a:off x="3242435" y="418108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2E5188A-1ACA-4498-86AD-2C6FAA852848}"/>
              </a:ext>
            </a:extLst>
          </p:cNvPr>
          <p:cNvSpPr txBox="1"/>
          <p:nvPr/>
        </p:nvSpPr>
        <p:spPr>
          <a:xfrm>
            <a:off x="3880334" y="418108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5E8F01D-610B-4A5B-BD4A-689AFCADA754}"/>
              </a:ext>
            </a:extLst>
          </p:cNvPr>
          <p:cNvSpPr txBox="1"/>
          <p:nvPr/>
        </p:nvSpPr>
        <p:spPr>
          <a:xfrm>
            <a:off x="4569261" y="418019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DD0559F-9CDF-499D-830D-57ED1C95DFA5}"/>
              </a:ext>
            </a:extLst>
          </p:cNvPr>
          <p:cNvSpPr txBox="1"/>
          <p:nvPr/>
        </p:nvSpPr>
        <p:spPr>
          <a:xfrm>
            <a:off x="5256698" y="418108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71F93B5-B170-4023-B427-D13BE02464BE}"/>
              </a:ext>
            </a:extLst>
          </p:cNvPr>
          <p:cNvSpPr txBox="1"/>
          <p:nvPr/>
        </p:nvSpPr>
        <p:spPr>
          <a:xfrm>
            <a:off x="5913706" y="418019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9C649BA-DFB9-40AF-8909-6F2A3EA67FBF}"/>
              </a:ext>
            </a:extLst>
          </p:cNvPr>
          <p:cNvSpPr txBox="1"/>
          <p:nvPr/>
        </p:nvSpPr>
        <p:spPr>
          <a:xfrm>
            <a:off x="6601305" y="4180197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B45A1D4-6F76-4266-8845-65F5C43889EA}"/>
              </a:ext>
            </a:extLst>
          </p:cNvPr>
          <p:cNvSpPr txBox="1"/>
          <p:nvPr/>
        </p:nvSpPr>
        <p:spPr>
          <a:xfrm>
            <a:off x="1855246" y="452216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8</a:t>
            </a:r>
            <a:endParaRPr kumimoji="1" lang="ja-JP" altLang="en-US" sz="14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7D5E57B-9197-41D3-BB59-F295EC26BD10}"/>
              </a:ext>
            </a:extLst>
          </p:cNvPr>
          <p:cNvSpPr txBox="1"/>
          <p:nvPr/>
        </p:nvSpPr>
        <p:spPr>
          <a:xfrm>
            <a:off x="2547733" y="452216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1</a:t>
            </a:r>
            <a:endParaRPr kumimoji="1" lang="ja-JP" altLang="en-US" sz="14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44D5B5B-E668-48DC-A033-AD9C668CF2E3}"/>
              </a:ext>
            </a:extLst>
          </p:cNvPr>
          <p:cNvSpPr txBox="1"/>
          <p:nvPr/>
        </p:nvSpPr>
        <p:spPr>
          <a:xfrm>
            <a:off x="3242435" y="4523052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0</a:t>
            </a:r>
            <a:endParaRPr kumimoji="1" lang="ja-JP" altLang="en-US" sz="14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CECA6C2-BADC-4D26-9ECC-77570F13044E}"/>
              </a:ext>
            </a:extLst>
          </p:cNvPr>
          <p:cNvSpPr txBox="1"/>
          <p:nvPr/>
        </p:nvSpPr>
        <p:spPr>
          <a:xfrm>
            <a:off x="3880334" y="452305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8</a:t>
            </a:r>
            <a:endParaRPr kumimoji="1" lang="ja-JP" altLang="en-US" sz="14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D7C79FA-33F8-4B2F-A268-88F2C27BF276}"/>
              </a:ext>
            </a:extLst>
          </p:cNvPr>
          <p:cNvSpPr txBox="1"/>
          <p:nvPr/>
        </p:nvSpPr>
        <p:spPr>
          <a:xfrm>
            <a:off x="4569261" y="452216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5</a:t>
            </a:r>
            <a:endParaRPr kumimoji="1" lang="ja-JP" altLang="en-US" sz="14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BEDD939-B5ED-4738-AE3F-DCEC6131C427}"/>
              </a:ext>
            </a:extLst>
          </p:cNvPr>
          <p:cNvSpPr txBox="1"/>
          <p:nvPr/>
        </p:nvSpPr>
        <p:spPr>
          <a:xfrm>
            <a:off x="5256698" y="452305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859706A-7447-47AE-AA05-148425D832CF}"/>
              </a:ext>
            </a:extLst>
          </p:cNvPr>
          <p:cNvSpPr txBox="1"/>
          <p:nvPr/>
        </p:nvSpPr>
        <p:spPr>
          <a:xfrm>
            <a:off x="5913706" y="452216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13EF907-67AD-4E51-AF5C-C22D6D1ADBEB}"/>
              </a:ext>
            </a:extLst>
          </p:cNvPr>
          <p:cNvSpPr txBox="1"/>
          <p:nvPr/>
        </p:nvSpPr>
        <p:spPr>
          <a:xfrm>
            <a:off x="6601305" y="4522167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23" name="テキスト ボックス 1">
            <a:extLst>
              <a:ext uri="{FF2B5EF4-FFF2-40B4-BE49-F238E27FC236}">
                <a16:creationId xmlns:a16="http://schemas.microsoft.com/office/drawing/2014/main" id="{2F80A6BF-880E-42AE-B051-B240336FF559}"/>
              </a:ext>
            </a:extLst>
          </p:cNvPr>
          <p:cNvSpPr txBox="1"/>
          <p:nvPr/>
        </p:nvSpPr>
        <p:spPr>
          <a:xfrm>
            <a:off x="4110130" y="1186212"/>
            <a:ext cx="3233964" cy="2918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No readministration of anti-PD-1 (n=18)</a:t>
            </a:r>
          </a:p>
        </p:txBody>
      </p:sp>
      <p:sp>
        <p:nvSpPr>
          <p:cNvPr id="24" name="テキスト ボックス 1">
            <a:extLst>
              <a:ext uri="{FF2B5EF4-FFF2-40B4-BE49-F238E27FC236}">
                <a16:creationId xmlns:a16="http://schemas.microsoft.com/office/drawing/2014/main" id="{7B2EA147-DE45-4081-8F7C-693271890590}"/>
              </a:ext>
            </a:extLst>
          </p:cNvPr>
          <p:cNvSpPr txBox="1"/>
          <p:nvPr/>
        </p:nvSpPr>
        <p:spPr>
          <a:xfrm>
            <a:off x="4114665" y="774478"/>
            <a:ext cx="3365492" cy="34089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 err="1"/>
              <a:t>Readministration</a:t>
            </a:r>
            <a:r>
              <a:rPr lang="en-US" altLang="ja-JP" sz="1400" dirty="0"/>
              <a:t> of anti-PD-1 (n=3)</a:t>
            </a: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057B4630-20E7-4ED9-90F8-3F288F076A07}"/>
              </a:ext>
            </a:extLst>
          </p:cNvPr>
          <p:cNvCxnSpPr>
            <a:cxnSpLocks/>
          </p:cNvCxnSpPr>
          <p:nvPr/>
        </p:nvCxnSpPr>
        <p:spPr>
          <a:xfrm>
            <a:off x="3601543" y="959921"/>
            <a:ext cx="501072" cy="0"/>
          </a:xfrm>
          <a:prstGeom prst="line">
            <a:avLst/>
          </a:prstGeom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A1C1A65C-84C3-4FA0-9FBA-C07D6D0DF825}"/>
              </a:ext>
            </a:extLst>
          </p:cNvPr>
          <p:cNvCxnSpPr>
            <a:cxnSpLocks/>
          </p:cNvCxnSpPr>
          <p:nvPr/>
        </p:nvCxnSpPr>
        <p:spPr>
          <a:xfrm>
            <a:off x="3601543" y="1331532"/>
            <a:ext cx="501072" cy="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AA61B80-1C1D-4236-BC89-6C14D1A17271}"/>
              </a:ext>
            </a:extLst>
          </p:cNvPr>
          <p:cNvSpPr txBox="1"/>
          <p:nvPr/>
        </p:nvSpPr>
        <p:spPr>
          <a:xfrm>
            <a:off x="701901" y="3838228"/>
            <a:ext cx="9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o. at risk</a:t>
            </a:r>
            <a:endParaRPr kumimoji="1" lang="ja-JP" altLang="en-US" sz="1400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A45FBA5-36B8-4DD3-BDC2-16230979E893}"/>
              </a:ext>
            </a:extLst>
          </p:cNvPr>
          <p:cNvSpPr txBox="1"/>
          <p:nvPr/>
        </p:nvSpPr>
        <p:spPr>
          <a:xfrm>
            <a:off x="327344" y="4169184"/>
            <a:ext cx="1619742" cy="2656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 err="1">
                <a:cs typeface="Arial" panose="020B0604020202020204" pitchFamily="34" charset="0"/>
              </a:rPr>
              <a:t>Readministration</a:t>
            </a:r>
            <a:endParaRPr lang="ja-JP" altLang="en-US" sz="1400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3D81423-5C45-4A52-BA3C-ABE79DBD2CC1}"/>
              </a:ext>
            </a:extLst>
          </p:cNvPr>
          <p:cNvSpPr txBox="1"/>
          <p:nvPr/>
        </p:nvSpPr>
        <p:spPr>
          <a:xfrm>
            <a:off x="15240" y="4511154"/>
            <a:ext cx="1931851" cy="28350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>
                <a:cs typeface="Arial" panose="020B0604020202020204" pitchFamily="34" charset="0"/>
              </a:rPr>
              <a:t>No readministration</a:t>
            </a:r>
            <a:endParaRPr lang="ja-JP" altLang="en-US" sz="14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546B7F4-2D68-48AD-91D3-C49FF089F951}"/>
              </a:ext>
            </a:extLst>
          </p:cNvPr>
          <p:cNvSpPr txBox="1"/>
          <p:nvPr/>
        </p:nvSpPr>
        <p:spPr>
          <a:xfrm>
            <a:off x="3896986" y="3896918"/>
            <a:ext cx="1181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(month)</a:t>
            </a:r>
            <a:endParaRPr kumimoji="1" lang="ja-JP" altLang="en-US" sz="14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4E3B8D8-3B28-43CE-9990-9638DC19A6D3}"/>
              </a:ext>
            </a:extLst>
          </p:cNvPr>
          <p:cNvSpPr txBox="1"/>
          <p:nvPr/>
        </p:nvSpPr>
        <p:spPr>
          <a:xfrm>
            <a:off x="2313466" y="3026835"/>
            <a:ext cx="1694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altLang="ja-JP" dirty="0">
                <a:solidFill>
                  <a:prstClr val="black"/>
                </a:solidFill>
                <a:ea typeface="游ゴシック" panose="020B0400000000000000" pitchFamily="50" charset="-128"/>
              </a:rPr>
              <a:t>Log-rank p=0.96</a:t>
            </a:r>
            <a:endParaRPr lang="ja-JP" altLang="en-US" dirty="0">
              <a:solidFill>
                <a:prstClr val="black"/>
              </a:solidFill>
              <a:ea typeface="游ゴシック" panose="020B0400000000000000" pitchFamily="50" charset="-128"/>
            </a:endParaRPr>
          </a:p>
        </p:txBody>
      </p:sp>
      <p:graphicFrame>
        <p:nvGraphicFramePr>
          <p:cNvPr id="32" name="グラフ 31">
            <a:extLst>
              <a:ext uri="{FF2B5EF4-FFF2-40B4-BE49-F238E27FC236}">
                <a16:creationId xmlns:a16="http://schemas.microsoft.com/office/drawing/2014/main" id="{9F9EF7E9-B4EF-41BD-9AFB-C5F865606BB9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930474620"/>
              </p:ext>
            </p:extLst>
          </p:nvPr>
        </p:nvGraphicFramePr>
        <p:xfrm>
          <a:off x="1576105" y="5331120"/>
          <a:ext cx="5480016" cy="35801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649980A-5EA2-4DEB-BCCD-BBDF949D6600}"/>
              </a:ext>
            </a:extLst>
          </p:cNvPr>
          <p:cNvSpPr txBox="1"/>
          <p:nvPr/>
        </p:nvSpPr>
        <p:spPr>
          <a:xfrm rot="16200000">
            <a:off x="-219401" y="6921135"/>
            <a:ext cx="28012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/>
              <a:t>Overall survival (%)</a:t>
            </a:r>
            <a:endParaRPr kumimoji="1" lang="ja-JP" altLang="en-US" sz="200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4E9C58A-E3A4-4136-BE04-1F682C5B37E3}"/>
              </a:ext>
            </a:extLst>
          </p:cNvPr>
          <p:cNvSpPr txBox="1"/>
          <p:nvPr/>
        </p:nvSpPr>
        <p:spPr>
          <a:xfrm>
            <a:off x="1937155" y="914900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B705800-0B9B-41AB-A327-8004E351F945}"/>
              </a:ext>
            </a:extLst>
          </p:cNvPr>
          <p:cNvSpPr txBox="1"/>
          <p:nvPr/>
        </p:nvSpPr>
        <p:spPr>
          <a:xfrm>
            <a:off x="2629642" y="914900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3C65B7A-E7DF-485F-99C7-DCE4A460D7C7}"/>
              </a:ext>
            </a:extLst>
          </p:cNvPr>
          <p:cNvSpPr txBox="1"/>
          <p:nvPr/>
        </p:nvSpPr>
        <p:spPr>
          <a:xfrm>
            <a:off x="3324344" y="914989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C83BCE1-9598-411A-A97D-98312D78FE41}"/>
              </a:ext>
            </a:extLst>
          </p:cNvPr>
          <p:cNvSpPr txBox="1"/>
          <p:nvPr/>
        </p:nvSpPr>
        <p:spPr>
          <a:xfrm>
            <a:off x="3962243" y="914989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CA98F31-3DAA-40BE-8B99-72A0634183E0}"/>
              </a:ext>
            </a:extLst>
          </p:cNvPr>
          <p:cNvSpPr txBox="1"/>
          <p:nvPr/>
        </p:nvSpPr>
        <p:spPr>
          <a:xfrm>
            <a:off x="4651170" y="914900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DFE2C7A-092B-48D2-B0DB-04FCD4748064}"/>
              </a:ext>
            </a:extLst>
          </p:cNvPr>
          <p:cNvSpPr txBox="1"/>
          <p:nvPr/>
        </p:nvSpPr>
        <p:spPr>
          <a:xfrm>
            <a:off x="5338607" y="914989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1BD324E-05E7-4467-8E94-69D3DBA460B1}"/>
              </a:ext>
            </a:extLst>
          </p:cNvPr>
          <p:cNvSpPr txBox="1"/>
          <p:nvPr/>
        </p:nvSpPr>
        <p:spPr>
          <a:xfrm>
            <a:off x="5995615" y="914900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DAE1B13-20F9-4C8D-9228-C1F6C2212885}"/>
              </a:ext>
            </a:extLst>
          </p:cNvPr>
          <p:cNvSpPr txBox="1"/>
          <p:nvPr/>
        </p:nvSpPr>
        <p:spPr>
          <a:xfrm>
            <a:off x="6683214" y="9149003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D8FEAAA-80C9-4342-9FEA-A1138ABA6766}"/>
              </a:ext>
            </a:extLst>
          </p:cNvPr>
          <p:cNvSpPr txBox="1"/>
          <p:nvPr/>
        </p:nvSpPr>
        <p:spPr>
          <a:xfrm>
            <a:off x="1937155" y="949097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3</a:t>
            </a:r>
            <a:endParaRPr kumimoji="1" lang="ja-JP" altLang="en-US" sz="1400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81F3BA9-75EE-410C-9A14-9E8D7D42898C}"/>
              </a:ext>
            </a:extLst>
          </p:cNvPr>
          <p:cNvSpPr txBox="1"/>
          <p:nvPr/>
        </p:nvSpPr>
        <p:spPr>
          <a:xfrm>
            <a:off x="2629642" y="949097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7</a:t>
            </a:r>
            <a:endParaRPr kumimoji="1" lang="ja-JP" altLang="en-US" sz="1400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939454E-841A-41F6-8533-3432AB050DA4}"/>
              </a:ext>
            </a:extLst>
          </p:cNvPr>
          <p:cNvSpPr txBox="1"/>
          <p:nvPr/>
        </p:nvSpPr>
        <p:spPr>
          <a:xfrm>
            <a:off x="3324344" y="949185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2</a:t>
            </a:r>
            <a:endParaRPr kumimoji="1" lang="ja-JP" altLang="en-US" sz="14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9FB971B-1BCB-4419-BA3B-4FA8A5F2AFFC}"/>
              </a:ext>
            </a:extLst>
          </p:cNvPr>
          <p:cNvSpPr txBox="1"/>
          <p:nvPr/>
        </p:nvSpPr>
        <p:spPr>
          <a:xfrm>
            <a:off x="3962243" y="949186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9</a:t>
            </a:r>
            <a:endParaRPr kumimoji="1" lang="ja-JP" altLang="en-US" sz="1400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23B31F0-7656-4EEA-B331-9FF5CB7A7F65}"/>
              </a:ext>
            </a:extLst>
          </p:cNvPr>
          <p:cNvSpPr txBox="1"/>
          <p:nvPr/>
        </p:nvSpPr>
        <p:spPr>
          <a:xfrm>
            <a:off x="4651170" y="949097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8</a:t>
            </a:r>
            <a:endParaRPr kumimoji="1" lang="ja-JP" altLang="en-US" sz="1400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F413CFC-E32A-4F28-BF00-6886EC99C01E}"/>
              </a:ext>
            </a:extLst>
          </p:cNvPr>
          <p:cNvSpPr txBox="1"/>
          <p:nvPr/>
        </p:nvSpPr>
        <p:spPr>
          <a:xfrm>
            <a:off x="5338607" y="949186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5E70AFC-361C-4281-8A06-F8BA97544A5D}"/>
              </a:ext>
            </a:extLst>
          </p:cNvPr>
          <p:cNvSpPr txBox="1"/>
          <p:nvPr/>
        </p:nvSpPr>
        <p:spPr>
          <a:xfrm>
            <a:off x="5995615" y="949097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880CCFF2-5650-4A29-B733-BDFE966CD7BC}"/>
              </a:ext>
            </a:extLst>
          </p:cNvPr>
          <p:cNvSpPr txBox="1"/>
          <p:nvPr/>
        </p:nvSpPr>
        <p:spPr>
          <a:xfrm>
            <a:off x="6683214" y="9490973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9454BD80-A770-418E-82A5-BBC2CD7418B0}"/>
              </a:ext>
            </a:extLst>
          </p:cNvPr>
          <p:cNvSpPr txBox="1"/>
          <p:nvPr/>
        </p:nvSpPr>
        <p:spPr>
          <a:xfrm>
            <a:off x="783810" y="8807034"/>
            <a:ext cx="9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o. at risk</a:t>
            </a:r>
            <a:endParaRPr kumimoji="1" lang="ja-JP" altLang="en-US" sz="1400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91D477D-BF65-4897-9E6A-135D7E37220D}"/>
              </a:ext>
            </a:extLst>
          </p:cNvPr>
          <p:cNvSpPr txBox="1"/>
          <p:nvPr/>
        </p:nvSpPr>
        <p:spPr>
          <a:xfrm>
            <a:off x="409253" y="9137990"/>
            <a:ext cx="1619742" cy="2656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 err="1">
                <a:cs typeface="Arial" panose="020B0604020202020204" pitchFamily="34" charset="0"/>
              </a:rPr>
              <a:t>Readministration</a:t>
            </a:r>
            <a:endParaRPr lang="ja-JP" altLang="en-US" sz="1400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E2CFFA1D-638F-41BA-9D47-E92B75B289B3}"/>
              </a:ext>
            </a:extLst>
          </p:cNvPr>
          <p:cNvSpPr txBox="1"/>
          <p:nvPr/>
        </p:nvSpPr>
        <p:spPr>
          <a:xfrm>
            <a:off x="97149" y="9479960"/>
            <a:ext cx="1931851" cy="28350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>
                <a:cs typeface="Arial" panose="020B0604020202020204" pitchFamily="34" charset="0"/>
              </a:rPr>
              <a:t>No readministration</a:t>
            </a:r>
            <a:endParaRPr lang="ja-JP" altLang="en-US" sz="1400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211335F-FDCA-4FAB-A538-60979D01F3C5}"/>
              </a:ext>
            </a:extLst>
          </p:cNvPr>
          <p:cNvSpPr txBox="1"/>
          <p:nvPr/>
        </p:nvSpPr>
        <p:spPr>
          <a:xfrm>
            <a:off x="3978895" y="8865724"/>
            <a:ext cx="1181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(month)</a:t>
            </a:r>
            <a:endParaRPr kumimoji="1" lang="ja-JP" altLang="en-US" sz="1400" dirty="0"/>
          </a:p>
        </p:txBody>
      </p:sp>
      <p:sp>
        <p:nvSpPr>
          <p:cNvPr id="54" name="テキスト ボックス 1">
            <a:extLst>
              <a:ext uri="{FF2B5EF4-FFF2-40B4-BE49-F238E27FC236}">
                <a16:creationId xmlns:a16="http://schemas.microsoft.com/office/drawing/2014/main" id="{B84AF176-A285-4813-AA7B-249BFD9150F5}"/>
              </a:ext>
            </a:extLst>
          </p:cNvPr>
          <p:cNvSpPr txBox="1"/>
          <p:nvPr/>
        </p:nvSpPr>
        <p:spPr>
          <a:xfrm>
            <a:off x="3887289" y="7643212"/>
            <a:ext cx="3233964" cy="2918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No readministration of anti-PD-1 (n=23)</a:t>
            </a:r>
          </a:p>
        </p:txBody>
      </p:sp>
      <p:sp>
        <p:nvSpPr>
          <p:cNvPr id="55" name="テキスト ボックス 1">
            <a:extLst>
              <a:ext uri="{FF2B5EF4-FFF2-40B4-BE49-F238E27FC236}">
                <a16:creationId xmlns:a16="http://schemas.microsoft.com/office/drawing/2014/main" id="{D2BEDBF1-31B2-4E22-9401-9A716904D5B3}"/>
              </a:ext>
            </a:extLst>
          </p:cNvPr>
          <p:cNvSpPr txBox="1"/>
          <p:nvPr/>
        </p:nvSpPr>
        <p:spPr>
          <a:xfrm>
            <a:off x="3891824" y="7231478"/>
            <a:ext cx="3365492" cy="34089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 err="1"/>
              <a:t>Readministration</a:t>
            </a:r>
            <a:r>
              <a:rPr lang="en-US" altLang="ja-JP" sz="1400" dirty="0"/>
              <a:t> of anti-PD-1 (n=3)</a:t>
            </a:r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2728A18C-3117-4529-B411-03D1EDD45CD1}"/>
              </a:ext>
            </a:extLst>
          </p:cNvPr>
          <p:cNvCxnSpPr>
            <a:cxnSpLocks/>
          </p:cNvCxnSpPr>
          <p:nvPr/>
        </p:nvCxnSpPr>
        <p:spPr>
          <a:xfrm>
            <a:off x="3378702" y="7416921"/>
            <a:ext cx="501072" cy="0"/>
          </a:xfrm>
          <a:prstGeom prst="line">
            <a:avLst/>
          </a:prstGeom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33002B35-352C-4AF3-ADE1-B45D29FA091D}"/>
              </a:ext>
            </a:extLst>
          </p:cNvPr>
          <p:cNvCxnSpPr>
            <a:cxnSpLocks/>
          </p:cNvCxnSpPr>
          <p:nvPr/>
        </p:nvCxnSpPr>
        <p:spPr>
          <a:xfrm>
            <a:off x="3378702" y="7788532"/>
            <a:ext cx="501072" cy="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E9CCF52-F1E4-4D36-83D4-B0B3DC19C539}"/>
              </a:ext>
            </a:extLst>
          </p:cNvPr>
          <p:cNvSpPr txBox="1"/>
          <p:nvPr/>
        </p:nvSpPr>
        <p:spPr>
          <a:xfrm>
            <a:off x="2313466" y="8000055"/>
            <a:ext cx="1694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altLang="ja-JP" dirty="0">
                <a:solidFill>
                  <a:prstClr val="black"/>
                </a:solidFill>
                <a:ea typeface="游ゴシック" panose="020B0400000000000000" pitchFamily="50" charset="-128"/>
              </a:rPr>
              <a:t>Log-rank p=0.55</a:t>
            </a:r>
            <a:endParaRPr lang="ja-JP" altLang="en-US" dirty="0">
              <a:solidFill>
                <a:prstClr val="black"/>
              </a:solidFill>
              <a:ea typeface="游ゴシック" panose="020B0400000000000000" pitchFamily="50" charset="-128"/>
            </a:endParaRPr>
          </a:p>
        </p:txBody>
      </p:sp>
      <p:graphicFrame>
        <p:nvGraphicFramePr>
          <p:cNvPr id="59" name="グラフ 58">
            <a:extLst>
              <a:ext uri="{FF2B5EF4-FFF2-40B4-BE49-F238E27FC236}">
                <a16:creationId xmlns:a16="http://schemas.microsoft.com/office/drawing/2014/main" id="{D33BA302-83FF-4955-98B1-A5BC28A3215A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399142912"/>
              </p:ext>
            </p:extLst>
          </p:nvPr>
        </p:nvGraphicFramePr>
        <p:xfrm>
          <a:off x="8570308" y="519962"/>
          <a:ext cx="5306364" cy="34666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196DA8F9-A673-468F-9C55-520840258CF5}"/>
              </a:ext>
            </a:extLst>
          </p:cNvPr>
          <p:cNvSpPr txBox="1"/>
          <p:nvPr/>
        </p:nvSpPr>
        <p:spPr>
          <a:xfrm>
            <a:off x="9537538" y="136038"/>
            <a:ext cx="3391166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/>
              <a:t>IrAEs other than pneumonitis</a:t>
            </a:r>
            <a:endParaRPr kumimoji="1" lang="ja-JP" altLang="en-US" sz="2000" b="1" dirty="0"/>
          </a:p>
        </p:txBody>
      </p:sp>
      <p:sp>
        <p:nvSpPr>
          <p:cNvPr id="61" name="テキスト ボックス 1">
            <a:extLst>
              <a:ext uri="{FF2B5EF4-FFF2-40B4-BE49-F238E27FC236}">
                <a16:creationId xmlns:a16="http://schemas.microsoft.com/office/drawing/2014/main" id="{043DB8AE-BF23-487A-AC19-7755EC9AFA70}"/>
              </a:ext>
            </a:extLst>
          </p:cNvPr>
          <p:cNvSpPr txBox="1"/>
          <p:nvPr/>
        </p:nvSpPr>
        <p:spPr>
          <a:xfrm>
            <a:off x="11238011" y="1015765"/>
            <a:ext cx="3233964" cy="2918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No readministration of anti-PD-1 (n=10)</a:t>
            </a:r>
          </a:p>
        </p:txBody>
      </p:sp>
      <p:sp>
        <p:nvSpPr>
          <p:cNvPr id="62" name="テキスト ボックス 1">
            <a:extLst>
              <a:ext uri="{FF2B5EF4-FFF2-40B4-BE49-F238E27FC236}">
                <a16:creationId xmlns:a16="http://schemas.microsoft.com/office/drawing/2014/main" id="{A60A4499-2754-4CF7-A904-3DE23E60590E}"/>
              </a:ext>
            </a:extLst>
          </p:cNvPr>
          <p:cNvSpPr txBox="1"/>
          <p:nvPr/>
        </p:nvSpPr>
        <p:spPr>
          <a:xfrm>
            <a:off x="11242546" y="592211"/>
            <a:ext cx="2856597" cy="35271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Readministration of anti-PD-1 (n=11)</a:t>
            </a: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7FC72F69-F136-4621-96ED-B83DADA20C2E}"/>
              </a:ext>
            </a:extLst>
          </p:cNvPr>
          <p:cNvCxnSpPr>
            <a:cxnSpLocks/>
          </p:cNvCxnSpPr>
          <p:nvPr/>
        </p:nvCxnSpPr>
        <p:spPr>
          <a:xfrm>
            <a:off x="10729424" y="789474"/>
            <a:ext cx="501072" cy="0"/>
          </a:xfrm>
          <a:prstGeom prst="line">
            <a:avLst/>
          </a:prstGeom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4DCEBFD5-125C-4C7A-A6FE-5CFC9DE52261}"/>
              </a:ext>
            </a:extLst>
          </p:cNvPr>
          <p:cNvCxnSpPr>
            <a:cxnSpLocks/>
          </p:cNvCxnSpPr>
          <p:nvPr/>
        </p:nvCxnSpPr>
        <p:spPr>
          <a:xfrm>
            <a:off x="10729424" y="1161085"/>
            <a:ext cx="501072" cy="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511BEC2A-CEC2-43E4-99E7-3271EA004CCE}"/>
              </a:ext>
            </a:extLst>
          </p:cNvPr>
          <p:cNvSpPr txBox="1"/>
          <p:nvPr/>
        </p:nvSpPr>
        <p:spPr>
          <a:xfrm>
            <a:off x="8908521" y="4237137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1</a:t>
            </a:r>
            <a:endParaRPr kumimoji="1" lang="ja-JP" altLang="en-US" sz="1400" dirty="0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0FC4359E-CA08-48C0-9DBD-905682E01018}"/>
              </a:ext>
            </a:extLst>
          </p:cNvPr>
          <p:cNvSpPr txBox="1"/>
          <p:nvPr/>
        </p:nvSpPr>
        <p:spPr>
          <a:xfrm>
            <a:off x="9697983" y="4237137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1</a:t>
            </a:r>
            <a:endParaRPr kumimoji="1" lang="ja-JP" altLang="en-US" sz="1400" dirty="0"/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6F06BC66-2A0A-4FB6-8AD0-4B30C5F65826}"/>
              </a:ext>
            </a:extLst>
          </p:cNvPr>
          <p:cNvSpPr txBox="1"/>
          <p:nvPr/>
        </p:nvSpPr>
        <p:spPr>
          <a:xfrm>
            <a:off x="10489670" y="4238023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6</a:t>
            </a:r>
            <a:endParaRPr kumimoji="1" lang="ja-JP" altLang="en-US" sz="1400" dirty="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01A3DAB-1F1B-4A78-BB88-1C86AEDBB4A4}"/>
              </a:ext>
            </a:extLst>
          </p:cNvPr>
          <p:cNvSpPr txBox="1"/>
          <p:nvPr/>
        </p:nvSpPr>
        <p:spPr>
          <a:xfrm>
            <a:off x="11279974" y="4238023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72808A2E-C696-4CE4-987A-DFCB146CDC8D}"/>
              </a:ext>
            </a:extLst>
          </p:cNvPr>
          <p:cNvSpPr txBox="1"/>
          <p:nvPr/>
        </p:nvSpPr>
        <p:spPr>
          <a:xfrm>
            <a:off x="12038176" y="4237137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BF37E56E-61A7-4004-B1C8-1850D46AAB85}"/>
              </a:ext>
            </a:extLst>
          </p:cNvPr>
          <p:cNvSpPr txBox="1"/>
          <p:nvPr/>
        </p:nvSpPr>
        <p:spPr>
          <a:xfrm>
            <a:off x="12808743" y="4238023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A9F2464-61EB-4BA6-8408-E126FEDB54B6}"/>
              </a:ext>
            </a:extLst>
          </p:cNvPr>
          <p:cNvSpPr txBox="1"/>
          <p:nvPr/>
        </p:nvSpPr>
        <p:spPr>
          <a:xfrm>
            <a:off x="13604295" y="4237137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D1DBDC4-626B-4625-8D0A-32F3EB9D3890}"/>
              </a:ext>
            </a:extLst>
          </p:cNvPr>
          <p:cNvSpPr txBox="1"/>
          <p:nvPr/>
        </p:nvSpPr>
        <p:spPr>
          <a:xfrm>
            <a:off x="8908521" y="457910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0</a:t>
            </a:r>
            <a:endParaRPr kumimoji="1" lang="ja-JP" altLang="en-US" sz="1400" dirty="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21401597-D248-4E69-9E5A-71B55D7A8539}"/>
              </a:ext>
            </a:extLst>
          </p:cNvPr>
          <p:cNvSpPr txBox="1"/>
          <p:nvPr/>
        </p:nvSpPr>
        <p:spPr>
          <a:xfrm>
            <a:off x="9697983" y="457910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5</a:t>
            </a:r>
            <a:endParaRPr kumimoji="1" lang="ja-JP" altLang="en-US" sz="1400" dirty="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E9F01313-8AB4-4E9F-9756-49BC66499F21}"/>
              </a:ext>
            </a:extLst>
          </p:cNvPr>
          <p:cNvSpPr txBox="1"/>
          <p:nvPr/>
        </p:nvSpPr>
        <p:spPr>
          <a:xfrm>
            <a:off x="10489670" y="4579991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5C4218E2-70AD-4308-A201-450CC701977D}"/>
              </a:ext>
            </a:extLst>
          </p:cNvPr>
          <p:cNvSpPr txBox="1"/>
          <p:nvPr/>
        </p:nvSpPr>
        <p:spPr>
          <a:xfrm>
            <a:off x="11279974" y="4579993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D924F5DA-B271-484D-AD94-069C2B6D20B2}"/>
              </a:ext>
            </a:extLst>
          </p:cNvPr>
          <p:cNvSpPr txBox="1"/>
          <p:nvPr/>
        </p:nvSpPr>
        <p:spPr>
          <a:xfrm>
            <a:off x="12038176" y="457910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622B4850-727A-4EEE-9DD5-C34F7FFE69E9}"/>
              </a:ext>
            </a:extLst>
          </p:cNvPr>
          <p:cNvSpPr txBox="1"/>
          <p:nvPr/>
        </p:nvSpPr>
        <p:spPr>
          <a:xfrm>
            <a:off x="12808743" y="4579993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503C213-707B-49F2-B023-3DCA5B2233CE}"/>
              </a:ext>
            </a:extLst>
          </p:cNvPr>
          <p:cNvSpPr txBox="1"/>
          <p:nvPr/>
        </p:nvSpPr>
        <p:spPr>
          <a:xfrm>
            <a:off x="13604295" y="457910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2C833F6C-CEDC-4B56-8292-A30A54CD4FAE}"/>
              </a:ext>
            </a:extLst>
          </p:cNvPr>
          <p:cNvSpPr txBox="1"/>
          <p:nvPr/>
        </p:nvSpPr>
        <p:spPr>
          <a:xfrm>
            <a:off x="7755176" y="3895167"/>
            <a:ext cx="9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o. at risk</a:t>
            </a:r>
            <a:endParaRPr kumimoji="1" lang="ja-JP" altLang="en-US" sz="1400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D5A70594-748A-48CB-B472-8E9265E4A650}"/>
              </a:ext>
            </a:extLst>
          </p:cNvPr>
          <p:cNvSpPr txBox="1"/>
          <p:nvPr/>
        </p:nvSpPr>
        <p:spPr>
          <a:xfrm>
            <a:off x="7380619" y="4226123"/>
            <a:ext cx="1619742" cy="2656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 err="1">
                <a:cs typeface="Arial" panose="020B0604020202020204" pitchFamily="34" charset="0"/>
              </a:rPr>
              <a:t>Readministration</a:t>
            </a:r>
            <a:endParaRPr lang="ja-JP" altLang="en-US" sz="1400" dirty="0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1CB2606A-EBBE-462F-BD9F-8AED656C992F}"/>
              </a:ext>
            </a:extLst>
          </p:cNvPr>
          <p:cNvSpPr txBox="1"/>
          <p:nvPr/>
        </p:nvSpPr>
        <p:spPr>
          <a:xfrm>
            <a:off x="7068515" y="4568093"/>
            <a:ext cx="1931851" cy="28350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>
                <a:cs typeface="Arial" panose="020B0604020202020204" pitchFamily="34" charset="0"/>
              </a:rPr>
              <a:t>No readministration</a:t>
            </a:r>
            <a:endParaRPr lang="ja-JP" altLang="en-US" sz="1400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C008ADDC-A52B-41C2-9698-7A25B4156801}"/>
              </a:ext>
            </a:extLst>
          </p:cNvPr>
          <p:cNvSpPr txBox="1"/>
          <p:nvPr/>
        </p:nvSpPr>
        <p:spPr>
          <a:xfrm>
            <a:off x="10950261" y="3953857"/>
            <a:ext cx="1181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(month)</a:t>
            </a:r>
            <a:endParaRPr kumimoji="1" lang="ja-JP" altLang="en-US" sz="1400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A2323C8C-AA05-4D1F-AF1F-5695C4938940}"/>
              </a:ext>
            </a:extLst>
          </p:cNvPr>
          <p:cNvSpPr txBox="1"/>
          <p:nvPr/>
        </p:nvSpPr>
        <p:spPr>
          <a:xfrm>
            <a:off x="9288748" y="3026835"/>
            <a:ext cx="1694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altLang="ja-JP" dirty="0">
                <a:solidFill>
                  <a:prstClr val="black"/>
                </a:solidFill>
                <a:ea typeface="游ゴシック" panose="020B0400000000000000" pitchFamily="50" charset="-128"/>
              </a:rPr>
              <a:t>Log-rank p=0.16</a:t>
            </a:r>
            <a:endParaRPr lang="ja-JP" altLang="en-US" dirty="0">
              <a:solidFill>
                <a:prstClr val="black"/>
              </a:solidFill>
              <a:ea typeface="游ゴシック" panose="020B0400000000000000" pitchFamily="50" charset="-128"/>
            </a:endParaRPr>
          </a:p>
        </p:txBody>
      </p:sp>
      <p:graphicFrame>
        <p:nvGraphicFramePr>
          <p:cNvPr id="84" name="グラフ 83">
            <a:extLst>
              <a:ext uri="{FF2B5EF4-FFF2-40B4-BE49-F238E27FC236}">
                <a16:creationId xmlns:a16="http://schemas.microsoft.com/office/drawing/2014/main" id="{57BDEF6B-D96D-4218-B489-C1DC06386EEE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595651003"/>
              </p:ext>
            </p:extLst>
          </p:nvPr>
        </p:nvGraphicFramePr>
        <p:xfrm>
          <a:off x="8570308" y="5380779"/>
          <a:ext cx="5480020" cy="35801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73F44B3-4D75-4BCC-9CCA-83492857CAC7}"/>
              </a:ext>
            </a:extLst>
          </p:cNvPr>
          <p:cNvSpPr txBox="1"/>
          <p:nvPr/>
        </p:nvSpPr>
        <p:spPr>
          <a:xfrm>
            <a:off x="8984784" y="913075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1</a:t>
            </a:r>
            <a:endParaRPr kumimoji="1" lang="ja-JP" altLang="en-US" sz="1400" dirty="0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167979A4-BA3C-4CD5-B156-E1F2B832A2FC}"/>
              </a:ext>
            </a:extLst>
          </p:cNvPr>
          <p:cNvSpPr txBox="1"/>
          <p:nvPr/>
        </p:nvSpPr>
        <p:spPr>
          <a:xfrm>
            <a:off x="9774246" y="913075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1</a:t>
            </a:r>
            <a:endParaRPr kumimoji="1" lang="ja-JP" altLang="en-US" sz="1400" dirty="0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ED247230-24E8-4A9C-AF80-094A13D4D8A2}"/>
              </a:ext>
            </a:extLst>
          </p:cNvPr>
          <p:cNvSpPr txBox="1"/>
          <p:nvPr/>
        </p:nvSpPr>
        <p:spPr>
          <a:xfrm>
            <a:off x="10565933" y="913164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8</a:t>
            </a:r>
            <a:endParaRPr kumimoji="1" lang="ja-JP" altLang="en-US" sz="1400" dirty="0"/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B472A12B-2062-4140-9C86-28259691E2D5}"/>
              </a:ext>
            </a:extLst>
          </p:cNvPr>
          <p:cNvSpPr txBox="1"/>
          <p:nvPr/>
        </p:nvSpPr>
        <p:spPr>
          <a:xfrm>
            <a:off x="11356237" y="913164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DA2F71FD-9AB0-4801-942F-3000FE73DF61}"/>
              </a:ext>
            </a:extLst>
          </p:cNvPr>
          <p:cNvSpPr txBox="1"/>
          <p:nvPr/>
        </p:nvSpPr>
        <p:spPr>
          <a:xfrm>
            <a:off x="12114439" y="913075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B2D2D87D-2FAD-445C-B304-A2B006960ABA}"/>
              </a:ext>
            </a:extLst>
          </p:cNvPr>
          <p:cNvSpPr txBox="1"/>
          <p:nvPr/>
        </p:nvSpPr>
        <p:spPr>
          <a:xfrm>
            <a:off x="12885006" y="913164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52AA0A7B-48BF-401E-BA54-AD7E13F67039}"/>
              </a:ext>
            </a:extLst>
          </p:cNvPr>
          <p:cNvSpPr txBox="1"/>
          <p:nvPr/>
        </p:nvSpPr>
        <p:spPr>
          <a:xfrm>
            <a:off x="13680558" y="913075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AC273EA1-BF03-43A6-B1BD-ADFF1E83ED84}"/>
              </a:ext>
            </a:extLst>
          </p:cNvPr>
          <p:cNvSpPr txBox="1"/>
          <p:nvPr/>
        </p:nvSpPr>
        <p:spPr>
          <a:xfrm>
            <a:off x="8984784" y="947273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3</a:t>
            </a:r>
            <a:endParaRPr kumimoji="1" lang="ja-JP" altLang="en-US" sz="1400" dirty="0"/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BD85167-3B88-4F8F-A4F1-F485E4DC1297}"/>
              </a:ext>
            </a:extLst>
          </p:cNvPr>
          <p:cNvSpPr txBox="1"/>
          <p:nvPr/>
        </p:nvSpPr>
        <p:spPr>
          <a:xfrm>
            <a:off x="9774246" y="947273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0</a:t>
            </a:r>
            <a:endParaRPr kumimoji="1" lang="ja-JP" altLang="en-US" sz="1400" dirty="0"/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3CF4B4FE-C6DB-4634-9D15-B55832318642}"/>
              </a:ext>
            </a:extLst>
          </p:cNvPr>
          <p:cNvSpPr txBox="1"/>
          <p:nvPr/>
        </p:nvSpPr>
        <p:spPr>
          <a:xfrm>
            <a:off x="10565933" y="9473613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6</a:t>
            </a:r>
            <a:endParaRPr kumimoji="1" lang="ja-JP" altLang="en-US" sz="1400" dirty="0"/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C2257529-8FA8-4834-93C4-C524EC619CE5}"/>
              </a:ext>
            </a:extLst>
          </p:cNvPr>
          <p:cNvSpPr txBox="1"/>
          <p:nvPr/>
        </p:nvSpPr>
        <p:spPr>
          <a:xfrm>
            <a:off x="11356237" y="947361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3A77727F-CF71-4E9C-9346-FD1F14291929}"/>
              </a:ext>
            </a:extLst>
          </p:cNvPr>
          <p:cNvSpPr txBox="1"/>
          <p:nvPr/>
        </p:nvSpPr>
        <p:spPr>
          <a:xfrm>
            <a:off x="12114439" y="947273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2A9773D3-85DB-4725-8860-3D0E08F3AAA3}"/>
              </a:ext>
            </a:extLst>
          </p:cNvPr>
          <p:cNvSpPr txBox="1"/>
          <p:nvPr/>
        </p:nvSpPr>
        <p:spPr>
          <a:xfrm>
            <a:off x="12885006" y="947361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4626329D-2866-476C-A586-3538E092CFB1}"/>
              </a:ext>
            </a:extLst>
          </p:cNvPr>
          <p:cNvSpPr txBox="1"/>
          <p:nvPr/>
        </p:nvSpPr>
        <p:spPr>
          <a:xfrm>
            <a:off x="13680558" y="947273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CD89A867-6B7C-4120-A54F-90DA62DD265F}"/>
              </a:ext>
            </a:extLst>
          </p:cNvPr>
          <p:cNvSpPr txBox="1"/>
          <p:nvPr/>
        </p:nvSpPr>
        <p:spPr>
          <a:xfrm>
            <a:off x="7831439" y="8788789"/>
            <a:ext cx="9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o. at risk</a:t>
            </a:r>
            <a:endParaRPr kumimoji="1" lang="ja-JP" altLang="en-US" sz="1400" dirty="0"/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40CA8479-6A4D-4D32-AC7C-64ACBC27C2FE}"/>
              </a:ext>
            </a:extLst>
          </p:cNvPr>
          <p:cNvSpPr txBox="1"/>
          <p:nvPr/>
        </p:nvSpPr>
        <p:spPr>
          <a:xfrm>
            <a:off x="7456882" y="9119745"/>
            <a:ext cx="1619742" cy="2656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 err="1">
                <a:cs typeface="Arial" panose="020B0604020202020204" pitchFamily="34" charset="0"/>
              </a:rPr>
              <a:t>Readministration</a:t>
            </a:r>
            <a:endParaRPr lang="ja-JP" altLang="en-US" sz="1400" dirty="0"/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330890A9-70E7-40C0-860C-D6498C0A9160}"/>
              </a:ext>
            </a:extLst>
          </p:cNvPr>
          <p:cNvSpPr txBox="1"/>
          <p:nvPr/>
        </p:nvSpPr>
        <p:spPr>
          <a:xfrm>
            <a:off x="7144778" y="9461715"/>
            <a:ext cx="1931851" cy="28350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>
                <a:cs typeface="Arial" panose="020B0604020202020204" pitchFamily="34" charset="0"/>
              </a:rPr>
              <a:t>No readministration</a:t>
            </a:r>
            <a:endParaRPr lang="ja-JP" altLang="en-US" sz="1400" dirty="0"/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A16DA729-16E3-426A-98AF-470C5C9C7124}"/>
              </a:ext>
            </a:extLst>
          </p:cNvPr>
          <p:cNvSpPr txBox="1"/>
          <p:nvPr/>
        </p:nvSpPr>
        <p:spPr>
          <a:xfrm>
            <a:off x="11026524" y="8847479"/>
            <a:ext cx="1181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(month)</a:t>
            </a:r>
            <a:endParaRPr kumimoji="1" lang="ja-JP" altLang="en-US" sz="1400" dirty="0"/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0D6B3C1F-2173-4D71-AE3F-71E1975530F8}"/>
              </a:ext>
            </a:extLst>
          </p:cNvPr>
          <p:cNvSpPr txBox="1"/>
          <p:nvPr/>
        </p:nvSpPr>
        <p:spPr>
          <a:xfrm>
            <a:off x="9288748" y="8000055"/>
            <a:ext cx="1694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altLang="ja-JP" dirty="0">
                <a:solidFill>
                  <a:prstClr val="black"/>
                </a:solidFill>
                <a:ea typeface="游ゴシック" panose="020B0400000000000000" pitchFamily="50" charset="-128"/>
              </a:rPr>
              <a:t>Log-rank p=0.07</a:t>
            </a:r>
            <a:endParaRPr lang="ja-JP" altLang="en-US" dirty="0">
              <a:solidFill>
                <a:prstClr val="black"/>
              </a:solidFill>
              <a:ea typeface="游ゴシック" panose="020B0400000000000000" pitchFamily="50" charset="-128"/>
            </a:endParaRPr>
          </a:p>
        </p:txBody>
      </p:sp>
      <p:sp>
        <p:nvSpPr>
          <p:cNvPr id="104" name="テキスト ボックス 1">
            <a:extLst>
              <a:ext uri="{FF2B5EF4-FFF2-40B4-BE49-F238E27FC236}">
                <a16:creationId xmlns:a16="http://schemas.microsoft.com/office/drawing/2014/main" id="{2D91AA44-C99F-4507-90B9-3896489C53AF}"/>
              </a:ext>
            </a:extLst>
          </p:cNvPr>
          <p:cNvSpPr txBox="1"/>
          <p:nvPr/>
        </p:nvSpPr>
        <p:spPr>
          <a:xfrm>
            <a:off x="9847140" y="7493912"/>
            <a:ext cx="3233964" cy="2918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No readministration of anti-PD-1 (n=13)</a:t>
            </a:r>
          </a:p>
        </p:txBody>
      </p:sp>
      <p:sp>
        <p:nvSpPr>
          <p:cNvPr id="105" name="テキスト ボックス 1">
            <a:extLst>
              <a:ext uri="{FF2B5EF4-FFF2-40B4-BE49-F238E27FC236}">
                <a16:creationId xmlns:a16="http://schemas.microsoft.com/office/drawing/2014/main" id="{B0F6533B-64D7-4C9F-B290-21CC24AD7CCA}"/>
              </a:ext>
            </a:extLst>
          </p:cNvPr>
          <p:cNvSpPr txBox="1"/>
          <p:nvPr/>
        </p:nvSpPr>
        <p:spPr>
          <a:xfrm>
            <a:off x="9851675" y="7070358"/>
            <a:ext cx="2856597" cy="35271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Readministration of anti-PD-1 (n=11)</a:t>
            </a:r>
          </a:p>
        </p:txBody>
      </p: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56357728-D0F2-4EFB-B46F-40C4D49ADD64}"/>
              </a:ext>
            </a:extLst>
          </p:cNvPr>
          <p:cNvCxnSpPr>
            <a:cxnSpLocks/>
          </p:cNvCxnSpPr>
          <p:nvPr/>
        </p:nvCxnSpPr>
        <p:spPr>
          <a:xfrm>
            <a:off x="9338553" y="7267621"/>
            <a:ext cx="501072" cy="0"/>
          </a:xfrm>
          <a:prstGeom prst="line">
            <a:avLst/>
          </a:prstGeom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id="{5BD5BE12-A42A-4EEC-80F5-68B8A3ADE0DB}"/>
              </a:ext>
            </a:extLst>
          </p:cNvPr>
          <p:cNvCxnSpPr>
            <a:cxnSpLocks/>
          </p:cNvCxnSpPr>
          <p:nvPr/>
        </p:nvCxnSpPr>
        <p:spPr>
          <a:xfrm>
            <a:off x="9338553" y="7639232"/>
            <a:ext cx="501072" cy="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F67A2E1F-E360-4A50-80B5-BDCC5A346DEE}"/>
              </a:ext>
            </a:extLst>
          </p:cNvPr>
          <p:cNvSpPr txBox="1"/>
          <p:nvPr/>
        </p:nvSpPr>
        <p:spPr>
          <a:xfrm rot="16200000">
            <a:off x="6418524" y="1767759"/>
            <a:ext cx="34778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/>
              <a:t>Progression free survival (%)</a:t>
            </a:r>
            <a:endParaRPr kumimoji="1" lang="ja-JP" altLang="en-US" sz="2000" dirty="0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5C71C283-8484-4356-8CDD-308B37B0CF59}"/>
              </a:ext>
            </a:extLst>
          </p:cNvPr>
          <p:cNvSpPr txBox="1"/>
          <p:nvPr/>
        </p:nvSpPr>
        <p:spPr>
          <a:xfrm rot="16200000">
            <a:off x="6756802" y="6916366"/>
            <a:ext cx="28012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/>
              <a:t>Overall survival (%)</a:t>
            </a:r>
            <a:endParaRPr kumimoji="1" lang="ja-JP" altLang="en-US" sz="2000" dirty="0"/>
          </a:p>
        </p:txBody>
      </p:sp>
      <p:graphicFrame>
        <p:nvGraphicFramePr>
          <p:cNvPr id="110" name="グラフ 109">
            <a:extLst>
              <a:ext uri="{FF2B5EF4-FFF2-40B4-BE49-F238E27FC236}">
                <a16:creationId xmlns:a16="http://schemas.microsoft.com/office/drawing/2014/main" id="{C1945521-166F-4C79-9F6C-EC0D45C15B44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641924469"/>
              </p:ext>
            </p:extLst>
          </p:nvPr>
        </p:nvGraphicFramePr>
        <p:xfrm>
          <a:off x="8570308" y="15297303"/>
          <a:ext cx="5475501" cy="3577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11" name="グラフ 110">
            <a:extLst>
              <a:ext uri="{FF2B5EF4-FFF2-40B4-BE49-F238E27FC236}">
                <a16:creationId xmlns:a16="http://schemas.microsoft.com/office/drawing/2014/main" id="{3BA802FD-D1C5-4CA4-B997-F4B3AC2F2434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595537935"/>
              </p:ext>
            </p:extLst>
          </p:nvPr>
        </p:nvGraphicFramePr>
        <p:xfrm>
          <a:off x="8570308" y="10400744"/>
          <a:ext cx="5524883" cy="36094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2" name="グラフ 111">
            <a:extLst>
              <a:ext uri="{FF2B5EF4-FFF2-40B4-BE49-F238E27FC236}">
                <a16:creationId xmlns:a16="http://schemas.microsoft.com/office/drawing/2014/main" id="{CF31A5DF-EF60-4778-9AA9-F257A17223A5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013477852"/>
              </p:ext>
            </p:extLst>
          </p:nvPr>
        </p:nvGraphicFramePr>
        <p:xfrm>
          <a:off x="1576105" y="15233168"/>
          <a:ext cx="5503568" cy="35955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3" name="グラフ 112">
            <a:extLst>
              <a:ext uri="{FF2B5EF4-FFF2-40B4-BE49-F238E27FC236}">
                <a16:creationId xmlns:a16="http://schemas.microsoft.com/office/drawing/2014/main" id="{E89DEC1B-1276-42B5-8BBA-3472C2914346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264116997"/>
              </p:ext>
            </p:extLst>
          </p:nvPr>
        </p:nvGraphicFramePr>
        <p:xfrm>
          <a:off x="1576105" y="10427017"/>
          <a:ext cx="5343333" cy="34908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34B91B78-6E34-4070-B94D-E2DFF3586DE7}"/>
              </a:ext>
            </a:extLst>
          </p:cNvPr>
          <p:cNvSpPr txBox="1"/>
          <p:nvPr/>
        </p:nvSpPr>
        <p:spPr>
          <a:xfrm>
            <a:off x="3316328" y="10024793"/>
            <a:ext cx="2347858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/>
              <a:t>Grade 1 or 2 irAEs</a:t>
            </a:r>
            <a:endParaRPr kumimoji="1" lang="ja-JP" altLang="en-US" sz="2000" b="1" dirty="0"/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6E82E08D-9F70-4962-A42A-249618A8B60A}"/>
              </a:ext>
            </a:extLst>
          </p:cNvPr>
          <p:cNvSpPr txBox="1"/>
          <p:nvPr/>
        </p:nvSpPr>
        <p:spPr>
          <a:xfrm>
            <a:off x="10136668" y="10048557"/>
            <a:ext cx="2192906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/>
              <a:t>Grade 3 or 4 irAEs</a:t>
            </a:r>
            <a:endParaRPr kumimoji="1" lang="ja-JP" altLang="en-US" sz="2000" b="1" dirty="0"/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11A04D80-0308-49BB-A8DE-232AB4381C49}"/>
              </a:ext>
            </a:extLst>
          </p:cNvPr>
          <p:cNvSpPr txBox="1"/>
          <p:nvPr/>
        </p:nvSpPr>
        <p:spPr>
          <a:xfrm rot="16200000">
            <a:off x="-623184" y="11804370"/>
            <a:ext cx="34778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/>
              <a:t>Progression free survival (%)</a:t>
            </a:r>
            <a:endParaRPr kumimoji="1" lang="ja-JP" altLang="en-US" sz="2000" dirty="0"/>
          </a:p>
        </p:txBody>
      </p:sp>
      <p:sp>
        <p:nvSpPr>
          <p:cNvPr id="117" name="テキスト ボックス 1">
            <a:extLst>
              <a:ext uri="{FF2B5EF4-FFF2-40B4-BE49-F238E27FC236}">
                <a16:creationId xmlns:a16="http://schemas.microsoft.com/office/drawing/2014/main" id="{7FB038E1-7C20-4B87-9773-BB29F88E2CB7}"/>
              </a:ext>
            </a:extLst>
          </p:cNvPr>
          <p:cNvSpPr txBox="1"/>
          <p:nvPr/>
        </p:nvSpPr>
        <p:spPr>
          <a:xfrm>
            <a:off x="4059649" y="11139693"/>
            <a:ext cx="3233964" cy="2918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No readministration of anti-PD-1 (n=16)</a:t>
            </a:r>
          </a:p>
        </p:txBody>
      </p:sp>
      <p:sp>
        <p:nvSpPr>
          <p:cNvPr id="118" name="テキスト ボックス 1">
            <a:extLst>
              <a:ext uri="{FF2B5EF4-FFF2-40B4-BE49-F238E27FC236}">
                <a16:creationId xmlns:a16="http://schemas.microsoft.com/office/drawing/2014/main" id="{61946CFD-A7B3-4241-861B-E7AFC71D11A4}"/>
              </a:ext>
            </a:extLst>
          </p:cNvPr>
          <p:cNvSpPr txBox="1"/>
          <p:nvPr/>
        </p:nvSpPr>
        <p:spPr>
          <a:xfrm>
            <a:off x="4064184" y="10727959"/>
            <a:ext cx="3365492" cy="34089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 err="1"/>
              <a:t>Readministration</a:t>
            </a:r>
            <a:r>
              <a:rPr lang="en-US" altLang="ja-JP" sz="1400" dirty="0"/>
              <a:t> of anti-PD-1 (n=9)</a:t>
            </a:r>
          </a:p>
        </p:txBody>
      </p: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4C053926-39D5-49FB-8717-213BADA78BB2}"/>
              </a:ext>
            </a:extLst>
          </p:cNvPr>
          <p:cNvCxnSpPr>
            <a:cxnSpLocks/>
          </p:cNvCxnSpPr>
          <p:nvPr/>
        </p:nvCxnSpPr>
        <p:spPr>
          <a:xfrm>
            <a:off x="3551062" y="10913402"/>
            <a:ext cx="501072" cy="0"/>
          </a:xfrm>
          <a:prstGeom prst="line">
            <a:avLst/>
          </a:prstGeom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837E3B79-DC9E-4A8A-B9F2-760C76CD050C}"/>
              </a:ext>
            </a:extLst>
          </p:cNvPr>
          <p:cNvCxnSpPr>
            <a:cxnSpLocks/>
          </p:cNvCxnSpPr>
          <p:nvPr/>
        </p:nvCxnSpPr>
        <p:spPr>
          <a:xfrm>
            <a:off x="3551062" y="11285013"/>
            <a:ext cx="501072" cy="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CCABC704-B5AC-4901-95EB-6F4B5A9D3844}"/>
              </a:ext>
            </a:extLst>
          </p:cNvPr>
          <p:cNvSpPr txBox="1"/>
          <p:nvPr/>
        </p:nvSpPr>
        <p:spPr>
          <a:xfrm>
            <a:off x="1804765" y="1413367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9</a:t>
            </a:r>
            <a:endParaRPr kumimoji="1" lang="ja-JP" altLang="en-US" sz="1400" dirty="0"/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A732B967-AFE6-4ABB-AEFE-53840C3B0BBC}"/>
              </a:ext>
            </a:extLst>
          </p:cNvPr>
          <p:cNvSpPr txBox="1"/>
          <p:nvPr/>
        </p:nvSpPr>
        <p:spPr>
          <a:xfrm>
            <a:off x="2468224" y="1413367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9</a:t>
            </a:r>
            <a:endParaRPr kumimoji="1" lang="ja-JP" altLang="en-US" sz="1400" dirty="0"/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00887E2F-9078-4B90-ABE1-38F07F21B73E}"/>
              </a:ext>
            </a:extLst>
          </p:cNvPr>
          <p:cNvSpPr txBox="1"/>
          <p:nvPr/>
        </p:nvSpPr>
        <p:spPr>
          <a:xfrm>
            <a:off x="3162926" y="1413456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6030E776-1608-4438-A664-8F2F26948978}"/>
              </a:ext>
            </a:extLst>
          </p:cNvPr>
          <p:cNvSpPr txBox="1"/>
          <p:nvPr/>
        </p:nvSpPr>
        <p:spPr>
          <a:xfrm>
            <a:off x="3829853" y="1413456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EFC8E749-CC2D-4B8F-B2B2-3B5684744E19}"/>
              </a:ext>
            </a:extLst>
          </p:cNvPr>
          <p:cNvSpPr txBox="1"/>
          <p:nvPr/>
        </p:nvSpPr>
        <p:spPr>
          <a:xfrm>
            <a:off x="4518780" y="1413367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19887FD8-4B79-4DB3-9116-96D45B62B3FC}"/>
              </a:ext>
            </a:extLst>
          </p:cNvPr>
          <p:cNvSpPr txBox="1"/>
          <p:nvPr/>
        </p:nvSpPr>
        <p:spPr>
          <a:xfrm>
            <a:off x="5177189" y="1413456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3E85D322-4ED4-48DE-B6CD-A0D8DE7CEF90}"/>
              </a:ext>
            </a:extLst>
          </p:cNvPr>
          <p:cNvSpPr txBox="1"/>
          <p:nvPr/>
        </p:nvSpPr>
        <p:spPr>
          <a:xfrm>
            <a:off x="5848711" y="1413367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DC44FF83-19C1-4A91-9D8C-74015989AC91}"/>
              </a:ext>
            </a:extLst>
          </p:cNvPr>
          <p:cNvSpPr txBox="1"/>
          <p:nvPr/>
        </p:nvSpPr>
        <p:spPr>
          <a:xfrm>
            <a:off x="6521796" y="1413367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467575F4-E943-4B51-B70E-DB516FE1E67E}"/>
              </a:ext>
            </a:extLst>
          </p:cNvPr>
          <p:cNvSpPr txBox="1"/>
          <p:nvPr/>
        </p:nvSpPr>
        <p:spPr>
          <a:xfrm>
            <a:off x="1804765" y="1447565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6</a:t>
            </a:r>
            <a:endParaRPr kumimoji="1" lang="ja-JP" altLang="en-US" sz="1400" dirty="0"/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DB513877-127C-49D6-BEE3-FE741D96C764}"/>
              </a:ext>
            </a:extLst>
          </p:cNvPr>
          <p:cNvSpPr txBox="1"/>
          <p:nvPr/>
        </p:nvSpPr>
        <p:spPr>
          <a:xfrm>
            <a:off x="2468224" y="1447565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2</a:t>
            </a:r>
            <a:endParaRPr kumimoji="1" lang="ja-JP" altLang="en-US" sz="1400" dirty="0"/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C2C3C880-E790-472E-A614-3A6E1BA58ED5}"/>
              </a:ext>
            </a:extLst>
          </p:cNvPr>
          <p:cNvSpPr txBox="1"/>
          <p:nvPr/>
        </p:nvSpPr>
        <p:spPr>
          <a:xfrm>
            <a:off x="3162926" y="14476533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1</a:t>
            </a:r>
            <a:endParaRPr kumimoji="1" lang="ja-JP" altLang="en-US" sz="1400" dirty="0"/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4855C08F-00F2-4C4D-8738-CD3DE0DA6CB5}"/>
              </a:ext>
            </a:extLst>
          </p:cNvPr>
          <p:cNvSpPr txBox="1"/>
          <p:nvPr/>
        </p:nvSpPr>
        <p:spPr>
          <a:xfrm>
            <a:off x="3829853" y="1447653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8</a:t>
            </a:r>
            <a:endParaRPr kumimoji="1" lang="ja-JP" altLang="en-US" sz="1400" dirty="0"/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4089D2CD-E4FF-4095-BC1A-351D2753370C}"/>
              </a:ext>
            </a:extLst>
          </p:cNvPr>
          <p:cNvSpPr txBox="1"/>
          <p:nvPr/>
        </p:nvSpPr>
        <p:spPr>
          <a:xfrm>
            <a:off x="4518780" y="1447565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5</a:t>
            </a:r>
            <a:endParaRPr kumimoji="1" lang="ja-JP" altLang="en-US" sz="1400" dirty="0"/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E2B6E284-66DB-431F-B8F7-E6FDB9C4B5E4}"/>
              </a:ext>
            </a:extLst>
          </p:cNvPr>
          <p:cNvSpPr txBox="1"/>
          <p:nvPr/>
        </p:nvSpPr>
        <p:spPr>
          <a:xfrm>
            <a:off x="5177189" y="1447653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7917105F-5ED6-4F06-8352-7C4B33578F17}"/>
              </a:ext>
            </a:extLst>
          </p:cNvPr>
          <p:cNvSpPr txBox="1"/>
          <p:nvPr/>
        </p:nvSpPr>
        <p:spPr>
          <a:xfrm>
            <a:off x="5848711" y="1447565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6E127BDC-A9E4-4FD0-9357-E9B94B0674CE}"/>
              </a:ext>
            </a:extLst>
          </p:cNvPr>
          <p:cNvSpPr txBox="1"/>
          <p:nvPr/>
        </p:nvSpPr>
        <p:spPr>
          <a:xfrm>
            <a:off x="6521796" y="1447564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11C67A07-DC6E-4ABF-8B1E-8501173CF45B}"/>
              </a:ext>
            </a:extLst>
          </p:cNvPr>
          <p:cNvSpPr txBox="1"/>
          <p:nvPr/>
        </p:nvSpPr>
        <p:spPr>
          <a:xfrm>
            <a:off x="651420" y="13791709"/>
            <a:ext cx="9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o. at risk</a:t>
            </a:r>
            <a:endParaRPr kumimoji="1" lang="ja-JP" altLang="en-US" sz="1400" dirty="0"/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F6EAB8D0-4558-4947-A5CA-8158F0DDB26B}"/>
              </a:ext>
            </a:extLst>
          </p:cNvPr>
          <p:cNvSpPr txBox="1"/>
          <p:nvPr/>
        </p:nvSpPr>
        <p:spPr>
          <a:xfrm>
            <a:off x="300721" y="14122665"/>
            <a:ext cx="1619742" cy="2656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 err="1">
                <a:cs typeface="Arial" panose="020B0604020202020204" pitchFamily="34" charset="0"/>
              </a:rPr>
              <a:t>Readministration</a:t>
            </a:r>
            <a:endParaRPr lang="ja-JP" altLang="en-US" sz="1400" dirty="0"/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94FDDFFD-F5E7-43C2-9173-9891F1484A19}"/>
              </a:ext>
            </a:extLst>
          </p:cNvPr>
          <p:cNvSpPr txBox="1"/>
          <p:nvPr/>
        </p:nvSpPr>
        <p:spPr>
          <a:xfrm>
            <a:off x="-11388" y="14464635"/>
            <a:ext cx="1931851" cy="28350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>
                <a:cs typeface="Arial" panose="020B0604020202020204" pitchFamily="34" charset="0"/>
              </a:rPr>
              <a:t>No readministration</a:t>
            </a:r>
            <a:endParaRPr lang="ja-JP" altLang="en-US" sz="1400" dirty="0"/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7ACB6188-E7B1-4E24-B360-DC14D15D73DB}"/>
              </a:ext>
            </a:extLst>
          </p:cNvPr>
          <p:cNvSpPr txBox="1"/>
          <p:nvPr/>
        </p:nvSpPr>
        <p:spPr>
          <a:xfrm>
            <a:off x="3846505" y="13850399"/>
            <a:ext cx="1181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(month)</a:t>
            </a:r>
            <a:endParaRPr kumimoji="1" lang="ja-JP" altLang="en-US" sz="1400" dirty="0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0892F144-EFBF-48A7-AD84-7B5DE97F213F}"/>
              </a:ext>
            </a:extLst>
          </p:cNvPr>
          <p:cNvSpPr txBox="1"/>
          <p:nvPr/>
        </p:nvSpPr>
        <p:spPr>
          <a:xfrm>
            <a:off x="2313466" y="13116561"/>
            <a:ext cx="1694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altLang="ja-JP" dirty="0">
                <a:solidFill>
                  <a:prstClr val="black"/>
                </a:solidFill>
                <a:ea typeface="游ゴシック" panose="020B0400000000000000" pitchFamily="50" charset="-128"/>
              </a:rPr>
              <a:t>Log-rank p=0.93</a:t>
            </a:r>
            <a:endParaRPr lang="ja-JP" altLang="en-US" dirty="0">
              <a:solidFill>
                <a:prstClr val="black"/>
              </a:solidFill>
              <a:ea typeface="游ゴシック" panose="020B0400000000000000" pitchFamily="50" charset="-128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B52AA66F-2C49-4D00-8721-5CC032058584}"/>
              </a:ext>
            </a:extLst>
          </p:cNvPr>
          <p:cNvSpPr txBox="1"/>
          <p:nvPr/>
        </p:nvSpPr>
        <p:spPr>
          <a:xfrm>
            <a:off x="1886674" y="1906257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9</a:t>
            </a:r>
            <a:endParaRPr kumimoji="1" lang="ja-JP" altLang="en-US" sz="1400" dirty="0"/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4F4186D2-3C7A-44C3-9906-B08F1A317620}"/>
              </a:ext>
            </a:extLst>
          </p:cNvPr>
          <p:cNvSpPr txBox="1"/>
          <p:nvPr/>
        </p:nvSpPr>
        <p:spPr>
          <a:xfrm>
            <a:off x="2579161" y="1906257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9</a:t>
            </a:r>
            <a:endParaRPr kumimoji="1" lang="ja-JP" altLang="en-US" sz="1400" dirty="0"/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FBAACBF6-14C4-420D-B212-2F1128AC4F41}"/>
              </a:ext>
            </a:extLst>
          </p:cNvPr>
          <p:cNvSpPr txBox="1"/>
          <p:nvPr/>
        </p:nvSpPr>
        <p:spPr>
          <a:xfrm>
            <a:off x="3273863" y="19063461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6</a:t>
            </a:r>
            <a:endParaRPr kumimoji="1" lang="ja-JP" altLang="en-US" sz="1400" dirty="0"/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78CFEF76-3359-44D3-8276-1F6D42DB2078}"/>
              </a:ext>
            </a:extLst>
          </p:cNvPr>
          <p:cNvSpPr txBox="1"/>
          <p:nvPr/>
        </p:nvSpPr>
        <p:spPr>
          <a:xfrm>
            <a:off x="3911762" y="19063461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A2C42260-BDA4-4405-B075-46F52AF5AC89}"/>
              </a:ext>
            </a:extLst>
          </p:cNvPr>
          <p:cNvSpPr txBox="1"/>
          <p:nvPr/>
        </p:nvSpPr>
        <p:spPr>
          <a:xfrm>
            <a:off x="4600689" y="1906257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8FC3CEAD-47C3-4C01-AC79-2580CB8A87B0}"/>
              </a:ext>
            </a:extLst>
          </p:cNvPr>
          <p:cNvSpPr txBox="1"/>
          <p:nvPr/>
        </p:nvSpPr>
        <p:spPr>
          <a:xfrm>
            <a:off x="5288126" y="19063461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2B29CCE6-2011-4EA1-BF34-70969C4CA170}"/>
              </a:ext>
            </a:extLst>
          </p:cNvPr>
          <p:cNvSpPr txBox="1"/>
          <p:nvPr/>
        </p:nvSpPr>
        <p:spPr>
          <a:xfrm>
            <a:off x="5945134" y="19062575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BF062832-B2BC-435E-ACC7-C568A0209C8D}"/>
              </a:ext>
            </a:extLst>
          </p:cNvPr>
          <p:cNvSpPr txBox="1"/>
          <p:nvPr/>
        </p:nvSpPr>
        <p:spPr>
          <a:xfrm>
            <a:off x="6632733" y="1906257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B4A38193-B48E-4922-BC33-94F5FFA7B8C0}"/>
              </a:ext>
            </a:extLst>
          </p:cNvPr>
          <p:cNvSpPr txBox="1"/>
          <p:nvPr/>
        </p:nvSpPr>
        <p:spPr>
          <a:xfrm>
            <a:off x="1886674" y="19404546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3</a:t>
            </a:r>
            <a:endParaRPr kumimoji="1" lang="ja-JP" altLang="en-US" sz="1400" dirty="0"/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CE3178FD-F8A7-4A21-9E70-09CDF61582E7}"/>
              </a:ext>
            </a:extLst>
          </p:cNvPr>
          <p:cNvSpPr txBox="1"/>
          <p:nvPr/>
        </p:nvSpPr>
        <p:spPr>
          <a:xfrm>
            <a:off x="2579161" y="19404546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9</a:t>
            </a:r>
            <a:endParaRPr kumimoji="1" lang="ja-JP" altLang="en-US" sz="1400" dirty="0"/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59BBBCC8-3300-4A53-925C-ED5297738797}"/>
              </a:ext>
            </a:extLst>
          </p:cNvPr>
          <p:cNvSpPr txBox="1"/>
          <p:nvPr/>
        </p:nvSpPr>
        <p:spPr>
          <a:xfrm>
            <a:off x="3273863" y="1940542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4</a:t>
            </a:r>
            <a:endParaRPr kumimoji="1" lang="ja-JP" altLang="en-US" sz="1400" dirty="0"/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193543EE-5548-456C-BA6C-7BF0AF254DF3}"/>
              </a:ext>
            </a:extLst>
          </p:cNvPr>
          <p:cNvSpPr txBox="1"/>
          <p:nvPr/>
        </p:nvSpPr>
        <p:spPr>
          <a:xfrm>
            <a:off x="3911762" y="19405431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9</a:t>
            </a:r>
            <a:endParaRPr kumimoji="1" lang="ja-JP" altLang="en-US" sz="1400" dirty="0"/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D4517A3C-0438-46BE-A9D3-C7240905F7A7}"/>
              </a:ext>
            </a:extLst>
          </p:cNvPr>
          <p:cNvSpPr txBox="1"/>
          <p:nvPr/>
        </p:nvSpPr>
        <p:spPr>
          <a:xfrm>
            <a:off x="4600689" y="19404546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8</a:t>
            </a:r>
            <a:endParaRPr kumimoji="1" lang="ja-JP" altLang="en-US" sz="1400" dirty="0"/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5C08DCBE-AD2D-482B-8A36-6AA4F4179EB9}"/>
              </a:ext>
            </a:extLst>
          </p:cNvPr>
          <p:cNvSpPr txBox="1"/>
          <p:nvPr/>
        </p:nvSpPr>
        <p:spPr>
          <a:xfrm>
            <a:off x="5288126" y="19405431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C4795C8F-8552-4F57-88AB-D0AE2C8F1A21}"/>
              </a:ext>
            </a:extLst>
          </p:cNvPr>
          <p:cNvSpPr txBox="1"/>
          <p:nvPr/>
        </p:nvSpPr>
        <p:spPr>
          <a:xfrm>
            <a:off x="5945134" y="19404546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DC9DF1F5-125D-4C6B-987D-FBB0FC6262CD}"/>
              </a:ext>
            </a:extLst>
          </p:cNvPr>
          <p:cNvSpPr txBox="1"/>
          <p:nvPr/>
        </p:nvSpPr>
        <p:spPr>
          <a:xfrm>
            <a:off x="6632733" y="1940454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4C497DCA-79E5-40F3-980A-BF74CECA73E2}"/>
              </a:ext>
            </a:extLst>
          </p:cNvPr>
          <p:cNvSpPr txBox="1"/>
          <p:nvPr/>
        </p:nvSpPr>
        <p:spPr>
          <a:xfrm>
            <a:off x="733329" y="18720605"/>
            <a:ext cx="9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o. at risk</a:t>
            </a:r>
            <a:endParaRPr kumimoji="1" lang="ja-JP" altLang="en-US" sz="1400" dirty="0"/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C9626F79-794C-464D-B889-C367D61E5FA7}"/>
              </a:ext>
            </a:extLst>
          </p:cNvPr>
          <p:cNvSpPr txBox="1"/>
          <p:nvPr/>
        </p:nvSpPr>
        <p:spPr>
          <a:xfrm>
            <a:off x="300721" y="19051561"/>
            <a:ext cx="1619742" cy="2656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 err="1">
                <a:cs typeface="Arial" panose="020B0604020202020204" pitchFamily="34" charset="0"/>
              </a:rPr>
              <a:t>Readministration</a:t>
            </a:r>
            <a:endParaRPr lang="ja-JP" altLang="en-US" sz="1400" dirty="0"/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AAB36402-56AE-4DFC-8E6A-FE867071AD4A}"/>
              </a:ext>
            </a:extLst>
          </p:cNvPr>
          <p:cNvSpPr txBox="1"/>
          <p:nvPr/>
        </p:nvSpPr>
        <p:spPr>
          <a:xfrm>
            <a:off x="-11388" y="19393531"/>
            <a:ext cx="1931851" cy="28350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>
                <a:cs typeface="Arial" panose="020B0604020202020204" pitchFamily="34" charset="0"/>
              </a:rPr>
              <a:t>No readministration</a:t>
            </a:r>
            <a:endParaRPr lang="ja-JP" altLang="en-US" sz="1400" dirty="0"/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5B24D218-2CF4-44E5-AF95-335701CA0FE2}"/>
              </a:ext>
            </a:extLst>
          </p:cNvPr>
          <p:cNvSpPr txBox="1"/>
          <p:nvPr/>
        </p:nvSpPr>
        <p:spPr>
          <a:xfrm>
            <a:off x="3928414" y="18779295"/>
            <a:ext cx="1181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(month)</a:t>
            </a:r>
            <a:endParaRPr kumimoji="1" lang="ja-JP" altLang="en-US" sz="1400" dirty="0"/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4F620676-F3AF-43AD-B327-7BF8A5523AF5}"/>
              </a:ext>
            </a:extLst>
          </p:cNvPr>
          <p:cNvSpPr txBox="1"/>
          <p:nvPr/>
        </p:nvSpPr>
        <p:spPr>
          <a:xfrm rot="16200000">
            <a:off x="-269881" y="16834707"/>
            <a:ext cx="28012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/>
              <a:t>Overall survival (%)</a:t>
            </a:r>
            <a:endParaRPr kumimoji="1" lang="ja-JP" altLang="en-US" sz="2000" dirty="0"/>
          </a:p>
        </p:txBody>
      </p:sp>
      <p:sp>
        <p:nvSpPr>
          <p:cNvPr id="163" name="テキスト ボックス 1">
            <a:extLst>
              <a:ext uri="{FF2B5EF4-FFF2-40B4-BE49-F238E27FC236}">
                <a16:creationId xmlns:a16="http://schemas.microsoft.com/office/drawing/2014/main" id="{4AF64B38-5F07-4156-B160-E051862893EC}"/>
              </a:ext>
            </a:extLst>
          </p:cNvPr>
          <p:cNvSpPr txBox="1"/>
          <p:nvPr/>
        </p:nvSpPr>
        <p:spPr>
          <a:xfrm>
            <a:off x="3836808" y="17432089"/>
            <a:ext cx="3233964" cy="2918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Not readministration of anti-PD-1 (n=23)</a:t>
            </a:r>
          </a:p>
        </p:txBody>
      </p:sp>
      <p:sp>
        <p:nvSpPr>
          <p:cNvPr id="164" name="テキスト ボックス 1">
            <a:extLst>
              <a:ext uri="{FF2B5EF4-FFF2-40B4-BE49-F238E27FC236}">
                <a16:creationId xmlns:a16="http://schemas.microsoft.com/office/drawing/2014/main" id="{6AC2DB94-2367-4232-B88B-D49568FA1043}"/>
              </a:ext>
            </a:extLst>
          </p:cNvPr>
          <p:cNvSpPr txBox="1"/>
          <p:nvPr/>
        </p:nvSpPr>
        <p:spPr>
          <a:xfrm>
            <a:off x="3841343" y="17020355"/>
            <a:ext cx="3365492" cy="34089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Readministration of anti-PD-1 (n=9)</a:t>
            </a:r>
          </a:p>
        </p:txBody>
      </p:sp>
      <p:cxnSp>
        <p:nvCxnSpPr>
          <p:cNvPr id="165" name="直線コネクタ 164">
            <a:extLst>
              <a:ext uri="{FF2B5EF4-FFF2-40B4-BE49-F238E27FC236}">
                <a16:creationId xmlns:a16="http://schemas.microsoft.com/office/drawing/2014/main" id="{65713F41-B066-4774-B326-BF22582B7312}"/>
              </a:ext>
            </a:extLst>
          </p:cNvPr>
          <p:cNvCxnSpPr>
            <a:cxnSpLocks/>
          </p:cNvCxnSpPr>
          <p:nvPr/>
        </p:nvCxnSpPr>
        <p:spPr>
          <a:xfrm>
            <a:off x="3328221" y="17205798"/>
            <a:ext cx="501072" cy="0"/>
          </a:xfrm>
          <a:prstGeom prst="line">
            <a:avLst/>
          </a:prstGeom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線コネクタ 165">
            <a:extLst>
              <a:ext uri="{FF2B5EF4-FFF2-40B4-BE49-F238E27FC236}">
                <a16:creationId xmlns:a16="http://schemas.microsoft.com/office/drawing/2014/main" id="{5E0327FA-623F-40D8-9E64-8EF8A06E0972}"/>
              </a:ext>
            </a:extLst>
          </p:cNvPr>
          <p:cNvCxnSpPr>
            <a:cxnSpLocks/>
          </p:cNvCxnSpPr>
          <p:nvPr/>
        </p:nvCxnSpPr>
        <p:spPr>
          <a:xfrm>
            <a:off x="3328221" y="17577409"/>
            <a:ext cx="501072" cy="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9822BF06-B622-44E5-BFBB-A8F904F2AB1F}"/>
              </a:ext>
            </a:extLst>
          </p:cNvPr>
          <p:cNvSpPr txBox="1"/>
          <p:nvPr/>
        </p:nvSpPr>
        <p:spPr>
          <a:xfrm>
            <a:off x="2313466" y="17913626"/>
            <a:ext cx="1694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altLang="ja-JP" dirty="0">
                <a:solidFill>
                  <a:prstClr val="black"/>
                </a:solidFill>
                <a:ea typeface="游ゴシック" panose="020B0400000000000000" pitchFamily="50" charset="-128"/>
              </a:rPr>
              <a:t>Log-rank p=0.28</a:t>
            </a:r>
            <a:endParaRPr lang="ja-JP" altLang="en-US" dirty="0">
              <a:solidFill>
                <a:prstClr val="black"/>
              </a:solidFill>
              <a:ea typeface="游ゴシック" panose="020B0400000000000000" pitchFamily="50" charset="-128"/>
            </a:endParaRPr>
          </a:p>
        </p:txBody>
      </p:sp>
      <p:sp>
        <p:nvSpPr>
          <p:cNvPr id="168" name="テキスト ボックス 1">
            <a:extLst>
              <a:ext uri="{FF2B5EF4-FFF2-40B4-BE49-F238E27FC236}">
                <a16:creationId xmlns:a16="http://schemas.microsoft.com/office/drawing/2014/main" id="{15A803FC-3482-4AFB-BF92-93AB489E78C7}"/>
              </a:ext>
            </a:extLst>
          </p:cNvPr>
          <p:cNvSpPr txBox="1"/>
          <p:nvPr/>
        </p:nvSpPr>
        <p:spPr>
          <a:xfrm>
            <a:off x="11115768" y="12479387"/>
            <a:ext cx="3233964" cy="2918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No readministration of anti-PD-1 (n=13)</a:t>
            </a:r>
          </a:p>
        </p:txBody>
      </p:sp>
      <p:sp>
        <p:nvSpPr>
          <p:cNvPr id="169" name="テキスト ボックス 1">
            <a:extLst>
              <a:ext uri="{FF2B5EF4-FFF2-40B4-BE49-F238E27FC236}">
                <a16:creationId xmlns:a16="http://schemas.microsoft.com/office/drawing/2014/main" id="{C7244E7B-9468-4C44-A247-47CDD83F73D0}"/>
              </a:ext>
            </a:extLst>
          </p:cNvPr>
          <p:cNvSpPr txBox="1"/>
          <p:nvPr/>
        </p:nvSpPr>
        <p:spPr>
          <a:xfrm>
            <a:off x="11120303" y="12180528"/>
            <a:ext cx="2856597" cy="35271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 err="1"/>
              <a:t>Readministration</a:t>
            </a:r>
            <a:r>
              <a:rPr lang="en-US" altLang="ja-JP" sz="1400" dirty="0"/>
              <a:t> of anti-PD-1 (n=4)</a:t>
            </a:r>
          </a:p>
        </p:txBody>
      </p:sp>
      <p:cxnSp>
        <p:nvCxnSpPr>
          <p:cNvPr id="170" name="直線コネクタ 169">
            <a:extLst>
              <a:ext uri="{FF2B5EF4-FFF2-40B4-BE49-F238E27FC236}">
                <a16:creationId xmlns:a16="http://schemas.microsoft.com/office/drawing/2014/main" id="{5D043A8C-78D8-4D0A-8573-E74E2DB975B2}"/>
              </a:ext>
            </a:extLst>
          </p:cNvPr>
          <p:cNvCxnSpPr>
            <a:cxnSpLocks/>
          </p:cNvCxnSpPr>
          <p:nvPr/>
        </p:nvCxnSpPr>
        <p:spPr>
          <a:xfrm>
            <a:off x="10607181" y="12377791"/>
            <a:ext cx="501072" cy="0"/>
          </a:xfrm>
          <a:prstGeom prst="line">
            <a:avLst/>
          </a:prstGeom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直線コネクタ 170">
            <a:extLst>
              <a:ext uri="{FF2B5EF4-FFF2-40B4-BE49-F238E27FC236}">
                <a16:creationId xmlns:a16="http://schemas.microsoft.com/office/drawing/2014/main" id="{35CD6A5C-4F12-4B44-9290-E024F8BFAAB0}"/>
              </a:ext>
            </a:extLst>
          </p:cNvPr>
          <p:cNvCxnSpPr>
            <a:cxnSpLocks/>
          </p:cNvCxnSpPr>
          <p:nvPr/>
        </p:nvCxnSpPr>
        <p:spPr>
          <a:xfrm>
            <a:off x="10607181" y="12624707"/>
            <a:ext cx="501072" cy="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B12F38D0-6B09-4B12-A742-4B7E6A1BD8AB}"/>
              </a:ext>
            </a:extLst>
          </p:cNvPr>
          <p:cNvSpPr txBox="1"/>
          <p:nvPr/>
        </p:nvSpPr>
        <p:spPr>
          <a:xfrm>
            <a:off x="9288748" y="13116561"/>
            <a:ext cx="1811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altLang="ja-JP" dirty="0">
                <a:solidFill>
                  <a:prstClr val="black"/>
                </a:solidFill>
                <a:ea typeface="游ゴシック" panose="020B0400000000000000" pitchFamily="50" charset="-128"/>
              </a:rPr>
              <a:t>Log-rank p=0.052</a:t>
            </a:r>
            <a:endParaRPr lang="ja-JP" altLang="en-US" dirty="0">
              <a:solidFill>
                <a:prstClr val="black"/>
              </a:solidFill>
              <a:ea typeface="游ゴシック" panose="020B0400000000000000" pitchFamily="50" charset="-128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CB9EC03C-EDDC-4E83-82DE-F09FD4B3C2C6}"/>
              </a:ext>
            </a:extLst>
          </p:cNvPr>
          <p:cNvSpPr txBox="1"/>
          <p:nvPr/>
        </p:nvSpPr>
        <p:spPr>
          <a:xfrm rot="16200000">
            <a:off x="6368043" y="11721240"/>
            <a:ext cx="34778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/>
              <a:t>Progression free survival (%)</a:t>
            </a:r>
            <a:endParaRPr kumimoji="1" lang="ja-JP" altLang="en-US" sz="2000" dirty="0"/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B4157399-4612-419C-A223-47091CCAFA87}"/>
              </a:ext>
            </a:extLst>
          </p:cNvPr>
          <p:cNvSpPr txBox="1"/>
          <p:nvPr/>
        </p:nvSpPr>
        <p:spPr>
          <a:xfrm>
            <a:off x="8858040" y="1419061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12CBB072-EF21-4D85-84B8-708C25CF24F3}"/>
              </a:ext>
            </a:extLst>
          </p:cNvPr>
          <p:cNvSpPr txBox="1"/>
          <p:nvPr/>
        </p:nvSpPr>
        <p:spPr>
          <a:xfrm>
            <a:off x="9647502" y="1419061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3DAABCAF-0D32-4DDC-9DDA-AE99DFBD613E}"/>
              </a:ext>
            </a:extLst>
          </p:cNvPr>
          <p:cNvSpPr txBox="1"/>
          <p:nvPr/>
        </p:nvSpPr>
        <p:spPr>
          <a:xfrm>
            <a:off x="10439189" y="1419150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C1B63659-9460-4BD9-85D5-2B13354D8ADB}"/>
              </a:ext>
            </a:extLst>
          </p:cNvPr>
          <p:cNvSpPr txBox="1"/>
          <p:nvPr/>
        </p:nvSpPr>
        <p:spPr>
          <a:xfrm>
            <a:off x="11229493" y="1419150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685E2451-FBB9-49E2-A02D-E7322CC61EF1}"/>
              </a:ext>
            </a:extLst>
          </p:cNvPr>
          <p:cNvSpPr txBox="1"/>
          <p:nvPr/>
        </p:nvSpPr>
        <p:spPr>
          <a:xfrm>
            <a:off x="12045751" y="1419061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32A0A5C4-F51B-4A5C-9B1C-9128558C4305}"/>
              </a:ext>
            </a:extLst>
          </p:cNvPr>
          <p:cNvSpPr txBox="1"/>
          <p:nvPr/>
        </p:nvSpPr>
        <p:spPr>
          <a:xfrm>
            <a:off x="12845346" y="1419150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2BF5F005-7D0F-4429-BF27-A465553E6986}"/>
              </a:ext>
            </a:extLst>
          </p:cNvPr>
          <p:cNvSpPr txBox="1"/>
          <p:nvPr/>
        </p:nvSpPr>
        <p:spPr>
          <a:xfrm>
            <a:off x="13640898" y="14190618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00D95D77-2EBE-4C87-A59E-3342036DC9E5}"/>
              </a:ext>
            </a:extLst>
          </p:cNvPr>
          <p:cNvSpPr txBox="1"/>
          <p:nvPr/>
        </p:nvSpPr>
        <p:spPr>
          <a:xfrm>
            <a:off x="8858040" y="1453258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3</a:t>
            </a:r>
            <a:endParaRPr kumimoji="1" lang="ja-JP" altLang="en-US" sz="1400" dirty="0"/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3AE9E97B-B27F-463E-8110-CC450B85D6BE}"/>
              </a:ext>
            </a:extLst>
          </p:cNvPr>
          <p:cNvSpPr txBox="1"/>
          <p:nvPr/>
        </p:nvSpPr>
        <p:spPr>
          <a:xfrm>
            <a:off x="9647502" y="1453258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36596BB1-C578-4167-8B00-F3922BCB97B6}"/>
              </a:ext>
            </a:extLst>
          </p:cNvPr>
          <p:cNvSpPr txBox="1"/>
          <p:nvPr/>
        </p:nvSpPr>
        <p:spPr>
          <a:xfrm>
            <a:off x="10439189" y="14533472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95CB3ABE-A0A9-47EC-B1EA-3D39EB02DA27}"/>
              </a:ext>
            </a:extLst>
          </p:cNvPr>
          <p:cNvSpPr txBox="1"/>
          <p:nvPr/>
        </p:nvSpPr>
        <p:spPr>
          <a:xfrm>
            <a:off x="11229493" y="1453347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80A42783-853C-4E29-AE4E-3B85ACE31C76}"/>
              </a:ext>
            </a:extLst>
          </p:cNvPr>
          <p:cNvSpPr txBox="1"/>
          <p:nvPr/>
        </p:nvSpPr>
        <p:spPr>
          <a:xfrm>
            <a:off x="12045751" y="1453258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15C810B8-B3AC-4BF4-9086-7EA3C34C4D04}"/>
              </a:ext>
            </a:extLst>
          </p:cNvPr>
          <p:cNvSpPr txBox="1"/>
          <p:nvPr/>
        </p:nvSpPr>
        <p:spPr>
          <a:xfrm>
            <a:off x="12845346" y="1453347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2895F1DA-D329-45F5-8449-78572E8FBD93}"/>
              </a:ext>
            </a:extLst>
          </p:cNvPr>
          <p:cNvSpPr txBox="1"/>
          <p:nvPr/>
        </p:nvSpPr>
        <p:spPr>
          <a:xfrm>
            <a:off x="13640898" y="14532589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D83910C7-D5F7-4A58-8C44-2CCAB23EA779}"/>
              </a:ext>
            </a:extLst>
          </p:cNvPr>
          <p:cNvSpPr txBox="1"/>
          <p:nvPr/>
        </p:nvSpPr>
        <p:spPr>
          <a:xfrm>
            <a:off x="7704695" y="13848648"/>
            <a:ext cx="9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o. at risk</a:t>
            </a:r>
            <a:endParaRPr kumimoji="1" lang="ja-JP" altLang="en-US" sz="1400" dirty="0"/>
          </a:p>
        </p:txBody>
      </p:sp>
      <p:sp>
        <p:nvSpPr>
          <p:cNvPr id="189" name="テキスト ボックス 188">
            <a:extLst>
              <a:ext uri="{FF2B5EF4-FFF2-40B4-BE49-F238E27FC236}">
                <a16:creationId xmlns:a16="http://schemas.microsoft.com/office/drawing/2014/main" id="{920495C1-FC8A-43DA-A275-FEC913636277}"/>
              </a:ext>
            </a:extLst>
          </p:cNvPr>
          <p:cNvSpPr txBox="1"/>
          <p:nvPr/>
        </p:nvSpPr>
        <p:spPr>
          <a:xfrm>
            <a:off x="7362864" y="14179604"/>
            <a:ext cx="1619742" cy="2656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 err="1">
                <a:cs typeface="Arial" panose="020B0604020202020204" pitchFamily="34" charset="0"/>
              </a:rPr>
              <a:t>Readministration</a:t>
            </a:r>
            <a:endParaRPr lang="ja-JP" altLang="en-US" sz="1400" dirty="0"/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E9D75669-5C81-4988-8B03-E8F7C5AAC942}"/>
              </a:ext>
            </a:extLst>
          </p:cNvPr>
          <p:cNvSpPr txBox="1"/>
          <p:nvPr/>
        </p:nvSpPr>
        <p:spPr>
          <a:xfrm>
            <a:off x="7050755" y="14521574"/>
            <a:ext cx="1931851" cy="28350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>
                <a:cs typeface="Arial" panose="020B0604020202020204" pitchFamily="34" charset="0"/>
              </a:rPr>
              <a:t>No readministration</a:t>
            </a:r>
            <a:endParaRPr lang="ja-JP" altLang="en-US" sz="1400" dirty="0"/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2785B96C-3563-4052-A88E-26FD0985B443}"/>
              </a:ext>
            </a:extLst>
          </p:cNvPr>
          <p:cNvSpPr txBox="1"/>
          <p:nvPr/>
        </p:nvSpPr>
        <p:spPr>
          <a:xfrm>
            <a:off x="10899780" y="13907338"/>
            <a:ext cx="1181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(month)</a:t>
            </a:r>
            <a:endParaRPr kumimoji="1" lang="ja-JP" altLang="en-US" sz="1400" dirty="0"/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B06807FF-3B3E-40B4-9C81-8686D6C361C7}"/>
              </a:ext>
            </a:extLst>
          </p:cNvPr>
          <p:cNvSpPr txBox="1"/>
          <p:nvPr/>
        </p:nvSpPr>
        <p:spPr>
          <a:xfrm rot="16200000">
            <a:off x="6706321" y="16829937"/>
            <a:ext cx="28012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/>
              <a:t>Overall survival (%)</a:t>
            </a:r>
            <a:endParaRPr kumimoji="1" lang="ja-JP" altLang="en-US" sz="2000" dirty="0"/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9159AA64-A914-49AD-8009-1A603E3CE76D}"/>
              </a:ext>
            </a:extLst>
          </p:cNvPr>
          <p:cNvSpPr txBox="1"/>
          <p:nvPr/>
        </p:nvSpPr>
        <p:spPr>
          <a:xfrm>
            <a:off x="8876247" y="1904433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5FE16149-30D1-4F09-9312-75907A833C61}"/>
              </a:ext>
            </a:extLst>
          </p:cNvPr>
          <p:cNvSpPr txBox="1"/>
          <p:nvPr/>
        </p:nvSpPr>
        <p:spPr>
          <a:xfrm>
            <a:off x="9651195" y="1904433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C90C3A5F-026B-4CDF-897E-FD8CFBBA3B6C}"/>
              </a:ext>
            </a:extLst>
          </p:cNvPr>
          <p:cNvSpPr txBox="1"/>
          <p:nvPr/>
        </p:nvSpPr>
        <p:spPr>
          <a:xfrm>
            <a:off x="10457396" y="19045216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8054EE86-CBC0-4030-B1CA-0ADE181FF1A3}"/>
              </a:ext>
            </a:extLst>
          </p:cNvPr>
          <p:cNvSpPr txBox="1"/>
          <p:nvPr/>
        </p:nvSpPr>
        <p:spPr>
          <a:xfrm>
            <a:off x="11233186" y="19045216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EF91881C-62BF-476B-871B-B03AE8974FA1}"/>
              </a:ext>
            </a:extLst>
          </p:cNvPr>
          <p:cNvSpPr txBox="1"/>
          <p:nvPr/>
        </p:nvSpPr>
        <p:spPr>
          <a:xfrm>
            <a:off x="12034930" y="1904433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8CAFC6A0-E931-4061-8823-F394107D107B}"/>
              </a:ext>
            </a:extLst>
          </p:cNvPr>
          <p:cNvSpPr txBox="1"/>
          <p:nvPr/>
        </p:nvSpPr>
        <p:spPr>
          <a:xfrm>
            <a:off x="12805497" y="19045216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64F8C3A8-F5B8-4E62-B2DD-4A898C511D68}"/>
              </a:ext>
            </a:extLst>
          </p:cNvPr>
          <p:cNvSpPr txBox="1"/>
          <p:nvPr/>
        </p:nvSpPr>
        <p:spPr>
          <a:xfrm>
            <a:off x="13615563" y="19044330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sz="1400" dirty="0"/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66145C1B-D57E-4B11-B5AB-71A4639140B1}"/>
              </a:ext>
            </a:extLst>
          </p:cNvPr>
          <p:cNvSpPr txBox="1"/>
          <p:nvPr/>
        </p:nvSpPr>
        <p:spPr>
          <a:xfrm>
            <a:off x="8876247" y="19386301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3</a:t>
            </a:r>
            <a:endParaRPr kumimoji="1" lang="ja-JP" altLang="en-US" sz="1400" dirty="0"/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70A49A46-73FA-4A29-AE9D-30638F7B96DC}"/>
              </a:ext>
            </a:extLst>
          </p:cNvPr>
          <p:cNvSpPr txBox="1"/>
          <p:nvPr/>
        </p:nvSpPr>
        <p:spPr>
          <a:xfrm>
            <a:off x="9651195" y="19386301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8</a:t>
            </a:r>
            <a:endParaRPr kumimoji="1" lang="ja-JP" altLang="en-US" sz="1400" dirty="0"/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13FE8A25-CD61-4061-A4A1-DC465B4F86EB}"/>
              </a:ext>
            </a:extLst>
          </p:cNvPr>
          <p:cNvSpPr txBox="1"/>
          <p:nvPr/>
        </p:nvSpPr>
        <p:spPr>
          <a:xfrm>
            <a:off x="10457396" y="19387184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 dirty="0"/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0C89E9CF-B667-4A09-AA14-01E47D6AE2A6}"/>
              </a:ext>
            </a:extLst>
          </p:cNvPr>
          <p:cNvSpPr txBox="1"/>
          <p:nvPr/>
        </p:nvSpPr>
        <p:spPr>
          <a:xfrm>
            <a:off x="11233186" y="19387186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B331D8C1-5BA2-4BDA-961D-51AF3243E0AA}"/>
              </a:ext>
            </a:extLst>
          </p:cNvPr>
          <p:cNvSpPr txBox="1"/>
          <p:nvPr/>
        </p:nvSpPr>
        <p:spPr>
          <a:xfrm>
            <a:off x="12034930" y="19386301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50892535-0FF7-4704-B88D-9D975D2B36F8}"/>
              </a:ext>
            </a:extLst>
          </p:cNvPr>
          <p:cNvSpPr txBox="1"/>
          <p:nvPr/>
        </p:nvSpPr>
        <p:spPr>
          <a:xfrm>
            <a:off x="12805497" y="19387186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3F814245-9E72-46F8-B90D-5F33EB0922AB}"/>
              </a:ext>
            </a:extLst>
          </p:cNvPr>
          <p:cNvSpPr txBox="1"/>
          <p:nvPr/>
        </p:nvSpPr>
        <p:spPr>
          <a:xfrm>
            <a:off x="13615563" y="19386301"/>
            <a:ext cx="44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AB1B75C6-010C-44EA-8FB3-CE8C2AE19A4A}"/>
              </a:ext>
            </a:extLst>
          </p:cNvPr>
          <p:cNvSpPr txBox="1"/>
          <p:nvPr/>
        </p:nvSpPr>
        <p:spPr>
          <a:xfrm>
            <a:off x="7780958" y="18702360"/>
            <a:ext cx="9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o. at risk</a:t>
            </a:r>
            <a:endParaRPr kumimoji="1" lang="ja-JP" altLang="en-US" sz="1400" dirty="0"/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6CF443C0-0597-4614-96B2-8E17B6803DC0}"/>
              </a:ext>
            </a:extLst>
          </p:cNvPr>
          <p:cNvSpPr txBox="1"/>
          <p:nvPr/>
        </p:nvSpPr>
        <p:spPr>
          <a:xfrm>
            <a:off x="7362864" y="19033316"/>
            <a:ext cx="1619742" cy="2656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 err="1">
                <a:cs typeface="Arial" panose="020B0604020202020204" pitchFamily="34" charset="0"/>
              </a:rPr>
              <a:t>Readministration</a:t>
            </a:r>
            <a:endParaRPr lang="ja-JP" altLang="en-US" sz="1400" dirty="0"/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A073A2C9-09A5-4DFA-83E3-EDC4E43CCD02}"/>
              </a:ext>
            </a:extLst>
          </p:cNvPr>
          <p:cNvSpPr txBox="1"/>
          <p:nvPr/>
        </p:nvSpPr>
        <p:spPr>
          <a:xfrm>
            <a:off x="7050755" y="19375286"/>
            <a:ext cx="1931851" cy="28350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kumimoji="1" lang="en-US" altLang="ja-JP" sz="1400" dirty="0">
                <a:cs typeface="Arial" panose="020B0604020202020204" pitchFamily="34" charset="0"/>
              </a:rPr>
              <a:t>No readministration</a:t>
            </a:r>
            <a:endParaRPr lang="ja-JP" altLang="en-US" sz="1400" dirty="0"/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F7375D17-C9AE-4BDB-96AB-71F467B1349D}"/>
              </a:ext>
            </a:extLst>
          </p:cNvPr>
          <p:cNvSpPr txBox="1"/>
          <p:nvPr/>
        </p:nvSpPr>
        <p:spPr>
          <a:xfrm>
            <a:off x="10976043" y="18761050"/>
            <a:ext cx="1181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(month)</a:t>
            </a:r>
            <a:endParaRPr kumimoji="1" lang="ja-JP" altLang="en-US" sz="1400" dirty="0"/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0C0C40AB-6819-42F4-84C6-EB6A723A057F}"/>
              </a:ext>
            </a:extLst>
          </p:cNvPr>
          <p:cNvSpPr txBox="1"/>
          <p:nvPr/>
        </p:nvSpPr>
        <p:spPr>
          <a:xfrm>
            <a:off x="9288748" y="17913626"/>
            <a:ext cx="1811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altLang="ja-JP" dirty="0">
                <a:solidFill>
                  <a:prstClr val="black"/>
                </a:solidFill>
                <a:ea typeface="游ゴシック" panose="020B0400000000000000" pitchFamily="50" charset="-128"/>
              </a:rPr>
              <a:t>Log-rank p=0.097</a:t>
            </a:r>
            <a:endParaRPr lang="ja-JP" altLang="en-US" dirty="0">
              <a:solidFill>
                <a:prstClr val="black"/>
              </a:solidFill>
              <a:ea typeface="游ゴシック" panose="020B0400000000000000" pitchFamily="50" charset="-128"/>
            </a:endParaRPr>
          </a:p>
        </p:txBody>
      </p:sp>
      <p:sp>
        <p:nvSpPr>
          <p:cNvPr id="212" name="テキスト ボックス 1">
            <a:extLst>
              <a:ext uri="{FF2B5EF4-FFF2-40B4-BE49-F238E27FC236}">
                <a16:creationId xmlns:a16="http://schemas.microsoft.com/office/drawing/2014/main" id="{885A31BB-BE68-4275-9C31-748F327601D5}"/>
              </a:ext>
            </a:extLst>
          </p:cNvPr>
          <p:cNvSpPr txBox="1"/>
          <p:nvPr/>
        </p:nvSpPr>
        <p:spPr>
          <a:xfrm>
            <a:off x="11137245" y="16354542"/>
            <a:ext cx="3233964" cy="2918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/>
              <a:t>No readministration of anti-PD-1 (n=13)</a:t>
            </a:r>
          </a:p>
        </p:txBody>
      </p:sp>
      <p:sp>
        <p:nvSpPr>
          <p:cNvPr id="213" name="テキスト ボックス 1">
            <a:extLst>
              <a:ext uri="{FF2B5EF4-FFF2-40B4-BE49-F238E27FC236}">
                <a16:creationId xmlns:a16="http://schemas.microsoft.com/office/drawing/2014/main" id="{1E03D66B-E3F2-44A3-A174-FF697E736FF2}"/>
              </a:ext>
            </a:extLst>
          </p:cNvPr>
          <p:cNvSpPr txBox="1"/>
          <p:nvPr/>
        </p:nvSpPr>
        <p:spPr>
          <a:xfrm>
            <a:off x="11141780" y="15930988"/>
            <a:ext cx="2856597" cy="35271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400" dirty="0" err="1"/>
              <a:t>Readministration</a:t>
            </a:r>
            <a:r>
              <a:rPr lang="en-US" altLang="ja-JP" sz="1400" dirty="0"/>
              <a:t> of anti-PD-1 (n=4)</a:t>
            </a:r>
          </a:p>
        </p:txBody>
      </p:sp>
      <p:cxnSp>
        <p:nvCxnSpPr>
          <p:cNvPr id="214" name="直線コネクタ 213">
            <a:extLst>
              <a:ext uri="{FF2B5EF4-FFF2-40B4-BE49-F238E27FC236}">
                <a16:creationId xmlns:a16="http://schemas.microsoft.com/office/drawing/2014/main" id="{29571E4E-3B0B-42F6-B39D-8294070ECD56}"/>
              </a:ext>
            </a:extLst>
          </p:cNvPr>
          <p:cNvCxnSpPr>
            <a:cxnSpLocks/>
          </p:cNvCxnSpPr>
          <p:nvPr/>
        </p:nvCxnSpPr>
        <p:spPr>
          <a:xfrm>
            <a:off x="10628658" y="16128251"/>
            <a:ext cx="501072" cy="0"/>
          </a:xfrm>
          <a:prstGeom prst="line">
            <a:avLst/>
          </a:prstGeom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直線コネクタ 214">
            <a:extLst>
              <a:ext uri="{FF2B5EF4-FFF2-40B4-BE49-F238E27FC236}">
                <a16:creationId xmlns:a16="http://schemas.microsoft.com/office/drawing/2014/main" id="{DC537852-A962-477F-B443-BE54B2897EA8}"/>
              </a:ext>
            </a:extLst>
          </p:cNvPr>
          <p:cNvCxnSpPr>
            <a:cxnSpLocks/>
          </p:cNvCxnSpPr>
          <p:nvPr/>
        </p:nvCxnSpPr>
        <p:spPr>
          <a:xfrm>
            <a:off x="10628658" y="16499862"/>
            <a:ext cx="501072" cy="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テキスト ボックス 105">
            <a:extLst>
              <a:ext uri="{FF2B5EF4-FFF2-40B4-BE49-F238E27FC236}">
                <a16:creationId xmlns:a16="http://schemas.microsoft.com/office/drawing/2014/main" id="{7D5ECED7-E042-4A7D-BF21-7A0D1251E475}"/>
              </a:ext>
            </a:extLst>
          </p:cNvPr>
          <p:cNvSpPr txBox="1"/>
          <p:nvPr/>
        </p:nvSpPr>
        <p:spPr>
          <a:xfrm>
            <a:off x="0" y="20144281"/>
            <a:ext cx="1440021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18390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36782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55172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873562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591952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310345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028734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747124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2000" b="1" dirty="0">
                <a:cs typeface="Times New Roman" pitchFamily="18" charset="0"/>
              </a:rPr>
              <a:t>Supplementary Figure S2. </a:t>
            </a:r>
            <a:r>
              <a:rPr lang="en-US" altLang="ja-JP" sz="2000" dirty="0">
                <a:cs typeface="Times New Roman" pitchFamily="18" charset="0"/>
              </a:rPr>
              <a:t>Kaplan-Meier curves for the 6-week landmark analysis of the progression-free survival and overall survival in patients with or without the readministration of anti-PD-1 treatment. (A and C) PFS and OS for patients with immune-related pneumonitis. (B and D) PFS and OS for patients with irAEs other than pneumonitis. (E and G) PFS and OS for patients with grade 1-2 irAEs. (F and H) PFS and OS for patients with 3-4 irAEs. PD-1, programmed-cell death-1; irAE, immune-related adverse event.</a:t>
            </a:r>
            <a:endParaRPr kumimoji="1" lang="ja-JP" altLang="en-US" sz="2000" dirty="0">
              <a:cs typeface="Times New Roman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D72B4F3-144F-48EE-A615-06322EA9A880}"/>
              </a:ext>
            </a:extLst>
          </p:cNvPr>
          <p:cNvSpPr txBox="1"/>
          <p:nvPr/>
        </p:nvSpPr>
        <p:spPr>
          <a:xfrm>
            <a:off x="168486" y="16929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4D7FB3C4-DE86-4121-AF9D-891799E1CE71}"/>
              </a:ext>
            </a:extLst>
          </p:cNvPr>
          <p:cNvSpPr txBox="1"/>
          <p:nvPr/>
        </p:nvSpPr>
        <p:spPr>
          <a:xfrm>
            <a:off x="168486" y="509629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C</a:t>
            </a:r>
            <a:endParaRPr kumimoji="1" lang="ja-JP" altLang="en-US" b="1" dirty="0"/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8E2DD971-B9C9-4112-A052-5EA01DB6990D}"/>
              </a:ext>
            </a:extLst>
          </p:cNvPr>
          <p:cNvSpPr txBox="1"/>
          <p:nvPr/>
        </p:nvSpPr>
        <p:spPr>
          <a:xfrm>
            <a:off x="7550646" y="16929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B</a:t>
            </a:r>
            <a:endParaRPr kumimoji="1" lang="ja-JP" altLang="en-US" b="1" dirty="0"/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FE513D52-6205-493B-BF67-F7C32A7B3407}"/>
              </a:ext>
            </a:extLst>
          </p:cNvPr>
          <p:cNvSpPr txBox="1"/>
          <p:nvPr/>
        </p:nvSpPr>
        <p:spPr>
          <a:xfrm>
            <a:off x="7550646" y="5096298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D</a:t>
            </a:r>
            <a:endParaRPr kumimoji="1" lang="ja-JP" altLang="en-US" b="1" dirty="0"/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26A400D2-47EF-4221-92C0-96FDA851E0E4}"/>
              </a:ext>
            </a:extLst>
          </p:cNvPr>
          <p:cNvSpPr txBox="1"/>
          <p:nvPr/>
        </p:nvSpPr>
        <p:spPr>
          <a:xfrm>
            <a:off x="3302922" y="5096298"/>
            <a:ext cx="2047274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/>
              <a:t>Pneumonitis</a:t>
            </a:r>
            <a:endParaRPr kumimoji="1" lang="ja-JP" altLang="en-US" sz="2000" b="1" dirty="0"/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3D62DFBD-5EED-407A-A81D-B86BCD9D97B2}"/>
              </a:ext>
            </a:extLst>
          </p:cNvPr>
          <p:cNvSpPr txBox="1"/>
          <p:nvPr/>
        </p:nvSpPr>
        <p:spPr>
          <a:xfrm>
            <a:off x="9537538" y="5096298"/>
            <a:ext cx="3391166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/>
              <a:t>IrAEs other than pneumonitis</a:t>
            </a:r>
            <a:endParaRPr kumimoji="1" lang="ja-JP" altLang="en-US" sz="2000" b="1" dirty="0"/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36D70BA5-57C1-4D74-AEC8-F911DCAC9D58}"/>
              </a:ext>
            </a:extLst>
          </p:cNvPr>
          <p:cNvSpPr txBox="1"/>
          <p:nvPr/>
        </p:nvSpPr>
        <p:spPr>
          <a:xfrm>
            <a:off x="168486" y="1004855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E</a:t>
            </a:r>
            <a:endParaRPr kumimoji="1" lang="ja-JP" altLang="en-US" b="1" dirty="0"/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39B589B3-13F1-4CDE-BA66-263782F0BE45}"/>
              </a:ext>
            </a:extLst>
          </p:cNvPr>
          <p:cNvSpPr txBox="1"/>
          <p:nvPr/>
        </p:nvSpPr>
        <p:spPr>
          <a:xfrm>
            <a:off x="168486" y="15121235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G</a:t>
            </a:r>
            <a:endParaRPr kumimoji="1" lang="ja-JP" altLang="en-US" b="1" dirty="0"/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C1100F32-F13E-4269-BF18-DC93CE2C36F0}"/>
              </a:ext>
            </a:extLst>
          </p:cNvPr>
          <p:cNvSpPr txBox="1"/>
          <p:nvPr/>
        </p:nvSpPr>
        <p:spPr>
          <a:xfrm>
            <a:off x="7550646" y="1004855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</a:t>
            </a:r>
            <a:endParaRPr kumimoji="1" lang="ja-JP" altLang="en-US" b="1" dirty="0"/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D9535DE2-F727-4D3D-A310-C4B77D14DB48}"/>
              </a:ext>
            </a:extLst>
          </p:cNvPr>
          <p:cNvSpPr txBox="1"/>
          <p:nvPr/>
        </p:nvSpPr>
        <p:spPr>
          <a:xfrm>
            <a:off x="7550646" y="15121235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H</a:t>
            </a:r>
            <a:endParaRPr kumimoji="1" lang="ja-JP" altLang="en-US" b="1" dirty="0"/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9D7171CA-EFD2-43E8-816B-2688972B9B94}"/>
              </a:ext>
            </a:extLst>
          </p:cNvPr>
          <p:cNvSpPr txBox="1"/>
          <p:nvPr/>
        </p:nvSpPr>
        <p:spPr>
          <a:xfrm>
            <a:off x="3329028" y="15090457"/>
            <a:ext cx="2347858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/>
              <a:t>Grade 1 or 2 irAEs</a:t>
            </a:r>
            <a:endParaRPr kumimoji="1" lang="ja-JP" altLang="en-US" sz="2000" b="1" dirty="0"/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C28C4DD6-FF4C-42B2-B972-DEB5E3D1A7BA}"/>
              </a:ext>
            </a:extLst>
          </p:cNvPr>
          <p:cNvSpPr txBox="1"/>
          <p:nvPr/>
        </p:nvSpPr>
        <p:spPr>
          <a:xfrm>
            <a:off x="10149368" y="15090457"/>
            <a:ext cx="2192906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/>
              <a:t>Grade 3 or 4 irAEs</a:t>
            </a:r>
            <a:endParaRPr kumimoji="1" lang="ja-JP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949443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3</TotalTime>
  <Words>541</Words>
  <Application>Microsoft Office PowerPoint</Application>
  <PresentationFormat>ユーザー設定</PresentationFormat>
  <Paragraphs>20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崎 俊哉</dc:creator>
  <cp:lastModifiedBy>Watanabe Satoshi</cp:lastModifiedBy>
  <cp:revision>5</cp:revision>
  <dcterms:created xsi:type="dcterms:W3CDTF">2021-08-27T11:28:56Z</dcterms:created>
  <dcterms:modified xsi:type="dcterms:W3CDTF">2021-08-29T02:35:32Z</dcterms:modified>
</cp:coreProperties>
</file>